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12192000"/>
  <p:notesSz cx="6797675" cy="9926638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Noto Sans Light" panose="020B0604020202020204" charset="0"/>
      <p:regular r:id="rId8"/>
      <p:bold r:id="rId9"/>
      <p:italic r:id="rId10"/>
      <p:boldItalic r:id="rId11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2" roundtripDataSignature="AMtx7mijSp93y8Y6WksimTOG5icxy9H5o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60" d="100"/>
          <a:sy n="160" d="100"/>
        </p:scale>
        <p:origin x="1272" y="-348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customschemas.google.com/relationships/presentationmetadata" Target="metadata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theme" Target="theme/theme1.xml"/><Relationship Id="rId10" Type="http://schemas.openxmlformats.org/officeDocument/2006/relationships/font" Target="fonts/font7.fntdata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45659" cy="4980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50443" y="0"/>
            <a:ext cx="2945659" cy="4980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457450" y="1241425"/>
            <a:ext cx="1882775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9428584"/>
            <a:ext cx="2945659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 txBox="1">
            <a:spLocks noGrp="1"/>
          </p:cNvSpPr>
          <p:nvPr>
            <p:ph type="body" idx="1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6" name="Google Shape;86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457450" y="1241425"/>
            <a:ext cx="1882775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 blanco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>
            <a:spLocks noGrp="1"/>
          </p:cNvSpPr>
          <p:nvPr>
            <p:ph type="dt" idx="10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"/>
          <p:cNvSpPr txBox="1">
            <a:spLocks noGrp="1"/>
          </p:cNvSpPr>
          <p:nvPr>
            <p:ph type="ftr" idx="11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3"/>
          <p:cNvSpPr txBox="1">
            <a:spLocks noGrp="1"/>
          </p:cNvSpPr>
          <p:nvPr>
            <p:ph type="sldNum" idx="12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texto vertical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-438856" y="4155899"/>
            <a:ext cx="7735712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vertical y texto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481057" y="5075811"/>
            <a:ext cx="10332156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-2519318" y="3639917"/>
            <a:ext cx="10332156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a de título" type="title">
  <p:cSld name="TITLE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4"/>
          <p:cNvSpPr txBox="1"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4"/>
          <p:cNvSpPr txBox="1"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22" name="Google Shape;22;p4"/>
          <p:cNvSpPr txBox="1">
            <a:spLocks noGrp="1"/>
          </p:cNvSpPr>
          <p:nvPr>
            <p:ph type="dt" idx="10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4"/>
          <p:cNvSpPr txBox="1">
            <a:spLocks noGrp="1"/>
          </p:cNvSpPr>
          <p:nvPr>
            <p:ph type="ftr" idx="11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4"/>
          <p:cNvSpPr txBox="1">
            <a:spLocks noGrp="1"/>
          </p:cNvSpPr>
          <p:nvPr>
            <p:ph type="sldNum" idx="12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objetos" type="obj">
  <p:cSld name="OBJEC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5"/>
          <p:cNvSpPr txBox="1"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5"/>
          <p:cNvSpPr txBox="1"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5"/>
          <p:cNvSpPr txBox="1">
            <a:spLocks noGrp="1"/>
          </p:cNvSpPr>
          <p:nvPr>
            <p:ph type="dt" idx="10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ftr" idx="11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5"/>
          <p:cNvSpPr txBox="1">
            <a:spLocks noGrp="1"/>
          </p:cNvSpPr>
          <p:nvPr>
            <p:ph type="sldNum" idx="12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cabezado de sección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dt" idx="10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ftr" idx="11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ldNum" idx="12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os objetos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1"/>
          </p:nvPr>
        </p:nvSpPr>
        <p:spPr>
          <a:xfrm>
            <a:off x="471488" y="3245556"/>
            <a:ext cx="2914650" cy="77357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2"/>
          </p:nvPr>
        </p:nvSpPr>
        <p:spPr>
          <a:xfrm>
            <a:off x="3471863" y="3245556"/>
            <a:ext cx="2914650" cy="77357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dt" idx="10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ftr" idx="11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ció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8"/>
          <p:cNvSpPr txBox="1"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body" idx="2"/>
          </p:nvPr>
        </p:nvSpPr>
        <p:spPr>
          <a:xfrm>
            <a:off x="472381" y="4453467"/>
            <a:ext cx="2901255" cy="65503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body" idx="3"/>
          </p:nvPr>
        </p:nvSpPr>
        <p:spPr>
          <a:xfrm>
            <a:off x="3471863" y="2988734"/>
            <a:ext cx="2915543" cy="14647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body" idx="4"/>
          </p:nvPr>
        </p:nvSpPr>
        <p:spPr>
          <a:xfrm>
            <a:off x="3471863" y="4453467"/>
            <a:ext cx="2915543" cy="65503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dt" idx="10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ftr" idx="11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sldNum" idx="12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el título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9"/>
          <p:cNvSpPr txBox="1"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ido con título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2915543" y="1755425"/>
            <a:ext cx="3471863" cy="86642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472381" y="3657600"/>
            <a:ext cx="2211884" cy="67761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n con título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2915543" y="1755425"/>
            <a:ext cx="3471863" cy="8664222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472381" y="3657600"/>
            <a:ext cx="2211884" cy="67761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8" name="Google Shape;88;p1"/>
          <p:cNvGrpSpPr/>
          <p:nvPr/>
        </p:nvGrpSpPr>
        <p:grpSpPr>
          <a:xfrm>
            <a:off x="497731" y="976778"/>
            <a:ext cx="1529290" cy="1288739"/>
            <a:chOff x="89379" y="720000"/>
            <a:chExt cx="2042097" cy="1720883"/>
          </a:xfrm>
        </p:grpSpPr>
        <p:pic>
          <p:nvPicPr>
            <p:cNvPr id="89" name="Google Shape;89;p1" descr="image.png"/>
            <p:cNvPicPr preferRelativeResize="0"/>
            <p:nvPr/>
          </p:nvPicPr>
          <p:blipFill rotWithShape="1">
            <a:blip r:embed="rId3">
              <a:alphaModFix/>
            </a:blip>
            <a:srcRect/>
            <a:stretch/>
          </p:blipFill>
          <p:spPr>
            <a:xfrm>
              <a:off x="180000" y="720000"/>
              <a:ext cx="1951476" cy="170529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90" name="Google Shape;90;p1"/>
            <p:cNvSpPr/>
            <p:nvPr/>
          </p:nvSpPr>
          <p:spPr>
            <a:xfrm>
              <a:off x="519256" y="879120"/>
              <a:ext cx="1206914" cy="1206914"/>
            </a:xfrm>
            <a:custGeom>
              <a:avLst/>
              <a:gdLst/>
              <a:ahLst/>
              <a:cxnLst/>
              <a:rect l="l" t="t" r="r" b="b"/>
              <a:pathLst>
                <a:path w="1206914" h="1206914" extrusionOk="0">
                  <a:moveTo>
                    <a:pt x="0" y="0"/>
                  </a:moveTo>
                  <a:lnTo>
                    <a:pt x="1206914" y="0"/>
                  </a:lnTo>
                  <a:lnTo>
                    <a:pt x="1206914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91" name="Google Shape;91;p1"/>
            <p:cNvSpPr txBox="1"/>
            <p:nvPr/>
          </p:nvSpPr>
          <p:spPr>
            <a:xfrm>
              <a:off x="936571" y="2276490"/>
              <a:ext cx="619800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1</a:t>
              </a:r>
              <a:endParaRPr dirty="0"/>
            </a:p>
          </p:txBody>
        </p:sp>
        <p:sp>
          <p:nvSpPr>
            <p:cNvPr id="92" name="Google Shape;92;p1"/>
            <p:cNvSpPr txBox="1"/>
            <p:nvPr/>
          </p:nvSpPr>
          <p:spPr>
            <a:xfrm rot="16200000">
              <a:off x="-124593" y="1363480"/>
              <a:ext cx="592337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2</a:t>
              </a:r>
              <a:endParaRPr dirty="0"/>
            </a:p>
          </p:txBody>
        </p:sp>
        <p:pic>
          <p:nvPicPr>
            <p:cNvPr id="93" name="Google Shape;93;p1" descr="image.png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522258" y="2089035"/>
              <a:ext cx="1194903" cy="180135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94" name="Google Shape;94;p1"/>
            <p:cNvGrpSpPr/>
            <p:nvPr/>
          </p:nvGrpSpPr>
          <p:grpSpPr>
            <a:xfrm>
              <a:off x="474221" y="2164280"/>
              <a:ext cx="1388240" cy="145144"/>
              <a:chOff x="474221" y="2164280"/>
              <a:chExt cx="1388240" cy="145144"/>
            </a:xfrm>
          </p:grpSpPr>
          <p:sp>
            <p:nvSpPr>
              <p:cNvPr id="95" name="Google Shape;95;p1"/>
              <p:cNvSpPr txBox="1"/>
              <p:nvPr/>
            </p:nvSpPr>
            <p:spPr>
              <a:xfrm>
                <a:off x="474221" y="2165968"/>
                <a:ext cx="236375" cy="14345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1</a:t>
                </a:r>
                <a:endParaRPr dirty="0"/>
              </a:p>
            </p:txBody>
          </p:sp>
          <p:sp>
            <p:nvSpPr>
              <p:cNvPr id="96" name="Google Shape;96;p1"/>
              <p:cNvSpPr txBox="1"/>
              <p:nvPr/>
            </p:nvSpPr>
            <p:spPr>
              <a:xfrm>
                <a:off x="762437" y="2164280"/>
                <a:ext cx="236375" cy="14345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36</a:t>
                </a:r>
                <a:endParaRPr/>
              </a:p>
            </p:txBody>
          </p:sp>
          <p:sp>
            <p:nvSpPr>
              <p:cNvPr id="97" name="Google Shape;97;p1"/>
              <p:cNvSpPr txBox="1"/>
              <p:nvPr/>
            </p:nvSpPr>
            <p:spPr>
              <a:xfrm>
                <a:off x="1068671" y="2164373"/>
                <a:ext cx="226659" cy="14345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0.4</a:t>
                </a:r>
                <a:endParaRPr dirty="0"/>
              </a:p>
            </p:txBody>
          </p:sp>
          <p:sp>
            <p:nvSpPr>
              <p:cNvPr id="98" name="Google Shape;98;p1"/>
              <p:cNvSpPr txBox="1"/>
              <p:nvPr/>
            </p:nvSpPr>
            <p:spPr>
              <a:xfrm>
                <a:off x="1374900" y="2164280"/>
                <a:ext cx="181328" cy="14345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6</a:t>
                </a:r>
                <a:endParaRPr/>
              </a:p>
            </p:txBody>
          </p:sp>
          <p:sp>
            <p:nvSpPr>
              <p:cNvPr id="99" name="Google Shape;99;p1"/>
              <p:cNvSpPr txBox="1"/>
              <p:nvPr/>
            </p:nvSpPr>
            <p:spPr>
              <a:xfrm>
                <a:off x="1681133" y="2165124"/>
                <a:ext cx="181328" cy="14345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2</a:t>
                </a:r>
                <a:endParaRPr/>
              </a:p>
            </p:txBody>
          </p:sp>
        </p:grpSp>
        <p:pic>
          <p:nvPicPr>
            <p:cNvPr id="100" name="Google Shape;100;p1" descr="image.png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336117" y="882122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101" name="Google Shape;101;p1"/>
            <p:cNvGrpSpPr/>
            <p:nvPr/>
          </p:nvGrpSpPr>
          <p:grpSpPr>
            <a:xfrm>
              <a:off x="255540" y="849379"/>
              <a:ext cx="236858" cy="1338655"/>
              <a:chOff x="255540" y="849379"/>
              <a:chExt cx="236858" cy="1338655"/>
            </a:xfrm>
          </p:grpSpPr>
          <p:sp>
            <p:nvSpPr>
              <p:cNvPr id="102" name="Google Shape;102;p1"/>
              <p:cNvSpPr txBox="1"/>
              <p:nvPr/>
            </p:nvSpPr>
            <p:spPr>
              <a:xfrm>
                <a:off x="281702" y="2044190"/>
                <a:ext cx="198744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9</a:t>
                </a:r>
                <a:endParaRPr/>
              </a:p>
            </p:txBody>
          </p:sp>
          <p:sp>
            <p:nvSpPr>
              <p:cNvPr id="103" name="Google Shape;103;p1"/>
              <p:cNvSpPr txBox="1"/>
              <p:nvPr/>
            </p:nvSpPr>
            <p:spPr>
              <a:xfrm>
                <a:off x="274998" y="1750153"/>
                <a:ext cx="213429" cy="14747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40</a:t>
                </a:r>
                <a:endParaRPr/>
              </a:p>
            </p:txBody>
          </p:sp>
          <p:sp>
            <p:nvSpPr>
              <p:cNvPr id="104" name="Google Shape;104;p1"/>
              <p:cNvSpPr txBox="1"/>
              <p:nvPr/>
            </p:nvSpPr>
            <p:spPr>
              <a:xfrm>
                <a:off x="255540" y="1449736"/>
                <a:ext cx="236858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0.6</a:t>
                </a:r>
                <a:endParaRPr/>
              </a:p>
            </p:txBody>
          </p:sp>
          <p:sp>
            <p:nvSpPr>
              <p:cNvPr id="105" name="Google Shape;105;p1"/>
              <p:cNvSpPr txBox="1"/>
              <p:nvPr/>
            </p:nvSpPr>
            <p:spPr>
              <a:xfrm>
                <a:off x="312329" y="1149512"/>
                <a:ext cx="163725" cy="14747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9</a:t>
                </a:r>
                <a:endParaRPr dirty="0"/>
              </a:p>
            </p:txBody>
          </p:sp>
          <p:sp>
            <p:nvSpPr>
              <p:cNvPr id="106" name="Google Shape;106;p1"/>
              <p:cNvSpPr txBox="1"/>
              <p:nvPr/>
            </p:nvSpPr>
            <p:spPr>
              <a:xfrm>
                <a:off x="315614" y="849379"/>
                <a:ext cx="152461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8</a:t>
                </a:r>
                <a:endParaRPr dirty="0"/>
              </a:p>
            </p:txBody>
          </p:sp>
        </p:grpSp>
        <p:sp>
          <p:nvSpPr>
            <p:cNvPr id="107" name="Google Shape;107;p1"/>
            <p:cNvSpPr/>
            <p:nvPr/>
          </p:nvSpPr>
          <p:spPr>
            <a:xfrm>
              <a:off x="1729172" y="882122"/>
              <a:ext cx="60045" cy="1200908"/>
            </a:xfrm>
            <a:prstGeom prst="rect">
              <a:avLst/>
            </a:prstGeom>
            <a:gradFill>
              <a:gsLst>
                <a:gs pos="0">
                  <a:srgbClr val="00007F"/>
                </a:gs>
                <a:gs pos="1562">
                  <a:srgbClr val="000091"/>
                </a:gs>
                <a:gs pos="3125">
                  <a:srgbClr val="0000A3"/>
                </a:gs>
                <a:gs pos="4688">
                  <a:srgbClr val="0000B6"/>
                </a:gs>
                <a:gs pos="6250">
                  <a:srgbClr val="0000C8"/>
                </a:gs>
                <a:gs pos="7812">
                  <a:srgbClr val="0000DA"/>
                </a:gs>
                <a:gs pos="9375">
                  <a:srgbClr val="0000EC"/>
                </a:gs>
                <a:gs pos="10938">
                  <a:srgbClr val="0000FE"/>
                </a:gs>
                <a:gs pos="12500">
                  <a:srgbClr val="0000FF"/>
                </a:gs>
                <a:gs pos="14062">
                  <a:srgbClr val="0010FF"/>
                </a:gs>
                <a:gs pos="15625">
                  <a:srgbClr val="0020FF"/>
                </a:gs>
                <a:gs pos="17188">
                  <a:srgbClr val="0030FF"/>
                </a:gs>
                <a:gs pos="18750">
                  <a:srgbClr val="0040FF"/>
                </a:gs>
                <a:gs pos="20312">
                  <a:srgbClr val="0050FF"/>
                </a:gs>
                <a:gs pos="21875">
                  <a:srgbClr val="0060FF"/>
                </a:gs>
                <a:gs pos="23438">
                  <a:srgbClr val="0070FF"/>
                </a:gs>
                <a:gs pos="25000">
                  <a:srgbClr val="0084FF"/>
                </a:gs>
                <a:gs pos="26562">
                  <a:srgbClr val="0094FF"/>
                </a:gs>
                <a:gs pos="28125">
                  <a:srgbClr val="00A4FF"/>
                </a:gs>
                <a:gs pos="29688">
                  <a:srgbClr val="00B4FF"/>
                </a:gs>
                <a:gs pos="31250">
                  <a:srgbClr val="00C4FF"/>
                </a:gs>
                <a:gs pos="32812">
                  <a:srgbClr val="00D4FF"/>
                </a:gs>
                <a:gs pos="34375">
                  <a:srgbClr val="00E4F7"/>
                </a:gs>
                <a:gs pos="35938">
                  <a:srgbClr val="0CF4EA"/>
                </a:gs>
                <a:gs pos="37500">
                  <a:srgbClr val="18FFDD"/>
                </a:gs>
                <a:gs pos="39062">
                  <a:srgbClr val="25FFD0"/>
                </a:gs>
                <a:gs pos="40625">
                  <a:srgbClr val="32FFC3"/>
                </a:gs>
                <a:gs pos="42188">
                  <a:srgbClr val="3FFFB7"/>
                </a:gs>
                <a:gs pos="43750">
                  <a:srgbClr val="4CFFAA"/>
                </a:gs>
                <a:gs pos="45312">
                  <a:srgbClr val="59FF9D"/>
                </a:gs>
                <a:gs pos="46875">
                  <a:srgbClr val="66FF90"/>
                </a:gs>
                <a:gs pos="48438">
                  <a:srgbClr val="73FF83"/>
                </a:gs>
                <a:gs pos="50000">
                  <a:srgbClr val="83FF73"/>
                </a:gs>
                <a:gs pos="51562">
                  <a:srgbClr val="90FF66"/>
                </a:gs>
                <a:gs pos="53125">
                  <a:srgbClr val="9DFF59"/>
                </a:gs>
                <a:gs pos="54688">
                  <a:srgbClr val="AAFF4C"/>
                </a:gs>
                <a:gs pos="56250">
                  <a:srgbClr val="B7FF3F"/>
                </a:gs>
                <a:gs pos="57812">
                  <a:srgbClr val="C3FF32"/>
                </a:gs>
                <a:gs pos="59375">
                  <a:srgbClr val="D0FF25"/>
                </a:gs>
                <a:gs pos="60938">
                  <a:srgbClr val="DDFF18"/>
                </a:gs>
                <a:gs pos="62500">
                  <a:srgbClr val="EAFF0C"/>
                </a:gs>
                <a:gs pos="64061">
                  <a:srgbClr val="F7F400"/>
                </a:gs>
                <a:gs pos="65625">
                  <a:srgbClr val="FFE500"/>
                </a:gs>
                <a:gs pos="67188">
                  <a:srgbClr val="FFD700"/>
                </a:gs>
                <a:gs pos="68750">
                  <a:srgbClr val="FFC800"/>
                </a:gs>
                <a:gs pos="70312">
                  <a:srgbClr val="FFB900"/>
                </a:gs>
                <a:gs pos="71875">
                  <a:srgbClr val="FFAA00"/>
                </a:gs>
                <a:gs pos="73438">
                  <a:srgbClr val="FF9B00"/>
                </a:gs>
                <a:gs pos="75000">
                  <a:srgbClr val="FF8900"/>
                </a:gs>
                <a:gs pos="76562">
                  <a:srgbClr val="FF7A00"/>
                </a:gs>
                <a:gs pos="78125">
                  <a:srgbClr val="FF6B00"/>
                </a:gs>
                <a:gs pos="79688">
                  <a:srgbClr val="FF5C00"/>
                </a:gs>
                <a:gs pos="81250">
                  <a:srgbClr val="FF4D00"/>
                </a:gs>
                <a:gs pos="82812">
                  <a:srgbClr val="FF3F00"/>
                </a:gs>
                <a:gs pos="84375">
                  <a:srgbClr val="FF3000"/>
                </a:gs>
                <a:gs pos="85938">
                  <a:srgbClr val="FF2100"/>
                </a:gs>
                <a:gs pos="87500">
                  <a:srgbClr val="FE1200"/>
                </a:gs>
                <a:gs pos="89062">
                  <a:srgbClr val="EC0300"/>
                </a:gs>
                <a:gs pos="90625">
                  <a:srgbClr val="DA0000"/>
                </a:gs>
                <a:gs pos="92188">
                  <a:srgbClr val="C80000"/>
                </a:gs>
                <a:gs pos="93750">
                  <a:srgbClr val="B60000"/>
                </a:gs>
                <a:gs pos="95312">
                  <a:srgbClr val="A30000"/>
                </a:gs>
                <a:gs pos="96875">
                  <a:srgbClr val="910000"/>
                </a:gs>
                <a:gs pos="98438">
                  <a:srgbClr val="7F0000"/>
                </a:gs>
                <a:gs pos="100000">
                  <a:srgbClr val="7F0000"/>
                </a:gs>
              </a:gsLst>
              <a:lin ang="16200000" scaled="0"/>
            </a:gra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08" name="Google Shape;108;p1"/>
            <p:cNvSpPr/>
            <p:nvPr/>
          </p:nvSpPr>
          <p:spPr>
            <a:xfrm>
              <a:off x="1726170" y="879120"/>
              <a:ext cx="66050" cy="1206914"/>
            </a:xfrm>
            <a:custGeom>
              <a:avLst/>
              <a:gdLst/>
              <a:ahLst/>
              <a:cxnLst/>
              <a:rect l="l" t="t" r="r" b="b"/>
              <a:pathLst>
                <a:path w="66050" h="1206914" extrusionOk="0">
                  <a:moveTo>
                    <a:pt x="0" y="0"/>
                  </a:moveTo>
                  <a:lnTo>
                    <a:pt x="66050" y="0"/>
                  </a:lnTo>
                  <a:lnTo>
                    <a:pt x="66050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09" name="Google Shape;109;p1" descr="image.png"/>
            <p:cNvPicPr preferRelativeResize="0"/>
            <p:nvPr/>
          </p:nvPicPr>
          <p:blipFill rotWithShape="1">
            <a:blip r:embed="rId6">
              <a:alphaModFix/>
            </a:blip>
            <a:srcRect/>
            <a:stretch/>
          </p:blipFill>
          <p:spPr>
            <a:xfrm>
              <a:off x="1795222" y="882122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10" name="Google Shape;110;p1"/>
            <p:cNvSpPr txBox="1"/>
            <p:nvPr/>
          </p:nvSpPr>
          <p:spPr>
            <a:xfrm>
              <a:off x="1855267" y="1134502"/>
              <a:ext cx="207333" cy="1442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10¹</a:t>
              </a:r>
              <a:endParaRPr dirty="0"/>
            </a:p>
          </p:txBody>
        </p:sp>
      </p:grpSp>
      <p:grpSp>
        <p:nvGrpSpPr>
          <p:cNvPr id="111" name="Google Shape;111;p1"/>
          <p:cNvGrpSpPr/>
          <p:nvPr/>
        </p:nvGrpSpPr>
        <p:grpSpPr>
          <a:xfrm>
            <a:off x="1974456" y="977120"/>
            <a:ext cx="1537347" cy="1288739"/>
            <a:chOff x="2054115" y="720000"/>
            <a:chExt cx="2052856" cy="1720883"/>
          </a:xfrm>
        </p:grpSpPr>
        <p:pic>
          <p:nvPicPr>
            <p:cNvPr id="112" name="Google Shape;112;p1" descr="image.png"/>
            <p:cNvPicPr preferRelativeResize="0"/>
            <p:nvPr/>
          </p:nvPicPr>
          <p:blipFill rotWithShape="1">
            <a:blip r:embed="rId7">
              <a:alphaModFix/>
            </a:blip>
            <a:srcRect/>
            <a:stretch/>
          </p:blipFill>
          <p:spPr>
            <a:xfrm>
              <a:off x="2155495" y="720000"/>
              <a:ext cx="1951476" cy="170529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13" name="Google Shape;113;p1"/>
            <p:cNvSpPr/>
            <p:nvPr/>
          </p:nvSpPr>
          <p:spPr>
            <a:xfrm>
              <a:off x="2494751" y="879120"/>
              <a:ext cx="1206914" cy="1206914"/>
            </a:xfrm>
            <a:custGeom>
              <a:avLst/>
              <a:gdLst/>
              <a:ahLst/>
              <a:cxnLst/>
              <a:rect l="l" t="t" r="r" b="b"/>
              <a:pathLst>
                <a:path w="1206914" h="1206914" extrusionOk="0">
                  <a:moveTo>
                    <a:pt x="0" y="0"/>
                  </a:moveTo>
                  <a:lnTo>
                    <a:pt x="1206914" y="0"/>
                  </a:lnTo>
                  <a:lnTo>
                    <a:pt x="1206914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14" name="Google Shape;114;p1"/>
            <p:cNvSpPr txBox="1"/>
            <p:nvPr/>
          </p:nvSpPr>
          <p:spPr>
            <a:xfrm>
              <a:off x="2912069" y="2276490"/>
              <a:ext cx="588162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1</a:t>
              </a:r>
              <a:endParaRPr dirty="0"/>
            </a:p>
          </p:txBody>
        </p:sp>
        <p:sp>
          <p:nvSpPr>
            <p:cNvPr id="115" name="Google Shape;115;p1"/>
            <p:cNvSpPr txBox="1"/>
            <p:nvPr/>
          </p:nvSpPr>
          <p:spPr>
            <a:xfrm rot="16200000">
              <a:off x="1812185" y="1335523"/>
              <a:ext cx="648253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2</a:t>
              </a:r>
              <a:endParaRPr dirty="0"/>
            </a:p>
          </p:txBody>
        </p:sp>
        <p:pic>
          <p:nvPicPr>
            <p:cNvPr id="116" name="Google Shape;116;p1" descr="image.png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2497753" y="2089035"/>
              <a:ext cx="1194903" cy="180135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117" name="Google Shape;117;p1"/>
            <p:cNvGrpSpPr/>
            <p:nvPr/>
          </p:nvGrpSpPr>
          <p:grpSpPr>
            <a:xfrm>
              <a:off x="2449716" y="2164279"/>
              <a:ext cx="1392911" cy="145531"/>
              <a:chOff x="2449716" y="2164279"/>
              <a:chExt cx="1392911" cy="145531"/>
            </a:xfrm>
          </p:grpSpPr>
          <p:sp>
            <p:nvSpPr>
              <p:cNvPr id="118" name="Google Shape;118;p1"/>
              <p:cNvSpPr txBox="1"/>
              <p:nvPr/>
            </p:nvSpPr>
            <p:spPr>
              <a:xfrm>
                <a:off x="2449716" y="2165967"/>
                <a:ext cx="242464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1</a:t>
                </a:r>
                <a:endParaRPr dirty="0"/>
              </a:p>
            </p:txBody>
          </p:sp>
          <p:sp>
            <p:nvSpPr>
              <p:cNvPr id="119" name="Google Shape;119;p1"/>
              <p:cNvSpPr txBox="1"/>
              <p:nvPr/>
            </p:nvSpPr>
            <p:spPr>
              <a:xfrm>
                <a:off x="2737932" y="2164279"/>
                <a:ext cx="242464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36</a:t>
                </a:r>
                <a:endParaRPr/>
              </a:p>
            </p:txBody>
          </p:sp>
          <p:sp>
            <p:nvSpPr>
              <p:cNvPr id="120" name="Google Shape;120;p1"/>
              <p:cNvSpPr txBox="1"/>
              <p:nvPr/>
            </p:nvSpPr>
            <p:spPr>
              <a:xfrm>
                <a:off x="3044167" y="2164372"/>
                <a:ext cx="232499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0.4</a:t>
                </a:r>
                <a:endParaRPr/>
              </a:p>
            </p:txBody>
          </p:sp>
          <p:sp>
            <p:nvSpPr>
              <p:cNvPr id="121" name="Google Shape;121;p1"/>
              <p:cNvSpPr txBox="1"/>
              <p:nvPr/>
            </p:nvSpPr>
            <p:spPr>
              <a:xfrm>
                <a:off x="3350395" y="2164279"/>
                <a:ext cx="185999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6</a:t>
                </a:r>
                <a:endParaRPr/>
              </a:p>
            </p:txBody>
          </p:sp>
          <p:sp>
            <p:nvSpPr>
              <p:cNvPr id="122" name="Google Shape;122;p1"/>
              <p:cNvSpPr txBox="1"/>
              <p:nvPr/>
            </p:nvSpPr>
            <p:spPr>
              <a:xfrm>
                <a:off x="3656628" y="2165123"/>
                <a:ext cx="185999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2</a:t>
                </a:r>
                <a:endParaRPr/>
              </a:p>
            </p:txBody>
          </p:sp>
        </p:grpSp>
        <p:pic>
          <p:nvPicPr>
            <p:cNvPr id="123" name="Google Shape;123;p1" descr="image.png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2311613" y="882122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124" name="Google Shape;124;p1"/>
            <p:cNvGrpSpPr/>
            <p:nvPr/>
          </p:nvGrpSpPr>
          <p:grpSpPr>
            <a:xfrm>
              <a:off x="2232677" y="833419"/>
              <a:ext cx="211277" cy="1338655"/>
              <a:chOff x="2232677" y="833419"/>
              <a:chExt cx="211277" cy="1338655"/>
            </a:xfrm>
          </p:grpSpPr>
          <p:sp>
            <p:nvSpPr>
              <p:cNvPr id="125" name="Google Shape;125;p1"/>
              <p:cNvSpPr txBox="1"/>
              <p:nvPr/>
            </p:nvSpPr>
            <p:spPr>
              <a:xfrm>
                <a:off x="2254724" y="2028230"/>
                <a:ext cx="177278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9</a:t>
                </a:r>
                <a:endParaRPr/>
              </a:p>
            </p:txBody>
          </p:sp>
          <p:sp>
            <p:nvSpPr>
              <p:cNvPr id="126" name="Google Shape;126;p1"/>
              <p:cNvSpPr txBox="1"/>
              <p:nvPr/>
            </p:nvSpPr>
            <p:spPr>
              <a:xfrm>
                <a:off x="2254724" y="1734193"/>
                <a:ext cx="177278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40</a:t>
                </a:r>
                <a:endParaRPr/>
              </a:p>
            </p:txBody>
          </p:sp>
          <p:sp>
            <p:nvSpPr>
              <p:cNvPr id="127" name="Google Shape;127;p1"/>
              <p:cNvSpPr txBox="1"/>
              <p:nvPr/>
            </p:nvSpPr>
            <p:spPr>
              <a:xfrm>
                <a:off x="2232677" y="1433776"/>
                <a:ext cx="211277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0.6</a:t>
                </a:r>
                <a:endParaRPr/>
              </a:p>
            </p:txBody>
          </p:sp>
          <p:sp>
            <p:nvSpPr>
              <p:cNvPr id="128" name="Google Shape;128;p1"/>
              <p:cNvSpPr txBox="1"/>
              <p:nvPr/>
            </p:nvSpPr>
            <p:spPr>
              <a:xfrm>
                <a:off x="2283636" y="1133552"/>
                <a:ext cx="135993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9</a:t>
                </a:r>
                <a:endParaRPr/>
              </a:p>
            </p:txBody>
          </p:sp>
          <p:sp>
            <p:nvSpPr>
              <p:cNvPr id="129" name="Google Shape;129;p1"/>
              <p:cNvSpPr txBox="1"/>
              <p:nvPr/>
            </p:nvSpPr>
            <p:spPr>
              <a:xfrm>
                <a:off x="2283636" y="833419"/>
                <a:ext cx="135993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8</a:t>
                </a:r>
                <a:endParaRPr dirty="0"/>
              </a:p>
            </p:txBody>
          </p:sp>
        </p:grpSp>
        <p:sp>
          <p:nvSpPr>
            <p:cNvPr id="130" name="Google Shape;130;p1"/>
            <p:cNvSpPr/>
            <p:nvPr/>
          </p:nvSpPr>
          <p:spPr>
            <a:xfrm>
              <a:off x="3704667" y="882122"/>
              <a:ext cx="60045" cy="1200908"/>
            </a:xfrm>
            <a:prstGeom prst="rect">
              <a:avLst/>
            </a:prstGeom>
            <a:gradFill>
              <a:gsLst>
                <a:gs pos="0">
                  <a:srgbClr val="00007F"/>
                </a:gs>
                <a:gs pos="1562">
                  <a:srgbClr val="000091"/>
                </a:gs>
                <a:gs pos="3125">
                  <a:srgbClr val="0000A3"/>
                </a:gs>
                <a:gs pos="4688">
                  <a:srgbClr val="0000B6"/>
                </a:gs>
                <a:gs pos="6250">
                  <a:srgbClr val="0000C8"/>
                </a:gs>
                <a:gs pos="7812">
                  <a:srgbClr val="0000DA"/>
                </a:gs>
                <a:gs pos="9375">
                  <a:srgbClr val="0000EC"/>
                </a:gs>
                <a:gs pos="10938">
                  <a:srgbClr val="0000FE"/>
                </a:gs>
                <a:gs pos="12500">
                  <a:srgbClr val="0000FF"/>
                </a:gs>
                <a:gs pos="14062">
                  <a:srgbClr val="0010FF"/>
                </a:gs>
                <a:gs pos="15625">
                  <a:srgbClr val="0020FF"/>
                </a:gs>
                <a:gs pos="17188">
                  <a:srgbClr val="0030FF"/>
                </a:gs>
                <a:gs pos="18750">
                  <a:srgbClr val="0040FF"/>
                </a:gs>
                <a:gs pos="20312">
                  <a:srgbClr val="0050FF"/>
                </a:gs>
                <a:gs pos="21875">
                  <a:srgbClr val="0060FF"/>
                </a:gs>
                <a:gs pos="23438">
                  <a:srgbClr val="0070FF"/>
                </a:gs>
                <a:gs pos="25000">
                  <a:srgbClr val="0084FF"/>
                </a:gs>
                <a:gs pos="26562">
                  <a:srgbClr val="0094FF"/>
                </a:gs>
                <a:gs pos="28125">
                  <a:srgbClr val="00A4FF"/>
                </a:gs>
                <a:gs pos="29688">
                  <a:srgbClr val="00B4FF"/>
                </a:gs>
                <a:gs pos="31250">
                  <a:srgbClr val="00C4FF"/>
                </a:gs>
                <a:gs pos="32812">
                  <a:srgbClr val="00D4FF"/>
                </a:gs>
                <a:gs pos="34375">
                  <a:srgbClr val="00E4F7"/>
                </a:gs>
                <a:gs pos="35938">
                  <a:srgbClr val="0CF4EA"/>
                </a:gs>
                <a:gs pos="37500">
                  <a:srgbClr val="18FFDD"/>
                </a:gs>
                <a:gs pos="39062">
                  <a:srgbClr val="25FFD0"/>
                </a:gs>
                <a:gs pos="40625">
                  <a:srgbClr val="32FFC3"/>
                </a:gs>
                <a:gs pos="42188">
                  <a:srgbClr val="3FFFB7"/>
                </a:gs>
                <a:gs pos="43750">
                  <a:srgbClr val="4CFFAA"/>
                </a:gs>
                <a:gs pos="45312">
                  <a:srgbClr val="59FF9D"/>
                </a:gs>
                <a:gs pos="46875">
                  <a:srgbClr val="66FF90"/>
                </a:gs>
                <a:gs pos="48438">
                  <a:srgbClr val="73FF83"/>
                </a:gs>
                <a:gs pos="50000">
                  <a:srgbClr val="83FF73"/>
                </a:gs>
                <a:gs pos="51562">
                  <a:srgbClr val="90FF66"/>
                </a:gs>
                <a:gs pos="53125">
                  <a:srgbClr val="9DFF59"/>
                </a:gs>
                <a:gs pos="54688">
                  <a:srgbClr val="AAFF4C"/>
                </a:gs>
                <a:gs pos="56250">
                  <a:srgbClr val="B7FF3F"/>
                </a:gs>
                <a:gs pos="57812">
                  <a:srgbClr val="C3FF32"/>
                </a:gs>
                <a:gs pos="59375">
                  <a:srgbClr val="D0FF25"/>
                </a:gs>
                <a:gs pos="60938">
                  <a:srgbClr val="DDFF18"/>
                </a:gs>
                <a:gs pos="62500">
                  <a:srgbClr val="EAFF0C"/>
                </a:gs>
                <a:gs pos="64061">
                  <a:srgbClr val="F7F400"/>
                </a:gs>
                <a:gs pos="65625">
                  <a:srgbClr val="FFE500"/>
                </a:gs>
                <a:gs pos="67188">
                  <a:srgbClr val="FFD700"/>
                </a:gs>
                <a:gs pos="68750">
                  <a:srgbClr val="FFC800"/>
                </a:gs>
                <a:gs pos="70312">
                  <a:srgbClr val="FFB900"/>
                </a:gs>
                <a:gs pos="71875">
                  <a:srgbClr val="FFAA00"/>
                </a:gs>
                <a:gs pos="73438">
                  <a:srgbClr val="FF9B00"/>
                </a:gs>
                <a:gs pos="75000">
                  <a:srgbClr val="FF8900"/>
                </a:gs>
                <a:gs pos="76562">
                  <a:srgbClr val="FF7A00"/>
                </a:gs>
                <a:gs pos="78125">
                  <a:srgbClr val="FF6B00"/>
                </a:gs>
                <a:gs pos="79688">
                  <a:srgbClr val="FF5C00"/>
                </a:gs>
                <a:gs pos="81250">
                  <a:srgbClr val="FF4D00"/>
                </a:gs>
                <a:gs pos="82812">
                  <a:srgbClr val="FF3F00"/>
                </a:gs>
                <a:gs pos="84375">
                  <a:srgbClr val="FF3000"/>
                </a:gs>
                <a:gs pos="85938">
                  <a:srgbClr val="FF2100"/>
                </a:gs>
                <a:gs pos="87500">
                  <a:srgbClr val="FE1200"/>
                </a:gs>
                <a:gs pos="89062">
                  <a:srgbClr val="EC0300"/>
                </a:gs>
                <a:gs pos="90625">
                  <a:srgbClr val="DA0000"/>
                </a:gs>
                <a:gs pos="92188">
                  <a:srgbClr val="C80000"/>
                </a:gs>
                <a:gs pos="93750">
                  <a:srgbClr val="B60000"/>
                </a:gs>
                <a:gs pos="95312">
                  <a:srgbClr val="A30000"/>
                </a:gs>
                <a:gs pos="96875">
                  <a:srgbClr val="910000"/>
                </a:gs>
                <a:gs pos="98438">
                  <a:srgbClr val="7F0000"/>
                </a:gs>
                <a:gs pos="100000">
                  <a:srgbClr val="7F0000"/>
                </a:gs>
              </a:gsLst>
              <a:lin ang="16200000" scaled="0"/>
            </a:gra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31" name="Google Shape;131;p1"/>
            <p:cNvSpPr/>
            <p:nvPr/>
          </p:nvSpPr>
          <p:spPr>
            <a:xfrm>
              <a:off x="3701665" y="879120"/>
              <a:ext cx="66050" cy="1206914"/>
            </a:xfrm>
            <a:custGeom>
              <a:avLst/>
              <a:gdLst/>
              <a:ahLst/>
              <a:cxnLst/>
              <a:rect l="l" t="t" r="r" b="b"/>
              <a:pathLst>
                <a:path w="66050" h="1206914" extrusionOk="0">
                  <a:moveTo>
                    <a:pt x="0" y="0"/>
                  </a:moveTo>
                  <a:lnTo>
                    <a:pt x="66050" y="0"/>
                  </a:lnTo>
                  <a:lnTo>
                    <a:pt x="66050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32" name="Google Shape;132;p1" descr="image.png"/>
            <p:cNvPicPr preferRelativeResize="0"/>
            <p:nvPr/>
          </p:nvPicPr>
          <p:blipFill rotWithShape="1">
            <a:blip r:embed="rId6">
              <a:alphaModFix/>
            </a:blip>
            <a:srcRect/>
            <a:stretch/>
          </p:blipFill>
          <p:spPr>
            <a:xfrm>
              <a:off x="3770717" y="882122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33" name="Google Shape;133;p1"/>
            <p:cNvSpPr txBox="1"/>
            <p:nvPr/>
          </p:nvSpPr>
          <p:spPr>
            <a:xfrm>
              <a:off x="3830761" y="1134502"/>
              <a:ext cx="211191" cy="14384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10¹</a:t>
              </a:r>
              <a:endParaRPr dirty="0"/>
            </a:p>
          </p:txBody>
        </p:sp>
      </p:grpSp>
      <p:grpSp>
        <p:nvGrpSpPr>
          <p:cNvPr id="134" name="Google Shape;134;p1"/>
          <p:cNvGrpSpPr/>
          <p:nvPr/>
        </p:nvGrpSpPr>
        <p:grpSpPr>
          <a:xfrm>
            <a:off x="3474351" y="979496"/>
            <a:ext cx="1521696" cy="1288740"/>
            <a:chOff x="4050509" y="720000"/>
            <a:chExt cx="2031957" cy="1720884"/>
          </a:xfrm>
        </p:grpSpPr>
        <p:pic>
          <p:nvPicPr>
            <p:cNvPr id="135" name="Google Shape;135;p1" descr="image.png"/>
            <p:cNvPicPr preferRelativeResize="0"/>
            <p:nvPr/>
          </p:nvPicPr>
          <p:blipFill rotWithShape="1">
            <a:blip r:embed="rId8">
              <a:alphaModFix/>
            </a:blip>
            <a:srcRect/>
            <a:stretch/>
          </p:blipFill>
          <p:spPr>
            <a:xfrm>
              <a:off x="4130990" y="720000"/>
              <a:ext cx="1951476" cy="170529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36" name="Google Shape;136;p1"/>
            <p:cNvSpPr/>
            <p:nvPr/>
          </p:nvSpPr>
          <p:spPr>
            <a:xfrm>
              <a:off x="4470247" y="879120"/>
              <a:ext cx="1206914" cy="1206914"/>
            </a:xfrm>
            <a:custGeom>
              <a:avLst/>
              <a:gdLst/>
              <a:ahLst/>
              <a:cxnLst/>
              <a:rect l="l" t="t" r="r" b="b"/>
              <a:pathLst>
                <a:path w="1206914" h="1206914" extrusionOk="0">
                  <a:moveTo>
                    <a:pt x="0" y="0"/>
                  </a:moveTo>
                  <a:lnTo>
                    <a:pt x="1206914" y="0"/>
                  </a:lnTo>
                  <a:lnTo>
                    <a:pt x="1206914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37" name="Google Shape;137;p1"/>
            <p:cNvSpPr txBox="1"/>
            <p:nvPr/>
          </p:nvSpPr>
          <p:spPr>
            <a:xfrm>
              <a:off x="4887562" y="2276491"/>
              <a:ext cx="625349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1</a:t>
              </a:r>
              <a:endParaRPr dirty="0"/>
            </a:p>
          </p:txBody>
        </p:sp>
        <p:sp>
          <p:nvSpPr>
            <p:cNvPr id="138" name="Google Shape;138;p1"/>
            <p:cNvSpPr txBox="1"/>
            <p:nvPr/>
          </p:nvSpPr>
          <p:spPr>
            <a:xfrm rot="16200000">
              <a:off x="3834723" y="1361667"/>
              <a:ext cx="595965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2</a:t>
              </a:r>
              <a:endParaRPr dirty="0"/>
            </a:p>
          </p:txBody>
        </p:sp>
        <p:pic>
          <p:nvPicPr>
            <p:cNvPr id="139" name="Google Shape;139;p1" descr="image.png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4473249" y="2089035"/>
              <a:ext cx="1194903" cy="180135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140" name="Google Shape;140;p1"/>
            <p:cNvGrpSpPr/>
            <p:nvPr/>
          </p:nvGrpSpPr>
          <p:grpSpPr>
            <a:xfrm>
              <a:off x="4425212" y="2164280"/>
              <a:ext cx="1326782" cy="145531"/>
              <a:chOff x="4425212" y="2164280"/>
              <a:chExt cx="1326782" cy="145531"/>
            </a:xfrm>
          </p:grpSpPr>
          <p:sp>
            <p:nvSpPr>
              <p:cNvPr id="141" name="Google Shape;141;p1"/>
              <p:cNvSpPr txBox="1"/>
              <p:nvPr/>
            </p:nvSpPr>
            <p:spPr>
              <a:xfrm>
                <a:off x="4425212" y="2165968"/>
                <a:ext cx="156259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1</a:t>
                </a:r>
                <a:endParaRPr/>
              </a:p>
            </p:txBody>
          </p:sp>
          <p:sp>
            <p:nvSpPr>
              <p:cNvPr id="142" name="Google Shape;142;p1"/>
              <p:cNvSpPr txBox="1"/>
              <p:nvPr/>
            </p:nvSpPr>
            <p:spPr>
              <a:xfrm>
                <a:off x="4713429" y="2164280"/>
                <a:ext cx="156259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36</a:t>
                </a:r>
                <a:endParaRPr/>
              </a:p>
            </p:txBody>
          </p:sp>
          <p:sp>
            <p:nvSpPr>
              <p:cNvPr id="143" name="Google Shape;143;p1"/>
              <p:cNvSpPr txBox="1"/>
              <p:nvPr/>
            </p:nvSpPr>
            <p:spPr>
              <a:xfrm>
                <a:off x="5019660" y="2164373"/>
                <a:ext cx="149837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0.4</a:t>
                </a:r>
                <a:endParaRPr/>
              </a:p>
            </p:txBody>
          </p:sp>
          <p:sp>
            <p:nvSpPr>
              <p:cNvPr id="144" name="Google Shape;144;p1"/>
              <p:cNvSpPr txBox="1"/>
              <p:nvPr/>
            </p:nvSpPr>
            <p:spPr>
              <a:xfrm>
                <a:off x="5325894" y="2164280"/>
                <a:ext cx="119869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6</a:t>
                </a:r>
                <a:endParaRPr/>
              </a:p>
            </p:txBody>
          </p:sp>
          <p:sp>
            <p:nvSpPr>
              <p:cNvPr id="145" name="Google Shape;145;p1"/>
              <p:cNvSpPr txBox="1"/>
              <p:nvPr/>
            </p:nvSpPr>
            <p:spPr>
              <a:xfrm>
                <a:off x="5632125" y="2165124"/>
                <a:ext cx="119869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2</a:t>
                </a:r>
                <a:endParaRPr/>
              </a:p>
            </p:txBody>
          </p:sp>
        </p:grpSp>
        <p:pic>
          <p:nvPicPr>
            <p:cNvPr id="146" name="Google Shape;146;p1" descr="image.png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4287108" y="882122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147" name="Google Shape;147;p1"/>
            <p:cNvGrpSpPr/>
            <p:nvPr/>
          </p:nvGrpSpPr>
          <p:grpSpPr>
            <a:xfrm>
              <a:off x="4196073" y="834526"/>
              <a:ext cx="247316" cy="1338655"/>
              <a:chOff x="4196073" y="834526"/>
              <a:chExt cx="247316" cy="1338655"/>
            </a:xfrm>
          </p:grpSpPr>
          <p:sp>
            <p:nvSpPr>
              <p:cNvPr id="148" name="Google Shape;148;p1"/>
              <p:cNvSpPr txBox="1"/>
              <p:nvPr/>
            </p:nvSpPr>
            <p:spPr>
              <a:xfrm>
                <a:off x="4223917" y="2029337"/>
                <a:ext cx="207519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9</a:t>
                </a:r>
                <a:endParaRPr/>
              </a:p>
            </p:txBody>
          </p:sp>
          <p:sp>
            <p:nvSpPr>
              <p:cNvPr id="149" name="Google Shape;149;p1"/>
              <p:cNvSpPr txBox="1"/>
              <p:nvPr/>
            </p:nvSpPr>
            <p:spPr>
              <a:xfrm>
                <a:off x="4223919" y="1735300"/>
                <a:ext cx="207518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40</a:t>
                </a:r>
                <a:endParaRPr/>
              </a:p>
            </p:txBody>
          </p:sp>
          <p:sp>
            <p:nvSpPr>
              <p:cNvPr id="150" name="Google Shape;150;p1"/>
              <p:cNvSpPr txBox="1"/>
              <p:nvPr/>
            </p:nvSpPr>
            <p:spPr>
              <a:xfrm>
                <a:off x="4196073" y="1434883"/>
                <a:ext cx="247316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0.6</a:t>
                </a:r>
                <a:endParaRPr dirty="0"/>
              </a:p>
            </p:txBody>
          </p:sp>
          <p:sp>
            <p:nvSpPr>
              <p:cNvPr id="151" name="Google Shape;151;p1"/>
              <p:cNvSpPr txBox="1"/>
              <p:nvPr/>
            </p:nvSpPr>
            <p:spPr>
              <a:xfrm>
                <a:off x="4259873" y="1134659"/>
                <a:ext cx="159192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9</a:t>
                </a:r>
                <a:endParaRPr/>
              </a:p>
            </p:txBody>
          </p:sp>
          <p:sp>
            <p:nvSpPr>
              <p:cNvPr id="152" name="Google Shape;152;p1"/>
              <p:cNvSpPr txBox="1"/>
              <p:nvPr/>
            </p:nvSpPr>
            <p:spPr>
              <a:xfrm>
                <a:off x="4259873" y="834526"/>
                <a:ext cx="159192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8</a:t>
                </a:r>
                <a:endParaRPr dirty="0"/>
              </a:p>
            </p:txBody>
          </p:sp>
        </p:grpSp>
        <p:sp>
          <p:nvSpPr>
            <p:cNvPr id="153" name="Google Shape;153;p1"/>
            <p:cNvSpPr/>
            <p:nvPr/>
          </p:nvSpPr>
          <p:spPr>
            <a:xfrm>
              <a:off x="5680162" y="882122"/>
              <a:ext cx="60045" cy="1200908"/>
            </a:xfrm>
            <a:prstGeom prst="rect">
              <a:avLst/>
            </a:prstGeom>
            <a:gradFill>
              <a:gsLst>
                <a:gs pos="0">
                  <a:srgbClr val="00007F"/>
                </a:gs>
                <a:gs pos="1562">
                  <a:srgbClr val="000091"/>
                </a:gs>
                <a:gs pos="3125">
                  <a:srgbClr val="0000A3"/>
                </a:gs>
                <a:gs pos="4688">
                  <a:srgbClr val="0000B6"/>
                </a:gs>
                <a:gs pos="6250">
                  <a:srgbClr val="0000C8"/>
                </a:gs>
                <a:gs pos="7812">
                  <a:srgbClr val="0000DA"/>
                </a:gs>
                <a:gs pos="9375">
                  <a:srgbClr val="0000EC"/>
                </a:gs>
                <a:gs pos="10938">
                  <a:srgbClr val="0000FE"/>
                </a:gs>
                <a:gs pos="12500">
                  <a:srgbClr val="0000FF"/>
                </a:gs>
                <a:gs pos="14062">
                  <a:srgbClr val="0010FF"/>
                </a:gs>
                <a:gs pos="15625">
                  <a:srgbClr val="0020FF"/>
                </a:gs>
                <a:gs pos="17188">
                  <a:srgbClr val="0030FF"/>
                </a:gs>
                <a:gs pos="18750">
                  <a:srgbClr val="0040FF"/>
                </a:gs>
                <a:gs pos="20312">
                  <a:srgbClr val="0050FF"/>
                </a:gs>
                <a:gs pos="21875">
                  <a:srgbClr val="0060FF"/>
                </a:gs>
                <a:gs pos="23438">
                  <a:srgbClr val="0070FF"/>
                </a:gs>
                <a:gs pos="25000">
                  <a:srgbClr val="0084FF"/>
                </a:gs>
                <a:gs pos="26562">
                  <a:srgbClr val="0094FF"/>
                </a:gs>
                <a:gs pos="28125">
                  <a:srgbClr val="00A4FF"/>
                </a:gs>
                <a:gs pos="29688">
                  <a:srgbClr val="00B4FF"/>
                </a:gs>
                <a:gs pos="31250">
                  <a:srgbClr val="00C4FF"/>
                </a:gs>
                <a:gs pos="32812">
                  <a:srgbClr val="00D4FF"/>
                </a:gs>
                <a:gs pos="34375">
                  <a:srgbClr val="00E4F7"/>
                </a:gs>
                <a:gs pos="35938">
                  <a:srgbClr val="0CF4EA"/>
                </a:gs>
                <a:gs pos="37500">
                  <a:srgbClr val="18FFDD"/>
                </a:gs>
                <a:gs pos="39062">
                  <a:srgbClr val="25FFD0"/>
                </a:gs>
                <a:gs pos="40625">
                  <a:srgbClr val="32FFC3"/>
                </a:gs>
                <a:gs pos="42188">
                  <a:srgbClr val="3FFFB7"/>
                </a:gs>
                <a:gs pos="43750">
                  <a:srgbClr val="4CFFAA"/>
                </a:gs>
                <a:gs pos="45312">
                  <a:srgbClr val="59FF9D"/>
                </a:gs>
                <a:gs pos="46875">
                  <a:srgbClr val="66FF90"/>
                </a:gs>
                <a:gs pos="48438">
                  <a:srgbClr val="73FF83"/>
                </a:gs>
                <a:gs pos="50000">
                  <a:srgbClr val="83FF73"/>
                </a:gs>
                <a:gs pos="51562">
                  <a:srgbClr val="90FF66"/>
                </a:gs>
                <a:gs pos="53125">
                  <a:srgbClr val="9DFF59"/>
                </a:gs>
                <a:gs pos="54688">
                  <a:srgbClr val="AAFF4C"/>
                </a:gs>
                <a:gs pos="56250">
                  <a:srgbClr val="B7FF3F"/>
                </a:gs>
                <a:gs pos="57812">
                  <a:srgbClr val="C3FF32"/>
                </a:gs>
                <a:gs pos="59375">
                  <a:srgbClr val="D0FF25"/>
                </a:gs>
                <a:gs pos="60938">
                  <a:srgbClr val="DDFF18"/>
                </a:gs>
                <a:gs pos="62500">
                  <a:srgbClr val="EAFF0C"/>
                </a:gs>
                <a:gs pos="64061">
                  <a:srgbClr val="F7F400"/>
                </a:gs>
                <a:gs pos="65625">
                  <a:srgbClr val="FFE500"/>
                </a:gs>
                <a:gs pos="67188">
                  <a:srgbClr val="FFD700"/>
                </a:gs>
                <a:gs pos="68750">
                  <a:srgbClr val="FFC800"/>
                </a:gs>
                <a:gs pos="70312">
                  <a:srgbClr val="FFB900"/>
                </a:gs>
                <a:gs pos="71875">
                  <a:srgbClr val="FFAA00"/>
                </a:gs>
                <a:gs pos="73438">
                  <a:srgbClr val="FF9B00"/>
                </a:gs>
                <a:gs pos="75000">
                  <a:srgbClr val="FF8900"/>
                </a:gs>
                <a:gs pos="76562">
                  <a:srgbClr val="FF7A00"/>
                </a:gs>
                <a:gs pos="78125">
                  <a:srgbClr val="FF6B00"/>
                </a:gs>
                <a:gs pos="79688">
                  <a:srgbClr val="FF5C00"/>
                </a:gs>
                <a:gs pos="81250">
                  <a:srgbClr val="FF4D00"/>
                </a:gs>
                <a:gs pos="82812">
                  <a:srgbClr val="FF3F00"/>
                </a:gs>
                <a:gs pos="84375">
                  <a:srgbClr val="FF3000"/>
                </a:gs>
                <a:gs pos="85938">
                  <a:srgbClr val="FF2100"/>
                </a:gs>
                <a:gs pos="87500">
                  <a:srgbClr val="FE1200"/>
                </a:gs>
                <a:gs pos="89062">
                  <a:srgbClr val="EC0300"/>
                </a:gs>
                <a:gs pos="90625">
                  <a:srgbClr val="DA0000"/>
                </a:gs>
                <a:gs pos="92188">
                  <a:srgbClr val="C80000"/>
                </a:gs>
                <a:gs pos="93750">
                  <a:srgbClr val="B60000"/>
                </a:gs>
                <a:gs pos="95312">
                  <a:srgbClr val="A30000"/>
                </a:gs>
                <a:gs pos="96875">
                  <a:srgbClr val="910000"/>
                </a:gs>
                <a:gs pos="98438">
                  <a:srgbClr val="7F0000"/>
                </a:gs>
                <a:gs pos="100000">
                  <a:srgbClr val="7F0000"/>
                </a:gs>
              </a:gsLst>
              <a:lin ang="16200000" scaled="0"/>
            </a:gra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54" name="Google Shape;154;p1"/>
            <p:cNvSpPr/>
            <p:nvPr/>
          </p:nvSpPr>
          <p:spPr>
            <a:xfrm>
              <a:off x="5677161" y="879120"/>
              <a:ext cx="66049" cy="1206914"/>
            </a:xfrm>
            <a:custGeom>
              <a:avLst/>
              <a:gdLst/>
              <a:ahLst/>
              <a:cxnLst/>
              <a:rect l="l" t="t" r="r" b="b"/>
              <a:pathLst>
                <a:path w="66049" h="1206914" extrusionOk="0">
                  <a:moveTo>
                    <a:pt x="0" y="0"/>
                  </a:moveTo>
                  <a:lnTo>
                    <a:pt x="66049" y="0"/>
                  </a:lnTo>
                  <a:lnTo>
                    <a:pt x="66049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55" name="Google Shape;155;p1" descr="image.png"/>
            <p:cNvPicPr preferRelativeResize="0"/>
            <p:nvPr/>
          </p:nvPicPr>
          <p:blipFill rotWithShape="1">
            <a:blip r:embed="rId6">
              <a:alphaModFix/>
            </a:blip>
            <a:srcRect/>
            <a:stretch/>
          </p:blipFill>
          <p:spPr>
            <a:xfrm>
              <a:off x="5746212" y="882122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56" name="Google Shape;156;p1"/>
            <p:cNvSpPr txBox="1"/>
            <p:nvPr/>
          </p:nvSpPr>
          <p:spPr>
            <a:xfrm>
              <a:off x="5806257" y="1134502"/>
              <a:ext cx="188907" cy="14384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10¹</a:t>
              </a:r>
              <a:endParaRPr dirty="0"/>
            </a:p>
          </p:txBody>
        </p:sp>
      </p:grpSp>
      <p:grpSp>
        <p:nvGrpSpPr>
          <p:cNvPr id="157" name="Google Shape;157;p1"/>
          <p:cNvGrpSpPr/>
          <p:nvPr/>
        </p:nvGrpSpPr>
        <p:grpSpPr>
          <a:xfrm>
            <a:off x="4956880" y="979659"/>
            <a:ext cx="1528445" cy="1289168"/>
            <a:chOff x="6016992" y="720000"/>
            <a:chExt cx="2040969" cy="1721456"/>
          </a:xfrm>
        </p:grpSpPr>
        <p:pic>
          <p:nvPicPr>
            <p:cNvPr id="158" name="Google Shape;158;p1" descr="image.png"/>
            <p:cNvPicPr preferRelativeResize="0"/>
            <p:nvPr/>
          </p:nvPicPr>
          <p:blipFill rotWithShape="1">
            <a:blip r:embed="rId9">
              <a:alphaModFix/>
            </a:blip>
            <a:srcRect/>
            <a:stretch/>
          </p:blipFill>
          <p:spPr>
            <a:xfrm>
              <a:off x="6106485" y="720000"/>
              <a:ext cx="1951476" cy="170529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59" name="Google Shape;159;p1"/>
            <p:cNvSpPr/>
            <p:nvPr/>
          </p:nvSpPr>
          <p:spPr>
            <a:xfrm>
              <a:off x="6445742" y="879120"/>
              <a:ext cx="1206914" cy="1206914"/>
            </a:xfrm>
            <a:custGeom>
              <a:avLst/>
              <a:gdLst/>
              <a:ahLst/>
              <a:cxnLst/>
              <a:rect l="l" t="t" r="r" b="b"/>
              <a:pathLst>
                <a:path w="1206914" h="1206914" extrusionOk="0">
                  <a:moveTo>
                    <a:pt x="0" y="0"/>
                  </a:moveTo>
                  <a:lnTo>
                    <a:pt x="1206914" y="0"/>
                  </a:lnTo>
                  <a:lnTo>
                    <a:pt x="1206914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60" name="Google Shape;160;p1"/>
            <p:cNvSpPr txBox="1"/>
            <p:nvPr/>
          </p:nvSpPr>
          <p:spPr>
            <a:xfrm>
              <a:off x="6863059" y="2276490"/>
              <a:ext cx="600017" cy="16496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1</a:t>
              </a:r>
              <a:endParaRPr dirty="0"/>
            </a:p>
          </p:txBody>
        </p:sp>
        <p:sp>
          <p:nvSpPr>
            <p:cNvPr id="161" name="Google Shape;161;p1"/>
            <p:cNvSpPr txBox="1"/>
            <p:nvPr/>
          </p:nvSpPr>
          <p:spPr>
            <a:xfrm rot="16200000">
              <a:off x="5801099" y="1361557"/>
              <a:ext cx="596180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2</a:t>
              </a:r>
              <a:endParaRPr dirty="0"/>
            </a:p>
          </p:txBody>
        </p:sp>
        <p:pic>
          <p:nvPicPr>
            <p:cNvPr id="162" name="Google Shape;162;p1" descr="image.png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6448744" y="2089035"/>
              <a:ext cx="1194903" cy="180135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163" name="Google Shape;163;p1"/>
            <p:cNvGrpSpPr/>
            <p:nvPr/>
          </p:nvGrpSpPr>
          <p:grpSpPr>
            <a:xfrm>
              <a:off x="6400706" y="2164280"/>
              <a:ext cx="1398958" cy="145531"/>
              <a:chOff x="6400706" y="2164280"/>
              <a:chExt cx="1398958" cy="145531"/>
            </a:xfrm>
          </p:grpSpPr>
          <p:sp>
            <p:nvSpPr>
              <p:cNvPr id="164" name="Google Shape;164;p1"/>
              <p:cNvSpPr txBox="1"/>
              <p:nvPr/>
            </p:nvSpPr>
            <p:spPr>
              <a:xfrm>
                <a:off x="6400706" y="2165968"/>
                <a:ext cx="250345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1</a:t>
                </a:r>
                <a:endParaRPr dirty="0"/>
              </a:p>
            </p:txBody>
          </p:sp>
          <p:sp>
            <p:nvSpPr>
              <p:cNvPr id="165" name="Google Shape;165;p1"/>
              <p:cNvSpPr txBox="1"/>
              <p:nvPr/>
            </p:nvSpPr>
            <p:spPr>
              <a:xfrm>
                <a:off x="6688921" y="2164280"/>
                <a:ext cx="250345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36</a:t>
                </a:r>
                <a:endParaRPr/>
              </a:p>
            </p:txBody>
          </p:sp>
          <p:sp>
            <p:nvSpPr>
              <p:cNvPr id="166" name="Google Shape;166;p1"/>
              <p:cNvSpPr txBox="1"/>
              <p:nvPr/>
            </p:nvSpPr>
            <p:spPr>
              <a:xfrm>
                <a:off x="6995152" y="2164373"/>
                <a:ext cx="240055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0.4</a:t>
                </a:r>
                <a:endParaRPr/>
              </a:p>
            </p:txBody>
          </p:sp>
          <p:sp>
            <p:nvSpPr>
              <p:cNvPr id="167" name="Google Shape;167;p1"/>
              <p:cNvSpPr txBox="1"/>
              <p:nvPr/>
            </p:nvSpPr>
            <p:spPr>
              <a:xfrm>
                <a:off x="7301389" y="2164280"/>
                <a:ext cx="192044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6</a:t>
                </a:r>
                <a:endParaRPr/>
              </a:p>
            </p:txBody>
          </p:sp>
          <p:sp>
            <p:nvSpPr>
              <p:cNvPr id="168" name="Google Shape;168;p1"/>
              <p:cNvSpPr txBox="1"/>
              <p:nvPr/>
            </p:nvSpPr>
            <p:spPr>
              <a:xfrm>
                <a:off x="7607620" y="2165124"/>
                <a:ext cx="192044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2</a:t>
                </a:r>
                <a:endParaRPr/>
              </a:p>
            </p:txBody>
          </p:sp>
        </p:grpSp>
        <p:pic>
          <p:nvPicPr>
            <p:cNvPr id="169" name="Google Shape;169;p1" descr="image.png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6262603" y="882122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170" name="Google Shape;170;p1"/>
            <p:cNvGrpSpPr/>
            <p:nvPr/>
          </p:nvGrpSpPr>
          <p:grpSpPr>
            <a:xfrm>
              <a:off x="6171568" y="833419"/>
              <a:ext cx="247316" cy="1338655"/>
              <a:chOff x="6171568" y="833419"/>
              <a:chExt cx="247316" cy="1338655"/>
            </a:xfrm>
          </p:grpSpPr>
          <p:sp>
            <p:nvSpPr>
              <p:cNvPr id="171" name="Google Shape;171;p1"/>
              <p:cNvSpPr txBox="1"/>
              <p:nvPr/>
            </p:nvSpPr>
            <p:spPr>
              <a:xfrm>
                <a:off x="6199412" y="2028230"/>
                <a:ext cx="207519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9</a:t>
                </a:r>
                <a:endParaRPr dirty="0"/>
              </a:p>
            </p:txBody>
          </p:sp>
          <p:sp>
            <p:nvSpPr>
              <p:cNvPr id="172" name="Google Shape;172;p1"/>
              <p:cNvSpPr txBox="1"/>
              <p:nvPr/>
            </p:nvSpPr>
            <p:spPr>
              <a:xfrm>
                <a:off x="6199414" y="1734193"/>
                <a:ext cx="207518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40</a:t>
                </a:r>
                <a:endParaRPr/>
              </a:p>
            </p:txBody>
          </p:sp>
          <p:sp>
            <p:nvSpPr>
              <p:cNvPr id="173" name="Google Shape;173;p1"/>
              <p:cNvSpPr txBox="1"/>
              <p:nvPr/>
            </p:nvSpPr>
            <p:spPr>
              <a:xfrm>
                <a:off x="6171568" y="1433776"/>
                <a:ext cx="247316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0.6</a:t>
                </a:r>
                <a:endParaRPr/>
              </a:p>
            </p:txBody>
          </p:sp>
          <p:sp>
            <p:nvSpPr>
              <p:cNvPr id="174" name="Google Shape;174;p1"/>
              <p:cNvSpPr txBox="1"/>
              <p:nvPr/>
            </p:nvSpPr>
            <p:spPr>
              <a:xfrm>
                <a:off x="6235368" y="1133552"/>
                <a:ext cx="159192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9</a:t>
                </a:r>
                <a:endParaRPr/>
              </a:p>
            </p:txBody>
          </p:sp>
          <p:sp>
            <p:nvSpPr>
              <p:cNvPr id="175" name="Google Shape;175;p1"/>
              <p:cNvSpPr txBox="1"/>
              <p:nvPr/>
            </p:nvSpPr>
            <p:spPr>
              <a:xfrm>
                <a:off x="6235368" y="833419"/>
                <a:ext cx="159192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8</a:t>
                </a:r>
                <a:endParaRPr dirty="0"/>
              </a:p>
            </p:txBody>
          </p:sp>
        </p:grpSp>
        <p:sp>
          <p:nvSpPr>
            <p:cNvPr id="176" name="Google Shape;176;p1"/>
            <p:cNvSpPr/>
            <p:nvPr/>
          </p:nvSpPr>
          <p:spPr>
            <a:xfrm>
              <a:off x="7655657" y="882122"/>
              <a:ext cx="60045" cy="1200908"/>
            </a:xfrm>
            <a:prstGeom prst="rect">
              <a:avLst/>
            </a:prstGeom>
            <a:gradFill>
              <a:gsLst>
                <a:gs pos="0">
                  <a:srgbClr val="00007F"/>
                </a:gs>
                <a:gs pos="1562">
                  <a:srgbClr val="000091"/>
                </a:gs>
                <a:gs pos="3125">
                  <a:srgbClr val="0000A3"/>
                </a:gs>
                <a:gs pos="4688">
                  <a:srgbClr val="0000B6"/>
                </a:gs>
                <a:gs pos="6250">
                  <a:srgbClr val="0000C8"/>
                </a:gs>
                <a:gs pos="7812">
                  <a:srgbClr val="0000DA"/>
                </a:gs>
                <a:gs pos="9375">
                  <a:srgbClr val="0000EC"/>
                </a:gs>
                <a:gs pos="10938">
                  <a:srgbClr val="0000FE"/>
                </a:gs>
                <a:gs pos="12500">
                  <a:srgbClr val="0000FF"/>
                </a:gs>
                <a:gs pos="14062">
                  <a:srgbClr val="0010FF"/>
                </a:gs>
                <a:gs pos="15625">
                  <a:srgbClr val="0020FF"/>
                </a:gs>
                <a:gs pos="17188">
                  <a:srgbClr val="0030FF"/>
                </a:gs>
                <a:gs pos="18750">
                  <a:srgbClr val="0040FF"/>
                </a:gs>
                <a:gs pos="20312">
                  <a:srgbClr val="0050FF"/>
                </a:gs>
                <a:gs pos="21875">
                  <a:srgbClr val="0060FF"/>
                </a:gs>
                <a:gs pos="23438">
                  <a:srgbClr val="0070FF"/>
                </a:gs>
                <a:gs pos="25000">
                  <a:srgbClr val="0084FF"/>
                </a:gs>
                <a:gs pos="26562">
                  <a:srgbClr val="0094FF"/>
                </a:gs>
                <a:gs pos="28125">
                  <a:srgbClr val="00A4FF"/>
                </a:gs>
                <a:gs pos="29688">
                  <a:srgbClr val="00B4FF"/>
                </a:gs>
                <a:gs pos="31250">
                  <a:srgbClr val="00C4FF"/>
                </a:gs>
                <a:gs pos="32812">
                  <a:srgbClr val="00D4FF"/>
                </a:gs>
                <a:gs pos="34375">
                  <a:srgbClr val="00E4F7"/>
                </a:gs>
                <a:gs pos="35938">
                  <a:srgbClr val="0CF4EA"/>
                </a:gs>
                <a:gs pos="37500">
                  <a:srgbClr val="18FFDD"/>
                </a:gs>
                <a:gs pos="39062">
                  <a:srgbClr val="25FFD0"/>
                </a:gs>
                <a:gs pos="40625">
                  <a:srgbClr val="32FFC3"/>
                </a:gs>
                <a:gs pos="42188">
                  <a:srgbClr val="3FFFB7"/>
                </a:gs>
                <a:gs pos="43750">
                  <a:srgbClr val="4CFFAA"/>
                </a:gs>
                <a:gs pos="45312">
                  <a:srgbClr val="59FF9D"/>
                </a:gs>
                <a:gs pos="46875">
                  <a:srgbClr val="66FF90"/>
                </a:gs>
                <a:gs pos="48438">
                  <a:srgbClr val="73FF83"/>
                </a:gs>
                <a:gs pos="50000">
                  <a:srgbClr val="83FF73"/>
                </a:gs>
                <a:gs pos="51562">
                  <a:srgbClr val="90FF66"/>
                </a:gs>
                <a:gs pos="53125">
                  <a:srgbClr val="9DFF59"/>
                </a:gs>
                <a:gs pos="54688">
                  <a:srgbClr val="AAFF4C"/>
                </a:gs>
                <a:gs pos="56250">
                  <a:srgbClr val="B7FF3F"/>
                </a:gs>
                <a:gs pos="57812">
                  <a:srgbClr val="C3FF32"/>
                </a:gs>
                <a:gs pos="59375">
                  <a:srgbClr val="D0FF25"/>
                </a:gs>
                <a:gs pos="60938">
                  <a:srgbClr val="DDFF18"/>
                </a:gs>
                <a:gs pos="62500">
                  <a:srgbClr val="EAFF0C"/>
                </a:gs>
                <a:gs pos="64061">
                  <a:srgbClr val="F7F400"/>
                </a:gs>
                <a:gs pos="65625">
                  <a:srgbClr val="FFE500"/>
                </a:gs>
                <a:gs pos="67188">
                  <a:srgbClr val="FFD700"/>
                </a:gs>
                <a:gs pos="68750">
                  <a:srgbClr val="FFC800"/>
                </a:gs>
                <a:gs pos="70312">
                  <a:srgbClr val="FFB900"/>
                </a:gs>
                <a:gs pos="71875">
                  <a:srgbClr val="FFAA00"/>
                </a:gs>
                <a:gs pos="73438">
                  <a:srgbClr val="FF9B00"/>
                </a:gs>
                <a:gs pos="75000">
                  <a:srgbClr val="FF8900"/>
                </a:gs>
                <a:gs pos="76562">
                  <a:srgbClr val="FF7A00"/>
                </a:gs>
                <a:gs pos="78125">
                  <a:srgbClr val="FF6B00"/>
                </a:gs>
                <a:gs pos="79688">
                  <a:srgbClr val="FF5C00"/>
                </a:gs>
                <a:gs pos="81250">
                  <a:srgbClr val="FF4D00"/>
                </a:gs>
                <a:gs pos="82812">
                  <a:srgbClr val="FF3F00"/>
                </a:gs>
                <a:gs pos="84375">
                  <a:srgbClr val="FF3000"/>
                </a:gs>
                <a:gs pos="85938">
                  <a:srgbClr val="FF2100"/>
                </a:gs>
                <a:gs pos="87500">
                  <a:srgbClr val="FE1200"/>
                </a:gs>
                <a:gs pos="89062">
                  <a:srgbClr val="EC0300"/>
                </a:gs>
                <a:gs pos="90625">
                  <a:srgbClr val="DA0000"/>
                </a:gs>
                <a:gs pos="92188">
                  <a:srgbClr val="C80000"/>
                </a:gs>
                <a:gs pos="93750">
                  <a:srgbClr val="B60000"/>
                </a:gs>
                <a:gs pos="95312">
                  <a:srgbClr val="A30000"/>
                </a:gs>
                <a:gs pos="96875">
                  <a:srgbClr val="910000"/>
                </a:gs>
                <a:gs pos="98438">
                  <a:srgbClr val="7F0000"/>
                </a:gs>
                <a:gs pos="100000">
                  <a:srgbClr val="7F0000"/>
                </a:gs>
              </a:gsLst>
              <a:lin ang="16200000" scaled="0"/>
            </a:gra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77" name="Google Shape;177;p1"/>
            <p:cNvSpPr/>
            <p:nvPr/>
          </p:nvSpPr>
          <p:spPr>
            <a:xfrm>
              <a:off x="7652656" y="879120"/>
              <a:ext cx="66049" cy="1206914"/>
            </a:xfrm>
            <a:custGeom>
              <a:avLst/>
              <a:gdLst/>
              <a:ahLst/>
              <a:cxnLst/>
              <a:rect l="l" t="t" r="r" b="b"/>
              <a:pathLst>
                <a:path w="66049" h="1206914" extrusionOk="0">
                  <a:moveTo>
                    <a:pt x="0" y="0"/>
                  </a:moveTo>
                  <a:lnTo>
                    <a:pt x="66049" y="0"/>
                  </a:lnTo>
                  <a:lnTo>
                    <a:pt x="66049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78" name="Google Shape;178;p1" descr="image.png"/>
            <p:cNvPicPr preferRelativeResize="0"/>
            <p:nvPr/>
          </p:nvPicPr>
          <p:blipFill rotWithShape="1">
            <a:blip r:embed="rId6">
              <a:alphaModFix/>
            </a:blip>
            <a:srcRect/>
            <a:stretch/>
          </p:blipFill>
          <p:spPr>
            <a:xfrm>
              <a:off x="7721707" y="882122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79" name="Google Shape;179;p1"/>
            <p:cNvSpPr txBox="1"/>
            <p:nvPr/>
          </p:nvSpPr>
          <p:spPr>
            <a:xfrm>
              <a:off x="7781753" y="1134502"/>
              <a:ext cx="276208" cy="14384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10¹</a:t>
              </a:r>
              <a:endParaRPr dirty="0"/>
            </a:p>
          </p:txBody>
        </p:sp>
      </p:grpSp>
      <p:grpSp>
        <p:nvGrpSpPr>
          <p:cNvPr id="180" name="Google Shape;180;p1"/>
          <p:cNvGrpSpPr/>
          <p:nvPr/>
        </p:nvGrpSpPr>
        <p:grpSpPr>
          <a:xfrm>
            <a:off x="502328" y="2341783"/>
            <a:ext cx="1524193" cy="1288740"/>
            <a:chOff x="7998163" y="720000"/>
            <a:chExt cx="2035293" cy="1720884"/>
          </a:xfrm>
        </p:grpSpPr>
        <p:pic>
          <p:nvPicPr>
            <p:cNvPr id="181" name="Google Shape;181;p1" descr="image.png"/>
            <p:cNvPicPr preferRelativeResize="0"/>
            <p:nvPr/>
          </p:nvPicPr>
          <p:blipFill rotWithShape="1">
            <a:blip r:embed="rId10">
              <a:alphaModFix/>
            </a:blip>
            <a:srcRect/>
            <a:stretch/>
          </p:blipFill>
          <p:spPr>
            <a:xfrm>
              <a:off x="8081980" y="720000"/>
              <a:ext cx="1951476" cy="170529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82" name="Google Shape;182;p1"/>
            <p:cNvSpPr/>
            <p:nvPr/>
          </p:nvSpPr>
          <p:spPr>
            <a:xfrm>
              <a:off x="8421236" y="879120"/>
              <a:ext cx="1206914" cy="1206914"/>
            </a:xfrm>
            <a:custGeom>
              <a:avLst/>
              <a:gdLst/>
              <a:ahLst/>
              <a:cxnLst/>
              <a:rect l="l" t="t" r="r" b="b"/>
              <a:pathLst>
                <a:path w="1206914" h="1206914" extrusionOk="0">
                  <a:moveTo>
                    <a:pt x="0" y="0"/>
                  </a:moveTo>
                  <a:lnTo>
                    <a:pt x="1206914" y="0"/>
                  </a:lnTo>
                  <a:lnTo>
                    <a:pt x="1206914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83" name="Google Shape;183;p1"/>
            <p:cNvSpPr txBox="1"/>
            <p:nvPr/>
          </p:nvSpPr>
          <p:spPr>
            <a:xfrm>
              <a:off x="8838553" y="2276491"/>
              <a:ext cx="588969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1</a:t>
              </a:r>
              <a:endParaRPr dirty="0"/>
            </a:p>
          </p:txBody>
        </p:sp>
        <p:sp>
          <p:nvSpPr>
            <p:cNvPr id="184" name="Google Shape;184;p1"/>
            <p:cNvSpPr txBox="1"/>
            <p:nvPr/>
          </p:nvSpPr>
          <p:spPr>
            <a:xfrm rot="16200000">
              <a:off x="7742792" y="1348928"/>
              <a:ext cx="675135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2</a:t>
              </a:r>
              <a:endParaRPr dirty="0"/>
            </a:p>
          </p:txBody>
        </p:sp>
        <p:pic>
          <p:nvPicPr>
            <p:cNvPr id="185" name="Google Shape;185;p1" descr="image.png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8424238" y="2089035"/>
              <a:ext cx="1194903" cy="180135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186" name="Google Shape;186;p1"/>
            <p:cNvGrpSpPr/>
            <p:nvPr/>
          </p:nvGrpSpPr>
          <p:grpSpPr>
            <a:xfrm>
              <a:off x="8376202" y="2164280"/>
              <a:ext cx="1375034" cy="145531"/>
              <a:chOff x="8376202" y="2164280"/>
              <a:chExt cx="1375034" cy="145531"/>
            </a:xfrm>
          </p:grpSpPr>
          <p:sp>
            <p:nvSpPr>
              <p:cNvPr id="187" name="Google Shape;187;p1"/>
              <p:cNvSpPr txBox="1"/>
              <p:nvPr/>
            </p:nvSpPr>
            <p:spPr>
              <a:xfrm>
                <a:off x="8376202" y="2165968"/>
                <a:ext cx="219164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1</a:t>
                </a:r>
                <a:endParaRPr dirty="0"/>
              </a:p>
            </p:txBody>
          </p:sp>
          <p:sp>
            <p:nvSpPr>
              <p:cNvPr id="188" name="Google Shape;188;p1"/>
              <p:cNvSpPr txBox="1"/>
              <p:nvPr/>
            </p:nvSpPr>
            <p:spPr>
              <a:xfrm>
                <a:off x="8664420" y="2164280"/>
                <a:ext cx="219164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36</a:t>
                </a:r>
                <a:endParaRPr/>
              </a:p>
            </p:txBody>
          </p:sp>
          <p:sp>
            <p:nvSpPr>
              <p:cNvPr id="189" name="Google Shape;189;p1"/>
              <p:cNvSpPr txBox="1"/>
              <p:nvPr/>
            </p:nvSpPr>
            <p:spPr>
              <a:xfrm>
                <a:off x="8970651" y="2164373"/>
                <a:ext cx="210155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0.4</a:t>
                </a:r>
                <a:endParaRPr/>
              </a:p>
            </p:txBody>
          </p:sp>
          <p:sp>
            <p:nvSpPr>
              <p:cNvPr id="190" name="Google Shape;190;p1"/>
              <p:cNvSpPr txBox="1"/>
              <p:nvPr/>
            </p:nvSpPr>
            <p:spPr>
              <a:xfrm>
                <a:off x="9276881" y="2164280"/>
                <a:ext cx="168124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6</a:t>
                </a:r>
                <a:endParaRPr/>
              </a:p>
            </p:txBody>
          </p:sp>
          <p:sp>
            <p:nvSpPr>
              <p:cNvPr id="191" name="Google Shape;191;p1"/>
              <p:cNvSpPr txBox="1"/>
              <p:nvPr/>
            </p:nvSpPr>
            <p:spPr>
              <a:xfrm>
                <a:off x="9583112" y="2165124"/>
                <a:ext cx="168124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2</a:t>
                </a:r>
                <a:endParaRPr/>
              </a:p>
            </p:txBody>
          </p:sp>
        </p:grpSp>
        <p:pic>
          <p:nvPicPr>
            <p:cNvPr id="192" name="Google Shape;192;p1" descr="image.png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8238098" y="882122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193" name="Google Shape;193;p1"/>
            <p:cNvGrpSpPr/>
            <p:nvPr/>
          </p:nvGrpSpPr>
          <p:grpSpPr>
            <a:xfrm>
              <a:off x="8157170" y="849379"/>
              <a:ext cx="237209" cy="1338653"/>
              <a:chOff x="8157170" y="849379"/>
              <a:chExt cx="237209" cy="1338653"/>
            </a:xfrm>
          </p:grpSpPr>
          <p:sp>
            <p:nvSpPr>
              <p:cNvPr id="194" name="Google Shape;194;p1"/>
              <p:cNvSpPr txBox="1"/>
              <p:nvPr/>
            </p:nvSpPr>
            <p:spPr>
              <a:xfrm>
                <a:off x="8183388" y="2044190"/>
                <a:ext cx="199039" cy="14384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9</a:t>
                </a:r>
                <a:endParaRPr/>
              </a:p>
            </p:txBody>
          </p:sp>
          <p:sp>
            <p:nvSpPr>
              <p:cNvPr id="195" name="Google Shape;195;p1"/>
              <p:cNvSpPr txBox="1"/>
              <p:nvPr/>
            </p:nvSpPr>
            <p:spPr>
              <a:xfrm>
                <a:off x="8169623" y="1750152"/>
                <a:ext cx="212802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40</a:t>
                </a:r>
                <a:endParaRPr/>
              </a:p>
            </p:txBody>
          </p:sp>
          <p:sp>
            <p:nvSpPr>
              <p:cNvPr id="196" name="Google Shape;196;p1"/>
              <p:cNvSpPr txBox="1"/>
              <p:nvPr/>
            </p:nvSpPr>
            <p:spPr>
              <a:xfrm>
                <a:off x="8157170" y="1449736"/>
                <a:ext cx="237209" cy="14384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0.6</a:t>
                </a:r>
                <a:endParaRPr/>
              </a:p>
            </p:txBody>
          </p:sp>
          <p:sp>
            <p:nvSpPr>
              <p:cNvPr id="197" name="Google Shape;197;p1"/>
              <p:cNvSpPr txBox="1"/>
              <p:nvPr/>
            </p:nvSpPr>
            <p:spPr>
              <a:xfrm>
                <a:off x="8206812" y="1149510"/>
                <a:ext cx="163247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9</a:t>
                </a:r>
                <a:endParaRPr dirty="0"/>
              </a:p>
            </p:txBody>
          </p:sp>
          <p:sp>
            <p:nvSpPr>
              <p:cNvPr id="198" name="Google Shape;198;p1"/>
              <p:cNvSpPr txBox="1"/>
              <p:nvPr/>
            </p:nvSpPr>
            <p:spPr>
              <a:xfrm>
                <a:off x="8209389" y="849379"/>
                <a:ext cx="152685" cy="14384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8</a:t>
                </a:r>
                <a:endParaRPr dirty="0"/>
              </a:p>
            </p:txBody>
          </p:sp>
        </p:grpSp>
        <p:sp>
          <p:nvSpPr>
            <p:cNvPr id="199" name="Google Shape;199;p1"/>
            <p:cNvSpPr/>
            <p:nvPr/>
          </p:nvSpPr>
          <p:spPr>
            <a:xfrm>
              <a:off x="9631152" y="882122"/>
              <a:ext cx="60045" cy="1200908"/>
            </a:xfrm>
            <a:prstGeom prst="rect">
              <a:avLst/>
            </a:prstGeom>
            <a:gradFill>
              <a:gsLst>
                <a:gs pos="0">
                  <a:srgbClr val="00007F"/>
                </a:gs>
                <a:gs pos="1562">
                  <a:srgbClr val="000091"/>
                </a:gs>
                <a:gs pos="3125">
                  <a:srgbClr val="0000A3"/>
                </a:gs>
                <a:gs pos="4688">
                  <a:srgbClr val="0000B6"/>
                </a:gs>
                <a:gs pos="6250">
                  <a:srgbClr val="0000C8"/>
                </a:gs>
                <a:gs pos="7812">
                  <a:srgbClr val="0000DA"/>
                </a:gs>
                <a:gs pos="9375">
                  <a:srgbClr val="0000EC"/>
                </a:gs>
                <a:gs pos="10938">
                  <a:srgbClr val="0000FE"/>
                </a:gs>
                <a:gs pos="12500">
                  <a:srgbClr val="0000FF"/>
                </a:gs>
                <a:gs pos="14062">
                  <a:srgbClr val="0010FF"/>
                </a:gs>
                <a:gs pos="15625">
                  <a:srgbClr val="0020FF"/>
                </a:gs>
                <a:gs pos="17188">
                  <a:srgbClr val="0030FF"/>
                </a:gs>
                <a:gs pos="18750">
                  <a:srgbClr val="0040FF"/>
                </a:gs>
                <a:gs pos="20312">
                  <a:srgbClr val="0050FF"/>
                </a:gs>
                <a:gs pos="21875">
                  <a:srgbClr val="0060FF"/>
                </a:gs>
                <a:gs pos="23438">
                  <a:srgbClr val="0070FF"/>
                </a:gs>
                <a:gs pos="25000">
                  <a:srgbClr val="0084FF"/>
                </a:gs>
                <a:gs pos="26562">
                  <a:srgbClr val="0094FF"/>
                </a:gs>
                <a:gs pos="28125">
                  <a:srgbClr val="00A4FF"/>
                </a:gs>
                <a:gs pos="29688">
                  <a:srgbClr val="00B4FF"/>
                </a:gs>
                <a:gs pos="31250">
                  <a:srgbClr val="00C4FF"/>
                </a:gs>
                <a:gs pos="32812">
                  <a:srgbClr val="00D4FF"/>
                </a:gs>
                <a:gs pos="34375">
                  <a:srgbClr val="00E4F7"/>
                </a:gs>
                <a:gs pos="35938">
                  <a:srgbClr val="0CF4EA"/>
                </a:gs>
                <a:gs pos="37500">
                  <a:srgbClr val="18FFDD"/>
                </a:gs>
                <a:gs pos="39062">
                  <a:srgbClr val="25FFD0"/>
                </a:gs>
                <a:gs pos="40625">
                  <a:srgbClr val="32FFC3"/>
                </a:gs>
                <a:gs pos="42188">
                  <a:srgbClr val="3FFFB7"/>
                </a:gs>
                <a:gs pos="43750">
                  <a:srgbClr val="4CFFAA"/>
                </a:gs>
                <a:gs pos="45312">
                  <a:srgbClr val="59FF9D"/>
                </a:gs>
                <a:gs pos="46875">
                  <a:srgbClr val="66FF90"/>
                </a:gs>
                <a:gs pos="48438">
                  <a:srgbClr val="73FF83"/>
                </a:gs>
                <a:gs pos="50000">
                  <a:srgbClr val="83FF73"/>
                </a:gs>
                <a:gs pos="51562">
                  <a:srgbClr val="90FF66"/>
                </a:gs>
                <a:gs pos="53125">
                  <a:srgbClr val="9DFF59"/>
                </a:gs>
                <a:gs pos="54688">
                  <a:srgbClr val="AAFF4C"/>
                </a:gs>
                <a:gs pos="56250">
                  <a:srgbClr val="B7FF3F"/>
                </a:gs>
                <a:gs pos="57812">
                  <a:srgbClr val="C3FF32"/>
                </a:gs>
                <a:gs pos="59375">
                  <a:srgbClr val="D0FF25"/>
                </a:gs>
                <a:gs pos="60938">
                  <a:srgbClr val="DDFF18"/>
                </a:gs>
                <a:gs pos="62500">
                  <a:srgbClr val="EAFF0C"/>
                </a:gs>
                <a:gs pos="64061">
                  <a:srgbClr val="F7F400"/>
                </a:gs>
                <a:gs pos="65625">
                  <a:srgbClr val="FFE500"/>
                </a:gs>
                <a:gs pos="67188">
                  <a:srgbClr val="FFD700"/>
                </a:gs>
                <a:gs pos="68750">
                  <a:srgbClr val="FFC800"/>
                </a:gs>
                <a:gs pos="70312">
                  <a:srgbClr val="FFB900"/>
                </a:gs>
                <a:gs pos="71875">
                  <a:srgbClr val="FFAA00"/>
                </a:gs>
                <a:gs pos="73438">
                  <a:srgbClr val="FF9B00"/>
                </a:gs>
                <a:gs pos="75000">
                  <a:srgbClr val="FF8900"/>
                </a:gs>
                <a:gs pos="76562">
                  <a:srgbClr val="FF7A00"/>
                </a:gs>
                <a:gs pos="78125">
                  <a:srgbClr val="FF6B00"/>
                </a:gs>
                <a:gs pos="79688">
                  <a:srgbClr val="FF5C00"/>
                </a:gs>
                <a:gs pos="81250">
                  <a:srgbClr val="FF4D00"/>
                </a:gs>
                <a:gs pos="82812">
                  <a:srgbClr val="FF3F00"/>
                </a:gs>
                <a:gs pos="84375">
                  <a:srgbClr val="FF3000"/>
                </a:gs>
                <a:gs pos="85938">
                  <a:srgbClr val="FF2100"/>
                </a:gs>
                <a:gs pos="87500">
                  <a:srgbClr val="FE1200"/>
                </a:gs>
                <a:gs pos="89062">
                  <a:srgbClr val="EC0300"/>
                </a:gs>
                <a:gs pos="90625">
                  <a:srgbClr val="DA0000"/>
                </a:gs>
                <a:gs pos="92188">
                  <a:srgbClr val="C80000"/>
                </a:gs>
                <a:gs pos="93750">
                  <a:srgbClr val="B60000"/>
                </a:gs>
                <a:gs pos="95312">
                  <a:srgbClr val="A30000"/>
                </a:gs>
                <a:gs pos="96875">
                  <a:srgbClr val="910000"/>
                </a:gs>
                <a:gs pos="98438">
                  <a:srgbClr val="7F0000"/>
                </a:gs>
                <a:gs pos="100000">
                  <a:srgbClr val="7F0000"/>
                </a:gs>
              </a:gsLst>
              <a:lin ang="16200000" scaled="0"/>
            </a:gra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00" name="Google Shape;200;p1"/>
            <p:cNvSpPr/>
            <p:nvPr/>
          </p:nvSpPr>
          <p:spPr>
            <a:xfrm>
              <a:off x="9628150" y="879120"/>
              <a:ext cx="66050" cy="1206914"/>
            </a:xfrm>
            <a:custGeom>
              <a:avLst/>
              <a:gdLst/>
              <a:ahLst/>
              <a:cxnLst/>
              <a:rect l="l" t="t" r="r" b="b"/>
              <a:pathLst>
                <a:path w="66050" h="1206914" extrusionOk="0">
                  <a:moveTo>
                    <a:pt x="0" y="0"/>
                  </a:moveTo>
                  <a:lnTo>
                    <a:pt x="66050" y="0"/>
                  </a:lnTo>
                  <a:lnTo>
                    <a:pt x="66050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201" name="Google Shape;201;p1" descr="image.png"/>
            <p:cNvPicPr preferRelativeResize="0"/>
            <p:nvPr/>
          </p:nvPicPr>
          <p:blipFill rotWithShape="1">
            <a:blip r:embed="rId11">
              <a:alphaModFix/>
            </a:blip>
            <a:srcRect/>
            <a:stretch/>
          </p:blipFill>
          <p:spPr>
            <a:xfrm>
              <a:off x="9697202" y="882122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02" name="Google Shape;202;p1"/>
            <p:cNvSpPr txBox="1"/>
            <p:nvPr/>
          </p:nvSpPr>
          <p:spPr>
            <a:xfrm>
              <a:off x="9757247" y="1128495"/>
              <a:ext cx="210169" cy="14384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10¹</a:t>
              </a:r>
              <a:endParaRPr dirty="0"/>
            </a:p>
          </p:txBody>
        </p:sp>
      </p:grpSp>
      <p:grpSp>
        <p:nvGrpSpPr>
          <p:cNvPr id="203" name="Google Shape;203;p1"/>
          <p:cNvGrpSpPr/>
          <p:nvPr/>
        </p:nvGrpSpPr>
        <p:grpSpPr>
          <a:xfrm>
            <a:off x="1979574" y="2339334"/>
            <a:ext cx="1533859" cy="1288739"/>
            <a:chOff x="9960752" y="720000"/>
            <a:chExt cx="2048199" cy="1720883"/>
          </a:xfrm>
        </p:grpSpPr>
        <p:pic>
          <p:nvPicPr>
            <p:cNvPr id="204" name="Google Shape;204;p1" descr="image.png"/>
            <p:cNvPicPr preferRelativeResize="0"/>
            <p:nvPr/>
          </p:nvPicPr>
          <p:blipFill rotWithShape="1">
            <a:blip r:embed="rId12">
              <a:alphaModFix/>
            </a:blip>
            <a:srcRect/>
            <a:stretch/>
          </p:blipFill>
          <p:spPr>
            <a:xfrm>
              <a:off x="10057475" y="720000"/>
              <a:ext cx="1951476" cy="170529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05" name="Google Shape;205;p1"/>
            <p:cNvSpPr/>
            <p:nvPr/>
          </p:nvSpPr>
          <p:spPr>
            <a:xfrm>
              <a:off x="10396732" y="879120"/>
              <a:ext cx="1206913" cy="1206914"/>
            </a:xfrm>
            <a:custGeom>
              <a:avLst/>
              <a:gdLst/>
              <a:ahLst/>
              <a:cxnLst/>
              <a:rect l="l" t="t" r="r" b="b"/>
              <a:pathLst>
                <a:path w="1206913" h="1206914" extrusionOk="0">
                  <a:moveTo>
                    <a:pt x="0" y="0"/>
                  </a:moveTo>
                  <a:lnTo>
                    <a:pt x="1206913" y="0"/>
                  </a:lnTo>
                  <a:lnTo>
                    <a:pt x="1206913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06" name="Google Shape;206;p1"/>
            <p:cNvSpPr txBox="1"/>
            <p:nvPr/>
          </p:nvSpPr>
          <p:spPr>
            <a:xfrm>
              <a:off x="10814050" y="2276490"/>
              <a:ext cx="576068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1</a:t>
              </a:r>
              <a:endParaRPr dirty="0"/>
            </a:p>
          </p:txBody>
        </p:sp>
        <p:sp>
          <p:nvSpPr>
            <p:cNvPr id="207" name="Google Shape;207;p1"/>
            <p:cNvSpPr txBox="1"/>
            <p:nvPr/>
          </p:nvSpPr>
          <p:spPr>
            <a:xfrm rot="16200000">
              <a:off x="9746781" y="1363483"/>
              <a:ext cx="592335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2</a:t>
              </a:r>
              <a:endParaRPr dirty="0"/>
            </a:p>
          </p:txBody>
        </p:sp>
        <p:pic>
          <p:nvPicPr>
            <p:cNvPr id="208" name="Google Shape;208;p1" descr="image.png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10399734" y="2089035"/>
              <a:ext cx="1194903" cy="180135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209" name="Google Shape;209;p1"/>
            <p:cNvGrpSpPr/>
            <p:nvPr/>
          </p:nvGrpSpPr>
          <p:grpSpPr>
            <a:xfrm>
              <a:off x="10351696" y="2164280"/>
              <a:ext cx="1344374" cy="145532"/>
              <a:chOff x="10351696" y="2164280"/>
              <a:chExt cx="1344374" cy="145532"/>
            </a:xfrm>
          </p:grpSpPr>
          <p:sp>
            <p:nvSpPr>
              <p:cNvPr id="210" name="Google Shape;210;p1"/>
              <p:cNvSpPr txBox="1"/>
              <p:nvPr/>
            </p:nvSpPr>
            <p:spPr>
              <a:xfrm>
                <a:off x="10351696" y="2165968"/>
                <a:ext cx="179194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1</a:t>
                </a:r>
                <a:endParaRPr dirty="0"/>
              </a:p>
            </p:txBody>
          </p:sp>
          <p:sp>
            <p:nvSpPr>
              <p:cNvPr id="211" name="Google Shape;211;p1"/>
              <p:cNvSpPr txBox="1"/>
              <p:nvPr/>
            </p:nvSpPr>
            <p:spPr>
              <a:xfrm>
                <a:off x="10639914" y="2164280"/>
                <a:ext cx="179194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36</a:t>
                </a:r>
                <a:endParaRPr/>
              </a:p>
            </p:txBody>
          </p:sp>
          <p:sp>
            <p:nvSpPr>
              <p:cNvPr id="212" name="Google Shape;212;p1"/>
              <p:cNvSpPr txBox="1"/>
              <p:nvPr/>
            </p:nvSpPr>
            <p:spPr>
              <a:xfrm>
                <a:off x="10946145" y="2164373"/>
                <a:ext cx="171828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0.4</a:t>
                </a:r>
                <a:endParaRPr/>
              </a:p>
            </p:txBody>
          </p:sp>
          <p:sp>
            <p:nvSpPr>
              <p:cNvPr id="213" name="Google Shape;213;p1"/>
              <p:cNvSpPr txBox="1"/>
              <p:nvPr/>
            </p:nvSpPr>
            <p:spPr>
              <a:xfrm>
                <a:off x="11252377" y="2164280"/>
                <a:ext cx="137462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6</a:t>
                </a:r>
                <a:endParaRPr/>
              </a:p>
            </p:txBody>
          </p:sp>
          <p:sp>
            <p:nvSpPr>
              <p:cNvPr id="214" name="Google Shape;214;p1"/>
              <p:cNvSpPr txBox="1"/>
              <p:nvPr/>
            </p:nvSpPr>
            <p:spPr>
              <a:xfrm>
                <a:off x="11558608" y="2165124"/>
                <a:ext cx="137462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2</a:t>
                </a:r>
                <a:endParaRPr/>
              </a:p>
            </p:txBody>
          </p:sp>
        </p:grpSp>
        <p:pic>
          <p:nvPicPr>
            <p:cNvPr id="215" name="Google Shape;215;p1" descr="image.png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10213593" y="882122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216" name="Google Shape;216;p1"/>
            <p:cNvGrpSpPr/>
            <p:nvPr/>
          </p:nvGrpSpPr>
          <p:grpSpPr>
            <a:xfrm>
              <a:off x="10128087" y="849379"/>
              <a:ext cx="233807" cy="1338655"/>
              <a:chOff x="10128087" y="849379"/>
              <a:chExt cx="233807" cy="1338655"/>
            </a:xfrm>
          </p:grpSpPr>
          <p:sp>
            <p:nvSpPr>
              <p:cNvPr id="217" name="Google Shape;217;p1"/>
              <p:cNvSpPr txBox="1"/>
              <p:nvPr/>
            </p:nvSpPr>
            <p:spPr>
              <a:xfrm>
                <a:off x="10153759" y="2044190"/>
                <a:ext cx="196184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9</a:t>
                </a:r>
                <a:endParaRPr/>
              </a:p>
            </p:txBody>
          </p:sp>
          <p:sp>
            <p:nvSpPr>
              <p:cNvPr id="218" name="Google Shape;218;p1"/>
              <p:cNvSpPr txBox="1"/>
              <p:nvPr/>
            </p:nvSpPr>
            <p:spPr>
              <a:xfrm>
                <a:off x="10169680" y="1750153"/>
                <a:ext cx="180263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40</a:t>
                </a:r>
                <a:endParaRPr/>
              </a:p>
            </p:txBody>
          </p:sp>
          <p:sp>
            <p:nvSpPr>
              <p:cNvPr id="219" name="Google Shape;219;p1"/>
              <p:cNvSpPr txBox="1"/>
              <p:nvPr/>
            </p:nvSpPr>
            <p:spPr>
              <a:xfrm>
                <a:off x="10128087" y="1449736"/>
                <a:ext cx="233807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0.6</a:t>
                </a:r>
                <a:endParaRPr/>
              </a:p>
            </p:txBody>
          </p:sp>
          <p:sp>
            <p:nvSpPr>
              <p:cNvPr id="220" name="Google Shape;220;p1"/>
              <p:cNvSpPr txBox="1"/>
              <p:nvPr/>
            </p:nvSpPr>
            <p:spPr>
              <a:xfrm>
                <a:off x="10199287" y="1149512"/>
                <a:ext cx="138285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9</a:t>
                </a:r>
                <a:endParaRPr dirty="0"/>
              </a:p>
            </p:txBody>
          </p:sp>
          <p:sp>
            <p:nvSpPr>
              <p:cNvPr id="221" name="Google Shape;221;p1"/>
              <p:cNvSpPr txBox="1"/>
              <p:nvPr/>
            </p:nvSpPr>
            <p:spPr>
              <a:xfrm>
                <a:off x="10187074" y="849379"/>
                <a:ext cx="150496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8</a:t>
                </a:r>
                <a:endParaRPr dirty="0"/>
              </a:p>
            </p:txBody>
          </p:sp>
        </p:grpSp>
        <p:sp>
          <p:nvSpPr>
            <p:cNvPr id="222" name="Google Shape;222;p1"/>
            <p:cNvSpPr/>
            <p:nvPr/>
          </p:nvSpPr>
          <p:spPr>
            <a:xfrm>
              <a:off x="11606647" y="882122"/>
              <a:ext cx="60045" cy="1200908"/>
            </a:xfrm>
            <a:prstGeom prst="rect">
              <a:avLst/>
            </a:prstGeom>
            <a:gradFill>
              <a:gsLst>
                <a:gs pos="0">
                  <a:srgbClr val="00007F"/>
                </a:gs>
                <a:gs pos="1562">
                  <a:srgbClr val="000091"/>
                </a:gs>
                <a:gs pos="3125">
                  <a:srgbClr val="0000A3"/>
                </a:gs>
                <a:gs pos="4688">
                  <a:srgbClr val="0000B6"/>
                </a:gs>
                <a:gs pos="6250">
                  <a:srgbClr val="0000C8"/>
                </a:gs>
                <a:gs pos="7812">
                  <a:srgbClr val="0000DA"/>
                </a:gs>
                <a:gs pos="9375">
                  <a:srgbClr val="0000EC"/>
                </a:gs>
                <a:gs pos="10938">
                  <a:srgbClr val="0000FE"/>
                </a:gs>
                <a:gs pos="12500">
                  <a:srgbClr val="0000FF"/>
                </a:gs>
                <a:gs pos="14062">
                  <a:srgbClr val="0010FF"/>
                </a:gs>
                <a:gs pos="15625">
                  <a:srgbClr val="0020FF"/>
                </a:gs>
                <a:gs pos="17188">
                  <a:srgbClr val="0030FF"/>
                </a:gs>
                <a:gs pos="18750">
                  <a:srgbClr val="0040FF"/>
                </a:gs>
                <a:gs pos="20312">
                  <a:srgbClr val="0050FF"/>
                </a:gs>
                <a:gs pos="21875">
                  <a:srgbClr val="0060FF"/>
                </a:gs>
                <a:gs pos="23438">
                  <a:srgbClr val="0070FF"/>
                </a:gs>
                <a:gs pos="25000">
                  <a:srgbClr val="0084FF"/>
                </a:gs>
                <a:gs pos="26562">
                  <a:srgbClr val="0094FF"/>
                </a:gs>
                <a:gs pos="28125">
                  <a:srgbClr val="00A4FF"/>
                </a:gs>
                <a:gs pos="29688">
                  <a:srgbClr val="00B4FF"/>
                </a:gs>
                <a:gs pos="31250">
                  <a:srgbClr val="00C4FF"/>
                </a:gs>
                <a:gs pos="32812">
                  <a:srgbClr val="00D4FF"/>
                </a:gs>
                <a:gs pos="34375">
                  <a:srgbClr val="00E4F7"/>
                </a:gs>
                <a:gs pos="35938">
                  <a:srgbClr val="0CF4EA"/>
                </a:gs>
                <a:gs pos="37500">
                  <a:srgbClr val="18FFDD"/>
                </a:gs>
                <a:gs pos="39062">
                  <a:srgbClr val="25FFD0"/>
                </a:gs>
                <a:gs pos="40625">
                  <a:srgbClr val="32FFC3"/>
                </a:gs>
                <a:gs pos="42188">
                  <a:srgbClr val="3FFFB7"/>
                </a:gs>
                <a:gs pos="43750">
                  <a:srgbClr val="4CFFAA"/>
                </a:gs>
                <a:gs pos="45312">
                  <a:srgbClr val="59FF9D"/>
                </a:gs>
                <a:gs pos="46875">
                  <a:srgbClr val="66FF90"/>
                </a:gs>
                <a:gs pos="48438">
                  <a:srgbClr val="73FF83"/>
                </a:gs>
                <a:gs pos="50000">
                  <a:srgbClr val="83FF73"/>
                </a:gs>
                <a:gs pos="51562">
                  <a:srgbClr val="90FF66"/>
                </a:gs>
                <a:gs pos="53125">
                  <a:srgbClr val="9DFF59"/>
                </a:gs>
                <a:gs pos="54688">
                  <a:srgbClr val="AAFF4C"/>
                </a:gs>
                <a:gs pos="56250">
                  <a:srgbClr val="B7FF3F"/>
                </a:gs>
                <a:gs pos="57812">
                  <a:srgbClr val="C3FF32"/>
                </a:gs>
                <a:gs pos="59375">
                  <a:srgbClr val="D0FF25"/>
                </a:gs>
                <a:gs pos="60938">
                  <a:srgbClr val="DDFF18"/>
                </a:gs>
                <a:gs pos="62500">
                  <a:srgbClr val="EAFF0C"/>
                </a:gs>
                <a:gs pos="64061">
                  <a:srgbClr val="F7F400"/>
                </a:gs>
                <a:gs pos="65625">
                  <a:srgbClr val="FFE500"/>
                </a:gs>
                <a:gs pos="67188">
                  <a:srgbClr val="FFD700"/>
                </a:gs>
                <a:gs pos="68750">
                  <a:srgbClr val="FFC800"/>
                </a:gs>
                <a:gs pos="70312">
                  <a:srgbClr val="FFB900"/>
                </a:gs>
                <a:gs pos="71875">
                  <a:srgbClr val="FFAA00"/>
                </a:gs>
                <a:gs pos="73438">
                  <a:srgbClr val="FF9B00"/>
                </a:gs>
                <a:gs pos="75000">
                  <a:srgbClr val="FF8900"/>
                </a:gs>
                <a:gs pos="76562">
                  <a:srgbClr val="FF7A00"/>
                </a:gs>
                <a:gs pos="78125">
                  <a:srgbClr val="FF6B00"/>
                </a:gs>
                <a:gs pos="79688">
                  <a:srgbClr val="FF5C00"/>
                </a:gs>
                <a:gs pos="81250">
                  <a:srgbClr val="FF4D00"/>
                </a:gs>
                <a:gs pos="82812">
                  <a:srgbClr val="FF3F00"/>
                </a:gs>
                <a:gs pos="84375">
                  <a:srgbClr val="FF3000"/>
                </a:gs>
                <a:gs pos="85938">
                  <a:srgbClr val="FF2100"/>
                </a:gs>
                <a:gs pos="87500">
                  <a:srgbClr val="FE1200"/>
                </a:gs>
                <a:gs pos="89062">
                  <a:srgbClr val="EC0300"/>
                </a:gs>
                <a:gs pos="90625">
                  <a:srgbClr val="DA0000"/>
                </a:gs>
                <a:gs pos="92188">
                  <a:srgbClr val="C80000"/>
                </a:gs>
                <a:gs pos="93750">
                  <a:srgbClr val="B60000"/>
                </a:gs>
                <a:gs pos="95312">
                  <a:srgbClr val="A30000"/>
                </a:gs>
                <a:gs pos="96875">
                  <a:srgbClr val="910000"/>
                </a:gs>
                <a:gs pos="98438">
                  <a:srgbClr val="7F0000"/>
                </a:gs>
                <a:gs pos="100000">
                  <a:srgbClr val="7F0000"/>
                </a:gs>
              </a:gsLst>
              <a:lin ang="16200000" scaled="0"/>
            </a:gra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23" name="Google Shape;223;p1"/>
            <p:cNvSpPr/>
            <p:nvPr/>
          </p:nvSpPr>
          <p:spPr>
            <a:xfrm>
              <a:off x="11603645" y="879120"/>
              <a:ext cx="66050" cy="1206914"/>
            </a:xfrm>
            <a:custGeom>
              <a:avLst/>
              <a:gdLst/>
              <a:ahLst/>
              <a:cxnLst/>
              <a:rect l="l" t="t" r="r" b="b"/>
              <a:pathLst>
                <a:path w="66050" h="1206914" extrusionOk="0">
                  <a:moveTo>
                    <a:pt x="0" y="0"/>
                  </a:moveTo>
                  <a:lnTo>
                    <a:pt x="66050" y="0"/>
                  </a:lnTo>
                  <a:lnTo>
                    <a:pt x="66050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224" name="Google Shape;224;p1" descr="image.png"/>
            <p:cNvPicPr preferRelativeResize="0"/>
            <p:nvPr/>
          </p:nvPicPr>
          <p:blipFill rotWithShape="1">
            <a:blip r:embed="rId13">
              <a:alphaModFix/>
            </a:blip>
            <a:srcRect/>
            <a:stretch/>
          </p:blipFill>
          <p:spPr>
            <a:xfrm>
              <a:off x="11672697" y="882122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25" name="Google Shape;225;p1"/>
            <p:cNvSpPr txBox="1"/>
            <p:nvPr/>
          </p:nvSpPr>
          <p:spPr>
            <a:xfrm>
              <a:off x="11732742" y="1122492"/>
              <a:ext cx="200279" cy="14384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10¹</a:t>
              </a:r>
              <a:endParaRPr dirty="0"/>
            </a:p>
          </p:txBody>
        </p:sp>
      </p:grpSp>
      <p:grpSp>
        <p:nvGrpSpPr>
          <p:cNvPr id="226" name="Google Shape;226;p1"/>
          <p:cNvGrpSpPr/>
          <p:nvPr/>
        </p:nvGrpSpPr>
        <p:grpSpPr>
          <a:xfrm>
            <a:off x="3469021" y="2339531"/>
            <a:ext cx="1528730" cy="1288740"/>
            <a:chOff x="90126" y="2473326"/>
            <a:chExt cx="2041350" cy="1720884"/>
          </a:xfrm>
        </p:grpSpPr>
        <p:pic>
          <p:nvPicPr>
            <p:cNvPr id="227" name="Google Shape;227;p1" descr="image.png"/>
            <p:cNvPicPr preferRelativeResize="0"/>
            <p:nvPr/>
          </p:nvPicPr>
          <p:blipFill rotWithShape="1">
            <a:blip r:embed="rId14">
              <a:alphaModFix/>
            </a:blip>
            <a:srcRect/>
            <a:stretch/>
          </p:blipFill>
          <p:spPr>
            <a:xfrm>
              <a:off x="180000" y="2473326"/>
              <a:ext cx="1951476" cy="170529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28" name="Google Shape;228;p1"/>
            <p:cNvSpPr/>
            <p:nvPr/>
          </p:nvSpPr>
          <p:spPr>
            <a:xfrm>
              <a:off x="519256" y="2632447"/>
              <a:ext cx="1206914" cy="1206914"/>
            </a:xfrm>
            <a:custGeom>
              <a:avLst/>
              <a:gdLst/>
              <a:ahLst/>
              <a:cxnLst/>
              <a:rect l="l" t="t" r="r" b="b"/>
              <a:pathLst>
                <a:path w="1206914" h="1206914" extrusionOk="0">
                  <a:moveTo>
                    <a:pt x="0" y="0"/>
                  </a:moveTo>
                  <a:lnTo>
                    <a:pt x="1206914" y="0"/>
                  </a:lnTo>
                  <a:lnTo>
                    <a:pt x="1206914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29" name="Google Shape;229;p1"/>
            <p:cNvSpPr txBox="1"/>
            <p:nvPr/>
          </p:nvSpPr>
          <p:spPr>
            <a:xfrm>
              <a:off x="936573" y="4029817"/>
              <a:ext cx="593917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1</a:t>
              </a:r>
              <a:endParaRPr dirty="0"/>
            </a:p>
          </p:txBody>
        </p:sp>
        <p:sp>
          <p:nvSpPr>
            <p:cNvPr id="230" name="Google Shape;230;p1"/>
            <p:cNvSpPr txBox="1"/>
            <p:nvPr/>
          </p:nvSpPr>
          <p:spPr>
            <a:xfrm rot="16200000">
              <a:off x="-136121" y="3098922"/>
              <a:ext cx="622498" cy="17000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2</a:t>
              </a:r>
              <a:endParaRPr dirty="0"/>
            </a:p>
          </p:txBody>
        </p:sp>
        <p:pic>
          <p:nvPicPr>
            <p:cNvPr id="231" name="Google Shape;231;p1" descr="image.png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522258" y="3842362"/>
              <a:ext cx="1194903" cy="180135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232" name="Google Shape;232;p1"/>
            <p:cNvGrpSpPr/>
            <p:nvPr/>
          </p:nvGrpSpPr>
          <p:grpSpPr>
            <a:xfrm>
              <a:off x="474222" y="3917607"/>
              <a:ext cx="1347313" cy="144423"/>
              <a:chOff x="474222" y="3917607"/>
              <a:chExt cx="1347313" cy="144423"/>
            </a:xfrm>
          </p:grpSpPr>
          <p:sp>
            <p:nvSpPr>
              <p:cNvPr id="233" name="Google Shape;233;p1"/>
              <p:cNvSpPr txBox="1"/>
              <p:nvPr/>
            </p:nvSpPr>
            <p:spPr>
              <a:xfrm>
                <a:off x="474222" y="3919295"/>
                <a:ext cx="183025" cy="14273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1</a:t>
                </a:r>
                <a:endParaRPr/>
              </a:p>
            </p:txBody>
          </p:sp>
          <p:sp>
            <p:nvSpPr>
              <p:cNvPr id="234" name="Google Shape;234;p1"/>
              <p:cNvSpPr txBox="1"/>
              <p:nvPr/>
            </p:nvSpPr>
            <p:spPr>
              <a:xfrm>
                <a:off x="762441" y="3917607"/>
                <a:ext cx="183025" cy="14273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36</a:t>
                </a:r>
                <a:endParaRPr/>
              </a:p>
            </p:txBody>
          </p:sp>
          <p:sp>
            <p:nvSpPr>
              <p:cNvPr id="235" name="Google Shape;235;p1"/>
              <p:cNvSpPr txBox="1"/>
              <p:nvPr/>
            </p:nvSpPr>
            <p:spPr>
              <a:xfrm>
                <a:off x="1068671" y="3917700"/>
                <a:ext cx="175502" cy="14273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0.4</a:t>
                </a:r>
                <a:endParaRPr/>
              </a:p>
            </p:txBody>
          </p:sp>
          <p:sp>
            <p:nvSpPr>
              <p:cNvPr id="236" name="Google Shape;236;p1"/>
              <p:cNvSpPr txBox="1"/>
              <p:nvPr/>
            </p:nvSpPr>
            <p:spPr>
              <a:xfrm>
                <a:off x="1374904" y="3917607"/>
                <a:ext cx="140401" cy="14273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6</a:t>
                </a:r>
                <a:endParaRPr/>
              </a:p>
            </p:txBody>
          </p:sp>
          <p:sp>
            <p:nvSpPr>
              <p:cNvPr id="237" name="Google Shape;237;p1"/>
              <p:cNvSpPr txBox="1"/>
              <p:nvPr/>
            </p:nvSpPr>
            <p:spPr>
              <a:xfrm>
                <a:off x="1681134" y="3918451"/>
                <a:ext cx="140401" cy="14273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2</a:t>
                </a:r>
                <a:endParaRPr dirty="0"/>
              </a:p>
            </p:txBody>
          </p:sp>
        </p:grpSp>
        <p:pic>
          <p:nvPicPr>
            <p:cNvPr id="238" name="Google Shape;238;p1" descr="image.png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336117" y="2635449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239" name="Google Shape;239;p1"/>
            <p:cNvGrpSpPr/>
            <p:nvPr/>
          </p:nvGrpSpPr>
          <p:grpSpPr>
            <a:xfrm>
              <a:off x="262203" y="2594726"/>
              <a:ext cx="226224" cy="1338655"/>
              <a:chOff x="262203" y="2594726"/>
              <a:chExt cx="226224" cy="1338655"/>
            </a:xfrm>
          </p:grpSpPr>
          <p:sp>
            <p:nvSpPr>
              <p:cNvPr id="240" name="Google Shape;240;p1"/>
              <p:cNvSpPr txBox="1"/>
              <p:nvPr/>
            </p:nvSpPr>
            <p:spPr>
              <a:xfrm>
                <a:off x="292707" y="3789537"/>
                <a:ext cx="179761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9</a:t>
                </a:r>
                <a:endParaRPr dirty="0"/>
              </a:p>
            </p:txBody>
          </p:sp>
          <p:sp>
            <p:nvSpPr>
              <p:cNvPr id="241" name="Google Shape;241;p1"/>
              <p:cNvSpPr txBox="1"/>
              <p:nvPr/>
            </p:nvSpPr>
            <p:spPr>
              <a:xfrm>
                <a:off x="280724" y="3495500"/>
                <a:ext cx="207703" cy="14685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40</a:t>
                </a:r>
                <a:endParaRPr/>
              </a:p>
            </p:txBody>
          </p:sp>
          <p:sp>
            <p:nvSpPr>
              <p:cNvPr id="242" name="Google Shape;242;p1"/>
              <p:cNvSpPr txBox="1"/>
              <p:nvPr/>
            </p:nvSpPr>
            <p:spPr>
              <a:xfrm>
                <a:off x="262203" y="3203063"/>
                <a:ext cx="214236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0.6</a:t>
                </a:r>
                <a:endParaRPr dirty="0"/>
              </a:p>
            </p:txBody>
          </p:sp>
          <p:sp>
            <p:nvSpPr>
              <p:cNvPr id="243" name="Google Shape;243;p1"/>
              <p:cNvSpPr txBox="1"/>
              <p:nvPr/>
            </p:nvSpPr>
            <p:spPr>
              <a:xfrm>
                <a:off x="316723" y="2894859"/>
                <a:ext cx="159331" cy="14685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9</a:t>
                </a:r>
                <a:endParaRPr dirty="0"/>
              </a:p>
            </p:txBody>
          </p:sp>
          <p:sp>
            <p:nvSpPr>
              <p:cNvPr id="244" name="Google Shape;244;p1"/>
              <p:cNvSpPr txBox="1"/>
              <p:nvPr/>
            </p:nvSpPr>
            <p:spPr>
              <a:xfrm>
                <a:off x="314216" y="2594726"/>
                <a:ext cx="137897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8</a:t>
                </a:r>
                <a:endParaRPr dirty="0"/>
              </a:p>
            </p:txBody>
          </p:sp>
        </p:grpSp>
        <p:sp>
          <p:nvSpPr>
            <p:cNvPr id="245" name="Google Shape;245;p1"/>
            <p:cNvSpPr/>
            <p:nvPr/>
          </p:nvSpPr>
          <p:spPr>
            <a:xfrm>
              <a:off x="1729172" y="2635449"/>
              <a:ext cx="60045" cy="1200908"/>
            </a:xfrm>
            <a:prstGeom prst="rect">
              <a:avLst/>
            </a:prstGeom>
            <a:gradFill>
              <a:gsLst>
                <a:gs pos="0">
                  <a:srgbClr val="00007F"/>
                </a:gs>
                <a:gs pos="1562">
                  <a:srgbClr val="000091"/>
                </a:gs>
                <a:gs pos="3125">
                  <a:srgbClr val="0000A3"/>
                </a:gs>
                <a:gs pos="4688">
                  <a:srgbClr val="0000B6"/>
                </a:gs>
                <a:gs pos="6250">
                  <a:srgbClr val="0000C8"/>
                </a:gs>
                <a:gs pos="7812">
                  <a:srgbClr val="0000DA"/>
                </a:gs>
                <a:gs pos="9375">
                  <a:srgbClr val="0000EC"/>
                </a:gs>
                <a:gs pos="10938">
                  <a:srgbClr val="0000FE"/>
                </a:gs>
                <a:gs pos="12500">
                  <a:srgbClr val="0000FF"/>
                </a:gs>
                <a:gs pos="14062">
                  <a:srgbClr val="0010FF"/>
                </a:gs>
                <a:gs pos="15625">
                  <a:srgbClr val="0020FF"/>
                </a:gs>
                <a:gs pos="17188">
                  <a:srgbClr val="0030FF"/>
                </a:gs>
                <a:gs pos="18750">
                  <a:srgbClr val="0040FF"/>
                </a:gs>
                <a:gs pos="20312">
                  <a:srgbClr val="0050FF"/>
                </a:gs>
                <a:gs pos="21875">
                  <a:srgbClr val="0060FF"/>
                </a:gs>
                <a:gs pos="23438">
                  <a:srgbClr val="0070FF"/>
                </a:gs>
                <a:gs pos="25000">
                  <a:srgbClr val="0084FF"/>
                </a:gs>
                <a:gs pos="26562">
                  <a:srgbClr val="0094FF"/>
                </a:gs>
                <a:gs pos="28125">
                  <a:srgbClr val="00A4FF"/>
                </a:gs>
                <a:gs pos="29688">
                  <a:srgbClr val="00B4FF"/>
                </a:gs>
                <a:gs pos="31250">
                  <a:srgbClr val="00C4FF"/>
                </a:gs>
                <a:gs pos="32812">
                  <a:srgbClr val="00D4FF"/>
                </a:gs>
                <a:gs pos="34375">
                  <a:srgbClr val="00E4F7"/>
                </a:gs>
                <a:gs pos="35938">
                  <a:srgbClr val="0CF4EA"/>
                </a:gs>
                <a:gs pos="37500">
                  <a:srgbClr val="18FFDD"/>
                </a:gs>
                <a:gs pos="39062">
                  <a:srgbClr val="25FFD0"/>
                </a:gs>
                <a:gs pos="40625">
                  <a:srgbClr val="32FFC3"/>
                </a:gs>
                <a:gs pos="42188">
                  <a:srgbClr val="3FFFB7"/>
                </a:gs>
                <a:gs pos="43750">
                  <a:srgbClr val="4CFFAA"/>
                </a:gs>
                <a:gs pos="45312">
                  <a:srgbClr val="59FF9D"/>
                </a:gs>
                <a:gs pos="46875">
                  <a:srgbClr val="66FF90"/>
                </a:gs>
                <a:gs pos="48438">
                  <a:srgbClr val="73FF83"/>
                </a:gs>
                <a:gs pos="50000">
                  <a:srgbClr val="83FF73"/>
                </a:gs>
                <a:gs pos="51562">
                  <a:srgbClr val="90FF66"/>
                </a:gs>
                <a:gs pos="53125">
                  <a:srgbClr val="9DFF59"/>
                </a:gs>
                <a:gs pos="54688">
                  <a:srgbClr val="AAFF4C"/>
                </a:gs>
                <a:gs pos="56250">
                  <a:srgbClr val="B7FF3F"/>
                </a:gs>
                <a:gs pos="57812">
                  <a:srgbClr val="C3FF32"/>
                </a:gs>
                <a:gs pos="59375">
                  <a:srgbClr val="D0FF25"/>
                </a:gs>
                <a:gs pos="60938">
                  <a:srgbClr val="DDFF18"/>
                </a:gs>
                <a:gs pos="62500">
                  <a:srgbClr val="EAFF0C"/>
                </a:gs>
                <a:gs pos="64061">
                  <a:srgbClr val="F7F400"/>
                </a:gs>
                <a:gs pos="65625">
                  <a:srgbClr val="FFE500"/>
                </a:gs>
                <a:gs pos="67188">
                  <a:srgbClr val="FFD700"/>
                </a:gs>
                <a:gs pos="68750">
                  <a:srgbClr val="FFC800"/>
                </a:gs>
                <a:gs pos="70312">
                  <a:srgbClr val="FFB900"/>
                </a:gs>
                <a:gs pos="71875">
                  <a:srgbClr val="FFAA00"/>
                </a:gs>
                <a:gs pos="73438">
                  <a:srgbClr val="FF9B00"/>
                </a:gs>
                <a:gs pos="75000">
                  <a:srgbClr val="FF8900"/>
                </a:gs>
                <a:gs pos="76562">
                  <a:srgbClr val="FF7A00"/>
                </a:gs>
                <a:gs pos="78125">
                  <a:srgbClr val="FF6B00"/>
                </a:gs>
                <a:gs pos="79688">
                  <a:srgbClr val="FF5C00"/>
                </a:gs>
                <a:gs pos="81250">
                  <a:srgbClr val="FF4D00"/>
                </a:gs>
                <a:gs pos="82812">
                  <a:srgbClr val="FF3F00"/>
                </a:gs>
                <a:gs pos="84375">
                  <a:srgbClr val="FF3000"/>
                </a:gs>
                <a:gs pos="85938">
                  <a:srgbClr val="FF2100"/>
                </a:gs>
                <a:gs pos="87500">
                  <a:srgbClr val="FE1200"/>
                </a:gs>
                <a:gs pos="89062">
                  <a:srgbClr val="EC0300"/>
                </a:gs>
                <a:gs pos="90625">
                  <a:srgbClr val="DA0000"/>
                </a:gs>
                <a:gs pos="92188">
                  <a:srgbClr val="C80000"/>
                </a:gs>
                <a:gs pos="93750">
                  <a:srgbClr val="B60000"/>
                </a:gs>
                <a:gs pos="95312">
                  <a:srgbClr val="A30000"/>
                </a:gs>
                <a:gs pos="96875">
                  <a:srgbClr val="910000"/>
                </a:gs>
                <a:gs pos="98438">
                  <a:srgbClr val="7F0000"/>
                </a:gs>
                <a:gs pos="100000">
                  <a:srgbClr val="7F0000"/>
                </a:gs>
              </a:gsLst>
              <a:lin ang="16200000" scaled="0"/>
            </a:gra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46" name="Google Shape;246;p1"/>
            <p:cNvSpPr/>
            <p:nvPr/>
          </p:nvSpPr>
          <p:spPr>
            <a:xfrm>
              <a:off x="1726170" y="2632447"/>
              <a:ext cx="66050" cy="1206914"/>
            </a:xfrm>
            <a:custGeom>
              <a:avLst/>
              <a:gdLst/>
              <a:ahLst/>
              <a:cxnLst/>
              <a:rect l="l" t="t" r="r" b="b"/>
              <a:pathLst>
                <a:path w="66050" h="1206914" extrusionOk="0">
                  <a:moveTo>
                    <a:pt x="0" y="0"/>
                  </a:moveTo>
                  <a:lnTo>
                    <a:pt x="66050" y="0"/>
                  </a:lnTo>
                  <a:lnTo>
                    <a:pt x="66050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247" name="Google Shape;247;p1" descr="image.png"/>
            <p:cNvPicPr preferRelativeResize="0"/>
            <p:nvPr/>
          </p:nvPicPr>
          <p:blipFill rotWithShape="1">
            <a:blip r:embed="rId11">
              <a:alphaModFix/>
            </a:blip>
            <a:srcRect/>
            <a:stretch/>
          </p:blipFill>
          <p:spPr>
            <a:xfrm>
              <a:off x="1795222" y="2635449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48" name="Google Shape;248;p1"/>
            <p:cNvSpPr txBox="1"/>
            <p:nvPr/>
          </p:nvSpPr>
          <p:spPr>
            <a:xfrm>
              <a:off x="1855267" y="2881821"/>
              <a:ext cx="180135" cy="14384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10¹</a:t>
              </a:r>
              <a:endParaRPr dirty="0"/>
            </a:p>
          </p:txBody>
        </p:sp>
      </p:grpSp>
      <p:grpSp>
        <p:nvGrpSpPr>
          <p:cNvPr id="249" name="Google Shape;249;p1"/>
          <p:cNvGrpSpPr/>
          <p:nvPr/>
        </p:nvGrpSpPr>
        <p:grpSpPr>
          <a:xfrm>
            <a:off x="4963896" y="2343168"/>
            <a:ext cx="1522756" cy="1292906"/>
            <a:chOff x="2073599" y="2473326"/>
            <a:chExt cx="2033372" cy="1726447"/>
          </a:xfrm>
        </p:grpSpPr>
        <p:pic>
          <p:nvPicPr>
            <p:cNvPr id="250" name="Google Shape;250;p1" descr="image.png"/>
            <p:cNvPicPr preferRelativeResize="0"/>
            <p:nvPr/>
          </p:nvPicPr>
          <p:blipFill rotWithShape="1">
            <a:blip r:embed="rId15">
              <a:alphaModFix/>
            </a:blip>
            <a:srcRect/>
            <a:stretch/>
          </p:blipFill>
          <p:spPr>
            <a:xfrm>
              <a:off x="2155495" y="2473326"/>
              <a:ext cx="1951476" cy="170529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51" name="Google Shape;251;p1"/>
            <p:cNvSpPr/>
            <p:nvPr/>
          </p:nvSpPr>
          <p:spPr>
            <a:xfrm>
              <a:off x="2494751" y="2632447"/>
              <a:ext cx="1206914" cy="1206914"/>
            </a:xfrm>
            <a:custGeom>
              <a:avLst/>
              <a:gdLst/>
              <a:ahLst/>
              <a:cxnLst/>
              <a:rect l="l" t="t" r="r" b="b"/>
              <a:pathLst>
                <a:path w="1206914" h="1206914" extrusionOk="0">
                  <a:moveTo>
                    <a:pt x="0" y="0"/>
                  </a:moveTo>
                  <a:lnTo>
                    <a:pt x="1206914" y="0"/>
                  </a:lnTo>
                  <a:lnTo>
                    <a:pt x="1206914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52" name="Google Shape;252;p1"/>
            <p:cNvSpPr txBox="1"/>
            <p:nvPr/>
          </p:nvSpPr>
          <p:spPr>
            <a:xfrm>
              <a:off x="2912068" y="4029817"/>
              <a:ext cx="576070" cy="1699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1</a:t>
              </a:r>
              <a:endParaRPr dirty="0"/>
            </a:p>
          </p:txBody>
        </p:sp>
        <p:sp>
          <p:nvSpPr>
            <p:cNvPr id="253" name="Google Shape;253;p1"/>
            <p:cNvSpPr txBox="1"/>
            <p:nvPr/>
          </p:nvSpPr>
          <p:spPr>
            <a:xfrm rot="16200000">
              <a:off x="1848195" y="3105376"/>
              <a:ext cx="615202" cy="16439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2</a:t>
              </a:r>
              <a:endParaRPr dirty="0"/>
            </a:p>
          </p:txBody>
        </p:sp>
        <p:pic>
          <p:nvPicPr>
            <p:cNvPr id="254" name="Google Shape;254;p1" descr="image.png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2497753" y="3842362"/>
              <a:ext cx="1194903" cy="180135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255" name="Google Shape;255;p1"/>
            <p:cNvGrpSpPr/>
            <p:nvPr/>
          </p:nvGrpSpPr>
          <p:grpSpPr>
            <a:xfrm>
              <a:off x="2449716" y="3917606"/>
              <a:ext cx="1398532" cy="145532"/>
              <a:chOff x="2449716" y="3917606"/>
              <a:chExt cx="1398532" cy="145532"/>
            </a:xfrm>
          </p:grpSpPr>
          <p:sp>
            <p:nvSpPr>
              <p:cNvPr id="256" name="Google Shape;256;p1"/>
              <p:cNvSpPr txBox="1"/>
              <p:nvPr/>
            </p:nvSpPr>
            <p:spPr>
              <a:xfrm>
                <a:off x="2449716" y="3919294"/>
                <a:ext cx="249790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1</a:t>
                </a:r>
                <a:endParaRPr/>
              </a:p>
            </p:txBody>
          </p:sp>
          <p:sp>
            <p:nvSpPr>
              <p:cNvPr id="257" name="Google Shape;257;p1"/>
              <p:cNvSpPr txBox="1"/>
              <p:nvPr/>
            </p:nvSpPr>
            <p:spPr>
              <a:xfrm>
                <a:off x="2737934" y="3917606"/>
                <a:ext cx="249790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36</a:t>
                </a:r>
                <a:endParaRPr/>
              </a:p>
            </p:txBody>
          </p:sp>
          <p:sp>
            <p:nvSpPr>
              <p:cNvPr id="258" name="Google Shape;258;p1"/>
              <p:cNvSpPr txBox="1"/>
              <p:nvPr/>
            </p:nvSpPr>
            <p:spPr>
              <a:xfrm>
                <a:off x="3044167" y="3917699"/>
                <a:ext cx="239522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0.4</a:t>
                </a:r>
                <a:endParaRPr/>
              </a:p>
            </p:txBody>
          </p:sp>
          <p:sp>
            <p:nvSpPr>
              <p:cNvPr id="259" name="Google Shape;259;p1"/>
              <p:cNvSpPr txBox="1"/>
              <p:nvPr/>
            </p:nvSpPr>
            <p:spPr>
              <a:xfrm>
                <a:off x="3350396" y="3917606"/>
                <a:ext cx="191618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6</a:t>
                </a:r>
                <a:endParaRPr/>
              </a:p>
            </p:txBody>
          </p:sp>
          <p:sp>
            <p:nvSpPr>
              <p:cNvPr id="260" name="Google Shape;260;p1"/>
              <p:cNvSpPr txBox="1"/>
              <p:nvPr/>
            </p:nvSpPr>
            <p:spPr>
              <a:xfrm>
                <a:off x="3656630" y="3918450"/>
                <a:ext cx="191618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2</a:t>
                </a:r>
                <a:endParaRPr dirty="0"/>
              </a:p>
            </p:txBody>
          </p:sp>
        </p:grpSp>
        <p:pic>
          <p:nvPicPr>
            <p:cNvPr id="261" name="Google Shape;261;p1" descr="image.png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2311613" y="2635449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262" name="Google Shape;262;p1"/>
            <p:cNvGrpSpPr/>
            <p:nvPr/>
          </p:nvGrpSpPr>
          <p:grpSpPr>
            <a:xfrm>
              <a:off x="2222175" y="2602706"/>
              <a:ext cx="245720" cy="1343075"/>
              <a:chOff x="2222175" y="2602706"/>
              <a:chExt cx="245720" cy="1343075"/>
            </a:xfrm>
          </p:grpSpPr>
          <p:sp>
            <p:nvSpPr>
              <p:cNvPr id="263" name="Google Shape;263;p1"/>
              <p:cNvSpPr txBox="1"/>
              <p:nvPr/>
            </p:nvSpPr>
            <p:spPr>
              <a:xfrm>
                <a:off x="2249763" y="3797517"/>
                <a:ext cx="206179" cy="14826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9</a:t>
                </a:r>
                <a:endParaRPr/>
              </a:p>
            </p:txBody>
          </p:sp>
          <p:sp>
            <p:nvSpPr>
              <p:cNvPr id="264" name="Google Shape;264;p1"/>
              <p:cNvSpPr txBox="1"/>
              <p:nvPr/>
            </p:nvSpPr>
            <p:spPr>
              <a:xfrm>
                <a:off x="2257744" y="3503480"/>
                <a:ext cx="206180" cy="14826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40</a:t>
                </a:r>
                <a:endParaRPr dirty="0"/>
              </a:p>
            </p:txBody>
          </p:sp>
          <p:sp>
            <p:nvSpPr>
              <p:cNvPr id="265" name="Google Shape;265;p1"/>
              <p:cNvSpPr txBox="1"/>
              <p:nvPr/>
            </p:nvSpPr>
            <p:spPr>
              <a:xfrm>
                <a:off x="2222175" y="3203063"/>
                <a:ext cx="245720" cy="14826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0.6</a:t>
                </a:r>
                <a:endParaRPr/>
              </a:p>
            </p:txBody>
          </p:sp>
          <p:sp>
            <p:nvSpPr>
              <p:cNvPr id="266" name="Google Shape;266;p1"/>
              <p:cNvSpPr txBox="1"/>
              <p:nvPr/>
            </p:nvSpPr>
            <p:spPr>
              <a:xfrm>
                <a:off x="2277425" y="2902839"/>
                <a:ext cx="158165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9</a:t>
                </a:r>
                <a:endParaRPr dirty="0"/>
              </a:p>
            </p:txBody>
          </p:sp>
          <p:sp>
            <p:nvSpPr>
              <p:cNvPr id="267" name="Google Shape;267;p1"/>
              <p:cNvSpPr txBox="1"/>
              <p:nvPr/>
            </p:nvSpPr>
            <p:spPr>
              <a:xfrm>
                <a:off x="2284097" y="2602706"/>
                <a:ext cx="183411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8</a:t>
                </a:r>
                <a:endParaRPr dirty="0"/>
              </a:p>
            </p:txBody>
          </p:sp>
        </p:grpSp>
        <p:sp>
          <p:nvSpPr>
            <p:cNvPr id="268" name="Google Shape;268;p1"/>
            <p:cNvSpPr/>
            <p:nvPr/>
          </p:nvSpPr>
          <p:spPr>
            <a:xfrm>
              <a:off x="3704667" y="2635449"/>
              <a:ext cx="60045" cy="1200908"/>
            </a:xfrm>
            <a:prstGeom prst="rect">
              <a:avLst/>
            </a:prstGeom>
            <a:gradFill>
              <a:gsLst>
                <a:gs pos="0">
                  <a:srgbClr val="00007F"/>
                </a:gs>
                <a:gs pos="1562">
                  <a:srgbClr val="000091"/>
                </a:gs>
                <a:gs pos="3125">
                  <a:srgbClr val="0000A3"/>
                </a:gs>
                <a:gs pos="4688">
                  <a:srgbClr val="0000B6"/>
                </a:gs>
                <a:gs pos="6250">
                  <a:srgbClr val="0000C8"/>
                </a:gs>
                <a:gs pos="7812">
                  <a:srgbClr val="0000DA"/>
                </a:gs>
                <a:gs pos="9375">
                  <a:srgbClr val="0000EC"/>
                </a:gs>
                <a:gs pos="10938">
                  <a:srgbClr val="0000FE"/>
                </a:gs>
                <a:gs pos="12500">
                  <a:srgbClr val="0000FF"/>
                </a:gs>
                <a:gs pos="14062">
                  <a:srgbClr val="0010FF"/>
                </a:gs>
                <a:gs pos="15625">
                  <a:srgbClr val="0020FF"/>
                </a:gs>
                <a:gs pos="17188">
                  <a:srgbClr val="0030FF"/>
                </a:gs>
                <a:gs pos="18750">
                  <a:srgbClr val="0040FF"/>
                </a:gs>
                <a:gs pos="20312">
                  <a:srgbClr val="0050FF"/>
                </a:gs>
                <a:gs pos="21875">
                  <a:srgbClr val="0060FF"/>
                </a:gs>
                <a:gs pos="23438">
                  <a:srgbClr val="0070FF"/>
                </a:gs>
                <a:gs pos="25000">
                  <a:srgbClr val="0084FF"/>
                </a:gs>
                <a:gs pos="26562">
                  <a:srgbClr val="0094FF"/>
                </a:gs>
                <a:gs pos="28125">
                  <a:srgbClr val="00A4FF"/>
                </a:gs>
                <a:gs pos="29688">
                  <a:srgbClr val="00B4FF"/>
                </a:gs>
                <a:gs pos="31250">
                  <a:srgbClr val="00C4FF"/>
                </a:gs>
                <a:gs pos="32812">
                  <a:srgbClr val="00D4FF"/>
                </a:gs>
                <a:gs pos="34375">
                  <a:srgbClr val="00E4F7"/>
                </a:gs>
                <a:gs pos="35938">
                  <a:srgbClr val="0CF4EA"/>
                </a:gs>
                <a:gs pos="37500">
                  <a:srgbClr val="18FFDD"/>
                </a:gs>
                <a:gs pos="39062">
                  <a:srgbClr val="25FFD0"/>
                </a:gs>
                <a:gs pos="40625">
                  <a:srgbClr val="32FFC3"/>
                </a:gs>
                <a:gs pos="42188">
                  <a:srgbClr val="3FFFB7"/>
                </a:gs>
                <a:gs pos="43750">
                  <a:srgbClr val="4CFFAA"/>
                </a:gs>
                <a:gs pos="45312">
                  <a:srgbClr val="59FF9D"/>
                </a:gs>
                <a:gs pos="46875">
                  <a:srgbClr val="66FF90"/>
                </a:gs>
                <a:gs pos="48438">
                  <a:srgbClr val="73FF83"/>
                </a:gs>
                <a:gs pos="50000">
                  <a:srgbClr val="83FF73"/>
                </a:gs>
                <a:gs pos="51562">
                  <a:srgbClr val="90FF66"/>
                </a:gs>
                <a:gs pos="53125">
                  <a:srgbClr val="9DFF59"/>
                </a:gs>
                <a:gs pos="54688">
                  <a:srgbClr val="AAFF4C"/>
                </a:gs>
                <a:gs pos="56250">
                  <a:srgbClr val="B7FF3F"/>
                </a:gs>
                <a:gs pos="57812">
                  <a:srgbClr val="C3FF32"/>
                </a:gs>
                <a:gs pos="59375">
                  <a:srgbClr val="D0FF25"/>
                </a:gs>
                <a:gs pos="60938">
                  <a:srgbClr val="DDFF18"/>
                </a:gs>
                <a:gs pos="62500">
                  <a:srgbClr val="EAFF0C"/>
                </a:gs>
                <a:gs pos="64061">
                  <a:srgbClr val="F7F400"/>
                </a:gs>
                <a:gs pos="65625">
                  <a:srgbClr val="FFE500"/>
                </a:gs>
                <a:gs pos="67188">
                  <a:srgbClr val="FFD700"/>
                </a:gs>
                <a:gs pos="68750">
                  <a:srgbClr val="FFC800"/>
                </a:gs>
                <a:gs pos="70312">
                  <a:srgbClr val="FFB900"/>
                </a:gs>
                <a:gs pos="71875">
                  <a:srgbClr val="FFAA00"/>
                </a:gs>
                <a:gs pos="73438">
                  <a:srgbClr val="FF9B00"/>
                </a:gs>
                <a:gs pos="75000">
                  <a:srgbClr val="FF8900"/>
                </a:gs>
                <a:gs pos="76562">
                  <a:srgbClr val="FF7A00"/>
                </a:gs>
                <a:gs pos="78125">
                  <a:srgbClr val="FF6B00"/>
                </a:gs>
                <a:gs pos="79688">
                  <a:srgbClr val="FF5C00"/>
                </a:gs>
                <a:gs pos="81250">
                  <a:srgbClr val="FF4D00"/>
                </a:gs>
                <a:gs pos="82812">
                  <a:srgbClr val="FF3F00"/>
                </a:gs>
                <a:gs pos="84375">
                  <a:srgbClr val="FF3000"/>
                </a:gs>
                <a:gs pos="85938">
                  <a:srgbClr val="FF2100"/>
                </a:gs>
                <a:gs pos="87500">
                  <a:srgbClr val="FE1200"/>
                </a:gs>
                <a:gs pos="89062">
                  <a:srgbClr val="EC0300"/>
                </a:gs>
                <a:gs pos="90625">
                  <a:srgbClr val="DA0000"/>
                </a:gs>
                <a:gs pos="92188">
                  <a:srgbClr val="C80000"/>
                </a:gs>
                <a:gs pos="93750">
                  <a:srgbClr val="B60000"/>
                </a:gs>
                <a:gs pos="95312">
                  <a:srgbClr val="A30000"/>
                </a:gs>
                <a:gs pos="96875">
                  <a:srgbClr val="910000"/>
                </a:gs>
                <a:gs pos="98438">
                  <a:srgbClr val="7F0000"/>
                </a:gs>
                <a:gs pos="100000">
                  <a:srgbClr val="7F0000"/>
                </a:gs>
              </a:gsLst>
              <a:lin ang="16200000" scaled="0"/>
            </a:gra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69" name="Google Shape;269;p1"/>
            <p:cNvSpPr/>
            <p:nvPr/>
          </p:nvSpPr>
          <p:spPr>
            <a:xfrm>
              <a:off x="3701665" y="2632447"/>
              <a:ext cx="66050" cy="1206914"/>
            </a:xfrm>
            <a:custGeom>
              <a:avLst/>
              <a:gdLst/>
              <a:ahLst/>
              <a:cxnLst/>
              <a:rect l="l" t="t" r="r" b="b"/>
              <a:pathLst>
                <a:path w="66050" h="1206914" extrusionOk="0">
                  <a:moveTo>
                    <a:pt x="0" y="0"/>
                  </a:moveTo>
                  <a:lnTo>
                    <a:pt x="66050" y="0"/>
                  </a:lnTo>
                  <a:lnTo>
                    <a:pt x="66050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270" name="Google Shape;270;p1" descr="image.png"/>
            <p:cNvPicPr preferRelativeResize="0"/>
            <p:nvPr/>
          </p:nvPicPr>
          <p:blipFill rotWithShape="1">
            <a:blip r:embed="rId6">
              <a:alphaModFix/>
            </a:blip>
            <a:srcRect/>
            <a:stretch/>
          </p:blipFill>
          <p:spPr>
            <a:xfrm>
              <a:off x="3770717" y="2635449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71" name="Google Shape;271;p1"/>
            <p:cNvSpPr txBox="1"/>
            <p:nvPr/>
          </p:nvSpPr>
          <p:spPr>
            <a:xfrm>
              <a:off x="3830762" y="2887828"/>
              <a:ext cx="178234" cy="14384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10¹</a:t>
              </a:r>
              <a:endParaRPr dirty="0"/>
            </a:p>
          </p:txBody>
        </p:sp>
      </p:grpSp>
      <p:grpSp>
        <p:nvGrpSpPr>
          <p:cNvPr id="272" name="Google Shape;272;p1"/>
          <p:cNvGrpSpPr/>
          <p:nvPr/>
        </p:nvGrpSpPr>
        <p:grpSpPr>
          <a:xfrm>
            <a:off x="495800" y="3694548"/>
            <a:ext cx="1530232" cy="1288740"/>
            <a:chOff x="4039111" y="2473326"/>
            <a:chExt cx="2043355" cy="1720884"/>
          </a:xfrm>
        </p:grpSpPr>
        <p:pic>
          <p:nvPicPr>
            <p:cNvPr id="273" name="Google Shape;273;p1" descr="image.png"/>
            <p:cNvPicPr preferRelativeResize="0"/>
            <p:nvPr/>
          </p:nvPicPr>
          <p:blipFill rotWithShape="1">
            <a:blip r:embed="rId16">
              <a:alphaModFix/>
            </a:blip>
            <a:srcRect/>
            <a:stretch/>
          </p:blipFill>
          <p:spPr>
            <a:xfrm>
              <a:off x="4130990" y="2473326"/>
              <a:ext cx="1951476" cy="170529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74" name="Google Shape;274;p1"/>
            <p:cNvSpPr/>
            <p:nvPr/>
          </p:nvSpPr>
          <p:spPr>
            <a:xfrm>
              <a:off x="4470247" y="2632447"/>
              <a:ext cx="1206914" cy="1206914"/>
            </a:xfrm>
            <a:custGeom>
              <a:avLst/>
              <a:gdLst/>
              <a:ahLst/>
              <a:cxnLst/>
              <a:rect l="l" t="t" r="r" b="b"/>
              <a:pathLst>
                <a:path w="1206914" h="1206914" extrusionOk="0">
                  <a:moveTo>
                    <a:pt x="0" y="0"/>
                  </a:moveTo>
                  <a:lnTo>
                    <a:pt x="1206914" y="0"/>
                  </a:lnTo>
                  <a:lnTo>
                    <a:pt x="1206914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75" name="Google Shape;275;p1"/>
            <p:cNvSpPr txBox="1"/>
            <p:nvPr/>
          </p:nvSpPr>
          <p:spPr>
            <a:xfrm>
              <a:off x="4887564" y="4029817"/>
              <a:ext cx="584700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1</a:t>
              </a:r>
              <a:endParaRPr dirty="0"/>
            </a:p>
          </p:txBody>
        </p:sp>
        <p:sp>
          <p:nvSpPr>
            <p:cNvPr id="276" name="Google Shape;276;p1"/>
            <p:cNvSpPr txBox="1"/>
            <p:nvPr/>
          </p:nvSpPr>
          <p:spPr>
            <a:xfrm rot="16200000">
              <a:off x="3797539" y="3089209"/>
              <a:ext cx="647537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2</a:t>
              </a:r>
              <a:endParaRPr dirty="0"/>
            </a:p>
          </p:txBody>
        </p:sp>
        <p:pic>
          <p:nvPicPr>
            <p:cNvPr id="277" name="Google Shape;277;p1" descr="image.png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4473249" y="3842362"/>
              <a:ext cx="1194903" cy="180135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278" name="Google Shape;278;p1"/>
            <p:cNvGrpSpPr/>
            <p:nvPr/>
          </p:nvGrpSpPr>
          <p:grpSpPr>
            <a:xfrm>
              <a:off x="4425212" y="3917607"/>
              <a:ext cx="1375036" cy="145531"/>
              <a:chOff x="4425212" y="3917607"/>
              <a:chExt cx="1375036" cy="145531"/>
            </a:xfrm>
          </p:grpSpPr>
          <p:sp>
            <p:nvSpPr>
              <p:cNvPr id="279" name="Google Shape;279;p1"/>
              <p:cNvSpPr txBox="1"/>
              <p:nvPr/>
            </p:nvSpPr>
            <p:spPr>
              <a:xfrm>
                <a:off x="4425212" y="3919295"/>
                <a:ext cx="219161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1</a:t>
                </a:r>
                <a:endParaRPr dirty="0"/>
              </a:p>
            </p:txBody>
          </p:sp>
          <p:sp>
            <p:nvSpPr>
              <p:cNvPr id="280" name="Google Shape;280;p1"/>
              <p:cNvSpPr txBox="1"/>
              <p:nvPr/>
            </p:nvSpPr>
            <p:spPr>
              <a:xfrm>
                <a:off x="4713428" y="3917607"/>
                <a:ext cx="219161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36</a:t>
                </a:r>
                <a:endParaRPr/>
              </a:p>
            </p:txBody>
          </p:sp>
          <p:sp>
            <p:nvSpPr>
              <p:cNvPr id="281" name="Google Shape;281;p1"/>
              <p:cNvSpPr txBox="1"/>
              <p:nvPr/>
            </p:nvSpPr>
            <p:spPr>
              <a:xfrm>
                <a:off x="5019660" y="3917700"/>
                <a:ext cx="210153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0.4</a:t>
                </a:r>
                <a:endParaRPr/>
              </a:p>
            </p:txBody>
          </p:sp>
          <p:sp>
            <p:nvSpPr>
              <p:cNvPr id="282" name="Google Shape;282;p1"/>
              <p:cNvSpPr txBox="1"/>
              <p:nvPr/>
            </p:nvSpPr>
            <p:spPr>
              <a:xfrm>
                <a:off x="5325893" y="3917607"/>
                <a:ext cx="168123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6</a:t>
                </a:r>
                <a:endParaRPr/>
              </a:p>
            </p:txBody>
          </p:sp>
          <p:sp>
            <p:nvSpPr>
              <p:cNvPr id="283" name="Google Shape;283;p1"/>
              <p:cNvSpPr txBox="1"/>
              <p:nvPr/>
            </p:nvSpPr>
            <p:spPr>
              <a:xfrm>
                <a:off x="5632125" y="3918451"/>
                <a:ext cx="168123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2</a:t>
                </a:r>
                <a:endParaRPr/>
              </a:p>
            </p:txBody>
          </p:sp>
        </p:grpSp>
        <p:pic>
          <p:nvPicPr>
            <p:cNvPr id="284" name="Google Shape;284;p1" descr="image.png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4287108" y="2635449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285" name="Google Shape;285;p1"/>
            <p:cNvGrpSpPr/>
            <p:nvPr/>
          </p:nvGrpSpPr>
          <p:grpSpPr>
            <a:xfrm>
              <a:off x="4193637" y="2602706"/>
              <a:ext cx="277699" cy="1338655"/>
              <a:chOff x="4193637" y="2602706"/>
              <a:chExt cx="277699" cy="1338655"/>
            </a:xfrm>
          </p:grpSpPr>
          <p:sp>
            <p:nvSpPr>
              <p:cNvPr id="286" name="Google Shape;286;p1"/>
              <p:cNvSpPr txBox="1"/>
              <p:nvPr/>
            </p:nvSpPr>
            <p:spPr>
              <a:xfrm>
                <a:off x="4224444" y="3797517"/>
                <a:ext cx="222955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9</a:t>
                </a:r>
                <a:endParaRPr/>
              </a:p>
            </p:txBody>
          </p:sp>
          <p:sp>
            <p:nvSpPr>
              <p:cNvPr id="287" name="Google Shape;287;p1"/>
              <p:cNvSpPr txBox="1"/>
              <p:nvPr/>
            </p:nvSpPr>
            <p:spPr>
              <a:xfrm>
                <a:off x="4234559" y="3503480"/>
                <a:ext cx="236777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40</a:t>
                </a:r>
                <a:endParaRPr dirty="0"/>
              </a:p>
            </p:txBody>
          </p:sp>
          <p:sp>
            <p:nvSpPr>
              <p:cNvPr id="288" name="Google Shape;288;p1"/>
              <p:cNvSpPr txBox="1"/>
              <p:nvPr/>
            </p:nvSpPr>
            <p:spPr>
              <a:xfrm>
                <a:off x="4193637" y="3203063"/>
                <a:ext cx="265710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0.6</a:t>
                </a:r>
                <a:endParaRPr dirty="0"/>
              </a:p>
            </p:txBody>
          </p:sp>
          <p:sp>
            <p:nvSpPr>
              <p:cNvPr id="289" name="Google Shape;289;p1"/>
              <p:cNvSpPr txBox="1"/>
              <p:nvPr/>
            </p:nvSpPr>
            <p:spPr>
              <a:xfrm>
                <a:off x="4261368" y="2902839"/>
                <a:ext cx="181638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9</a:t>
                </a:r>
                <a:endParaRPr/>
              </a:p>
            </p:txBody>
          </p:sp>
          <p:sp>
            <p:nvSpPr>
              <p:cNvPr id="290" name="Google Shape;290;p1"/>
              <p:cNvSpPr txBox="1"/>
              <p:nvPr/>
            </p:nvSpPr>
            <p:spPr>
              <a:xfrm>
                <a:off x="4248031" y="2602706"/>
                <a:ext cx="171034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8</a:t>
                </a:r>
                <a:endParaRPr dirty="0"/>
              </a:p>
            </p:txBody>
          </p:sp>
        </p:grpSp>
        <p:sp>
          <p:nvSpPr>
            <p:cNvPr id="291" name="Google Shape;291;p1"/>
            <p:cNvSpPr/>
            <p:nvPr/>
          </p:nvSpPr>
          <p:spPr>
            <a:xfrm>
              <a:off x="5680162" y="2635449"/>
              <a:ext cx="60045" cy="1200908"/>
            </a:xfrm>
            <a:prstGeom prst="rect">
              <a:avLst/>
            </a:prstGeom>
            <a:gradFill>
              <a:gsLst>
                <a:gs pos="0">
                  <a:srgbClr val="00007F"/>
                </a:gs>
                <a:gs pos="1562">
                  <a:srgbClr val="000091"/>
                </a:gs>
                <a:gs pos="3125">
                  <a:srgbClr val="0000A3"/>
                </a:gs>
                <a:gs pos="4688">
                  <a:srgbClr val="0000B6"/>
                </a:gs>
                <a:gs pos="6250">
                  <a:srgbClr val="0000C8"/>
                </a:gs>
                <a:gs pos="7812">
                  <a:srgbClr val="0000DA"/>
                </a:gs>
                <a:gs pos="9375">
                  <a:srgbClr val="0000EC"/>
                </a:gs>
                <a:gs pos="10938">
                  <a:srgbClr val="0000FE"/>
                </a:gs>
                <a:gs pos="12500">
                  <a:srgbClr val="0000FF"/>
                </a:gs>
                <a:gs pos="14062">
                  <a:srgbClr val="0010FF"/>
                </a:gs>
                <a:gs pos="15625">
                  <a:srgbClr val="0020FF"/>
                </a:gs>
                <a:gs pos="17188">
                  <a:srgbClr val="0030FF"/>
                </a:gs>
                <a:gs pos="18750">
                  <a:srgbClr val="0040FF"/>
                </a:gs>
                <a:gs pos="20312">
                  <a:srgbClr val="0050FF"/>
                </a:gs>
                <a:gs pos="21875">
                  <a:srgbClr val="0060FF"/>
                </a:gs>
                <a:gs pos="23438">
                  <a:srgbClr val="0070FF"/>
                </a:gs>
                <a:gs pos="25000">
                  <a:srgbClr val="0084FF"/>
                </a:gs>
                <a:gs pos="26562">
                  <a:srgbClr val="0094FF"/>
                </a:gs>
                <a:gs pos="28125">
                  <a:srgbClr val="00A4FF"/>
                </a:gs>
                <a:gs pos="29688">
                  <a:srgbClr val="00B4FF"/>
                </a:gs>
                <a:gs pos="31250">
                  <a:srgbClr val="00C4FF"/>
                </a:gs>
                <a:gs pos="32812">
                  <a:srgbClr val="00D4FF"/>
                </a:gs>
                <a:gs pos="34375">
                  <a:srgbClr val="00E4F7"/>
                </a:gs>
                <a:gs pos="35938">
                  <a:srgbClr val="0CF4EA"/>
                </a:gs>
                <a:gs pos="37500">
                  <a:srgbClr val="18FFDD"/>
                </a:gs>
                <a:gs pos="39062">
                  <a:srgbClr val="25FFD0"/>
                </a:gs>
                <a:gs pos="40625">
                  <a:srgbClr val="32FFC3"/>
                </a:gs>
                <a:gs pos="42188">
                  <a:srgbClr val="3FFFB7"/>
                </a:gs>
                <a:gs pos="43750">
                  <a:srgbClr val="4CFFAA"/>
                </a:gs>
                <a:gs pos="45312">
                  <a:srgbClr val="59FF9D"/>
                </a:gs>
                <a:gs pos="46875">
                  <a:srgbClr val="66FF90"/>
                </a:gs>
                <a:gs pos="48438">
                  <a:srgbClr val="73FF83"/>
                </a:gs>
                <a:gs pos="50000">
                  <a:srgbClr val="83FF73"/>
                </a:gs>
                <a:gs pos="51562">
                  <a:srgbClr val="90FF66"/>
                </a:gs>
                <a:gs pos="53125">
                  <a:srgbClr val="9DFF59"/>
                </a:gs>
                <a:gs pos="54688">
                  <a:srgbClr val="AAFF4C"/>
                </a:gs>
                <a:gs pos="56250">
                  <a:srgbClr val="B7FF3F"/>
                </a:gs>
                <a:gs pos="57812">
                  <a:srgbClr val="C3FF32"/>
                </a:gs>
                <a:gs pos="59375">
                  <a:srgbClr val="D0FF25"/>
                </a:gs>
                <a:gs pos="60938">
                  <a:srgbClr val="DDFF18"/>
                </a:gs>
                <a:gs pos="62500">
                  <a:srgbClr val="EAFF0C"/>
                </a:gs>
                <a:gs pos="64061">
                  <a:srgbClr val="F7F400"/>
                </a:gs>
                <a:gs pos="65625">
                  <a:srgbClr val="FFE500"/>
                </a:gs>
                <a:gs pos="67188">
                  <a:srgbClr val="FFD700"/>
                </a:gs>
                <a:gs pos="68750">
                  <a:srgbClr val="FFC800"/>
                </a:gs>
                <a:gs pos="70312">
                  <a:srgbClr val="FFB900"/>
                </a:gs>
                <a:gs pos="71875">
                  <a:srgbClr val="FFAA00"/>
                </a:gs>
                <a:gs pos="73438">
                  <a:srgbClr val="FF9B00"/>
                </a:gs>
                <a:gs pos="75000">
                  <a:srgbClr val="FF8900"/>
                </a:gs>
                <a:gs pos="76562">
                  <a:srgbClr val="FF7A00"/>
                </a:gs>
                <a:gs pos="78125">
                  <a:srgbClr val="FF6B00"/>
                </a:gs>
                <a:gs pos="79688">
                  <a:srgbClr val="FF5C00"/>
                </a:gs>
                <a:gs pos="81250">
                  <a:srgbClr val="FF4D00"/>
                </a:gs>
                <a:gs pos="82812">
                  <a:srgbClr val="FF3F00"/>
                </a:gs>
                <a:gs pos="84375">
                  <a:srgbClr val="FF3000"/>
                </a:gs>
                <a:gs pos="85938">
                  <a:srgbClr val="FF2100"/>
                </a:gs>
                <a:gs pos="87500">
                  <a:srgbClr val="FE1200"/>
                </a:gs>
                <a:gs pos="89062">
                  <a:srgbClr val="EC0300"/>
                </a:gs>
                <a:gs pos="90625">
                  <a:srgbClr val="DA0000"/>
                </a:gs>
                <a:gs pos="92188">
                  <a:srgbClr val="C80000"/>
                </a:gs>
                <a:gs pos="93750">
                  <a:srgbClr val="B60000"/>
                </a:gs>
                <a:gs pos="95312">
                  <a:srgbClr val="A30000"/>
                </a:gs>
                <a:gs pos="96875">
                  <a:srgbClr val="910000"/>
                </a:gs>
                <a:gs pos="98438">
                  <a:srgbClr val="7F0000"/>
                </a:gs>
                <a:gs pos="100000">
                  <a:srgbClr val="7F0000"/>
                </a:gs>
              </a:gsLst>
              <a:lin ang="16200000" scaled="0"/>
            </a:gra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92" name="Google Shape;292;p1"/>
            <p:cNvSpPr/>
            <p:nvPr/>
          </p:nvSpPr>
          <p:spPr>
            <a:xfrm>
              <a:off x="5677161" y="2632447"/>
              <a:ext cx="66049" cy="1206914"/>
            </a:xfrm>
            <a:custGeom>
              <a:avLst/>
              <a:gdLst/>
              <a:ahLst/>
              <a:cxnLst/>
              <a:rect l="l" t="t" r="r" b="b"/>
              <a:pathLst>
                <a:path w="66049" h="1206914" extrusionOk="0">
                  <a:moveTo>
                    <a:pt x="0" y="0"/>
                  </a:moveTo>
                  <a:lnTo>
                    <a:pt x="66049" y="0"/>
                  </a:lnTo>
                  <a:lnTo>
                    <a:pt x="66049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293" name="Google Shape;293;p1" descr="image.png"/>
            <p:cNvPicPr preferRelativeResize="0"/>
            <p:nvPr/>
          </p:nvPicPr>
          <p:blipFill rotWithShape="1">
            <a:blip r:embed="rId17">
              <a:alphaModFix/>
            </a:blip>
            <a:srcRect/>
            <a:stretch/>
          </p:blipFill>
          <p:spPr>
            <a:xfrm>
              <a:off x="5746212" y="2635449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294" name="Google Shape;294;p1"/>
            <p:cNvGrpSpPr/>
            <p:nvPr/>
          </p:nvGrpSpPr>
          <p:grpSpPr>
            <a:xfrm>
              <a:off x="5806258" y="2761732"/>
              <a:ext cx="212600" cy="915617"/>
              <a:chOff x="5806258" y="2761732"/>
              <a:chExt cx="212600" cy="915617"/>
            </a:xfrm>
          </p:grpSpPr>
          <p:sp>
            <p:nvSpPr>
              <p:cNvPr id="295" name="Google Shape;295;p1"/>
              <p:cNvSpPr txBox="1"/>
              <p:nvPr/>
            </p:nvSpPr>
            <p:spPr>
              <a:xfrm>
                <a:off x="5806258" y="3533505"/>
                <a:ext cx="59934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0</a:t>
                </a:r>
                <a:endParaRPr/>
              </a:p>
            </p:txBody>
          </p:sp>
          <p:sp>
            <p:nvSpPr>
              <p:cNvPr id="296" name="Google Shape;296;p1"/>
              <p:cNvSpPr txBox="1"/>
              <p:nvPr/>
            </p:nvSpPr>
            <p:spPr>
              <a:xfrm>
                <a:off x="5806258" y="2761732"/>
                <a:ext cx="212600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10¹</a:t>
                </a:r>
                <a:endParaRPr dirty="0"/>
              </a:p>
            </p:txBody>
          </p:sp>
        </p:grpSp>
      </p:grpSp>
      <p:grpSp>
        <p:nvGrpSpPr>
          <p:cNvPr id="297" name="Google Shape;297;p1"/>
          <p:cNvGrpSpPr/>
          <p:nvPr/>
        </p:nvGrpSpPr>
        <p:grpSpPr>
          <a:xfrm>
            <a:off x="1980648" y="3690595"/>
            <a:ext cx="1532398" cy="1288740"/>
            <a:chOff x="6011713" y="2473326"/>
            <a:chExt cx="2046248" cy="1720884"/>
          </a:xfrm>
        </p:grpSpPr>
        <p:pic>
          <p:nvPicPr>
            <p:cNvPr id="298" name="Google Shape;298;p1" descr="image.png"/>
            <p:cNvPicPr preferRelativeResize="0"/>
            <p:nvPr/>
          </p:nvPicPr>
          <p:blipFill rotWithShape="1">
            <a:blip r:embed="rId18">
              <a:alphaModFix/>
            </a:blip>
            <a:srcRect/>
            <a:stretch/>
          </p:blipFill>
          <p:spPr>
            <a:xfrm>
              <a:off x="6106485" y="2473326"/>
              <a:ext cx="1951476" cy="170529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99" name="Google Shape;299;p1"/>
            <p:cNvSpPr/>
            <p:nvPr/>
          </p:nvSpPr>
          <p:spPr>
            <a:xfrm>
              <a:off x="6445742" y="2632447"/>
              <a:ext cx="1206914" cy="1206914"/>
            </a:xfrm>
            <a:custGeom>
              <a:avLst/>
              <a:gdLst/>
              <a:ahLst/>
              <a:cxnLst/>
              <a:rect l="l" t="t" r="r" b="b"/>
              <a:pathLst>
                <a:path w="1206914" h="1206914" extrusionOk="0">
                  <a:moveTo>
                    <a:pt x="0" y="0"/>
                  </a:moveTo>
                  <a:lnTo>
                    <a:pt x="1206914" y="0"/>
                  </a:lnTo>
                  <a:lnTo>
                    <a:pt x="1206914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00" name="Google Shape;300;p1"/>
            <p:cNvSpPr txBox="1"/>
            <p:nvPr/>
          </p:nvSpPr>
          <p:spPr>
            <a:xfrm>
              <a:off x="6863057" y="4029817"/>
              <a:ext cx="602805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1</a:t>
              </a:r>
              <a:endParaRPr dirty="0"/>
            </a:p>
          </p:txBody>
        </p:sp>
        <p:sp>
          <p:nvSpPr>
            <p:cNvPr id="301" name="Google Shape;301;p1"/>
            <p:cNvSpPr txBox="1"/>
            <p:nvPr/>
          </p:nvSpPr>
          <p:spPr>
            <a:xfrm rot="16200000">
              <a:off x="5787402" y="3106469"/>
              <a:ext cx="613015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2</a:t>
              </a:r>
              <a:endParaRPr dirty="0"/>
            </a:p>
          </p:txBody>
        </p:sp>
        <p:pic>
          <p:nvPicPr>
            <p:cNvPr id="302" name="Google Shape;302;p1" descr="image.png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6448744" y="3842362"/>
              <a:ext cx="1194903" cy="180135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303" name="Google Shape;303;p1"/>
            <p:cNvGrpSpPr/>
            <p:nvPr/>
          </p:nvGrpSpPr>
          <p:grpSpPr>
            <a:xfrm>
              <a:off x="6400707" y="3917607"/>
              <a:ext cx="1359378" cy="145531"/>
              <a:chOff x="6400707" y="3917607"/>
              <a:chExt cx="1359378" cy="145531"/>
            </a:xfrm>
          </p:grpSpPr>
          <p:sp>
            <p:nvSpPr>
              <p:cNvPr id="304" name="Google Shape;304;p1"/>
              <p:cNvSpPr txBox="1"/>
              <p:nvPr/>
            </p:nvSpPr>
            <p:spPr>
              <a:xfrm>
                <a:off x="6400707" y="3919295"/>
                <a:ext cx="198750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1</a:t>
                </a:r>
                <a:endParaRPr dirty="0"/>
              </a:p>
            </p:txBody>
          </p:sp>
          <p:sp>
            <p:nvSpPr>
              <p:cNvPr id="305" name="Google Shape;305;p1"/>
              <p:cNvSpPr txBox="1"/>
              <p:nvPr/>
            </p:nvSpPr>
            <p:spPr>
              <a:xfrm>
                <a:off x="6688923" y="3917607"/>
                <a:ext cx="198750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36</a:t>
                </a:r>
                <a:endParaRPr/>
              </a:p>
            </p:txBody>
          </p:sp>
          <p:sp>
            <p:nvSpPr>
              <p:cNvPr id="306" name="Google Shape;306;p1"/>
              <p:cNvSpPr txBox="1"/>
              <p:nvPr/>
            </p:nvSpPr>
            <p:spPr>
              <a:xfrm>
                <a:off x="6995153" y="3917700"/>
                <a:ext cx="190581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0.4</a:t>
                </a:r>
                <a:endParaRPr/>
              </a:p>
            </p:txBody>
          </p:sp>
          <p:sp>
            <p:nvSpPr>
              <p:cNvPr id="307" name="Google Shape;307;p1"/>
              <p:cNvSpPr txBox="1"/>
              <p:nvPr/>
            </p:nvSpPr>
            <p:spPr>
              <a:xfrm>
                <a:off x="7301388" y="3917607"/>
                <a:ext cx="152465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6</a:t>
                </a:r>
                <a:endParaRPr/>
              </a:p>
            </p:txBody>
          </p:sp>
          <p:sp>
            <p:nvSpPr>
              <p:cNvPr id="308" name="Google Shape;308;p1"/>
              <p:cNvSpPr txBox="1"/>
              <p:nvPr/>
            </p:nvSpPr>
            <p:spPr>
              <a:xfrm>
                <a:off x="7607620" y="3918451"/>
                <a:ext cx="152465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2</a:t>
                </a:r>
                <a:endParaRPr/>
              </a:p>
            </p:txBody>
          </p:sp>
        </p:grpSp>
        <p:pic>
          <p:nvPicPr>
            <p:cNvPr id="309" name="Google Shape;309;p1" descr="image.png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6262603" y="2635449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310" name="Google Shape;310;p1"/>
            <p:cNvGrpSpPr/>
            <p:nvPr/>
          </p:nvGrpSpPr>
          <p:grpSpPr>
            <a:xfrm>
              <a:off x="6171231" y="2602706"/>
              <a:ext cx="243682" cy="1338655"/>
              <a:chOff x="6171231" y="2602706"/>
              <a:chExt cx="243682" cy="1338655"/>
            </a:xfrm>
          </p:grpSpPr>
          <p:sp>
            <p:nvSpPr>
              <p:cNvPr id="311" name="Google Shape;311;p1"/>
              <p:cNvSpPr txBox="1"/>
              <p:nvPr/>
            </p:nvSpPr>
            <p:spPr>
              <a:xfrm>
                <a:off x="6201973" y="3797517"/>
                <a:ext cx="181018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9</a:t>
                </a:r>
                <a:endParaRPr/>
              </a:p>
            </p:txBody>
          </p:sp>
          <p:sp>
            <p:nvSpPr>
              <p:cNvPr id="312" name="Google Shape;312;p1"/>
              <p:cNvSpPr txBox="1"/>
              <p:nvPr/>
            </p:nvSpPr>
            <p:spPr>
              <a:xfrm>
                <a:off x="6198386" y="3503479"/>
                <a:ext cx="216527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40</a:t>
                </a:r>
                <a:endParaRPr/>
              </a:p>
            </p:txBody>
          </p:sp>
          <p:sp>
            <p:nvSpPr>
              <p:cNvPr id="313" name="Google Shape;313;p1"/>
              <p:cNvSpPr txBox="1"/>
              <p:nvPr/>
            </p:nvSpPr>
            <p:spPr>
              <a:xfrm>
                <a:off x="6171231" y="3203063"/>
                <a:ext cx="215734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0.6</a:t>
                </a:r>
                <a:endParaRPr dirty="0"/>
              </a:p>
            </p:txBody>
          </p:sp>
          <p:sp>
            <p:nvSpPr>
              <p:cNvPr id="314" name="Google Shape;314;p1"/>
              <p:cNvSpPr txBox="1"/>
              <p:nvPr/>
            </p:nvSpPr>
            <p:spPr>
              <a:xfrm>
                <a:off x="6228458" y="2902837"/>
                <a:ext cx="166103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9</a:t>
                </a:r>
                <a:endParaRPr dirty="0"/>
              </a:p>
            </p:txBody>
          </p:sp>
          <p:sp>
            <p:nvSpPr>
              <p:cNvPr id="315" name="Google Shape;315;p1"/>
              <p:cNvSpPr txBox="1"/>
              <p:nvPr/>
            </p:nvSpPr>
            <p:spPr>
              <a:xfrm>
                <a:off x="6231756" y="2602706"/>
                <a:ext cx="138863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8</a:t>
                </a:r>
                <a:endParaRPr dirty="0"/>
              </a:p>
            </p:txBody>
          </p:sp>
        </p:grpSp>
        <p:sp>
          <p:nvSpPr>
            <p:cNvPr id="316" name="Google Shape;316;p1"/>
            <p:cNvSpPr/>
            <p:nvPr/>
          </p:nvSpPr>
          <p:spPr>
            <a:xfrm>
              <a:off x="7655657" y="2635449"/>
              <a:ext cx="60045" cy="1200908"/>
            </a:xfrm>
            <a:prstGeom prst="rect">
              <a:avLst/>
            </a:prstGeom>
            <a:gradFill>
              <a:gsLst>
                <a:gs pos="0">
                  <a:srgbClr val="00007F"/>
                </a:gs>
                <a:gs pos="1562">
                  <a:srgbClr val="000091"/>
                </a:gs>
                <a:gs pos="3125">
                  <a:srgbClr val="0000A3"/>
                </a:gs>
                <a:gs pos="4688">
                  <a:srgbClr val="0000B6"/>
                </a:gs>
                <a:gs pos="6250">
                  <a:srgbClr val="0000C8"/>
                </a:gs>
                <a:gs pos="7812">
                  <a:srgbClr val="0000DA"/>
                </a:gs>
                <a:gs pos="9375">
                  <a:srgbClr val="0000EC"/>
                </a:gs>
                <a:gs pos="10938">
                  <a:srgbClr val="0000FE"/>
                </a:gs>
                <a:gs pos="12500">
                  <a:srgbClr val="0000FF"/>
                </a:gs>
                <a:gs pos="14062">
                  <a:srgbClr val="0010FF"/>
                </a:gs>
                <a:gs pos="15625">
                  <a:srgbClr val="0020FF"/>
                </a:gs>
                <a:gs pos="17188">
                  <a:srgbClr val="0030FF"/>
                </a:gs>
                <a:gs pos="18750">
                  <a:srgbClr val="0040FF"/>
                </a:gs>
                <a:gs pos="20312">
                  <a:srgbClr val="0050FF"/>
                </a:gs>
                <a:gs pos="21875">
                  <a:srgbClr val="0060FF"/>
                </a:gs>
                <a:gs pos="23438">
                  <a:srgbClr val="0070FF"/>
                </a:gs>
                <a:gs pos="25000">
                  <a:srgbClr val="0084FF"/>
                </a:gs>
                <a:gs pos="26562">
                  <a:srgbClr val="0094FF"/>
                </a:gs>
                <a:gs pos="28125">
                  <a:srgbClr val="00A4FF"/>
                </a:gs>
                <a:gs pos="29688">
                  <a:srgbClr val="00B4FF"/>
                </a:gs>
                <a:gs pos="31250">
                  <a:srgbClr val="00C4FF"/>
                </a:gs>
                <a:gs pos="32812">
                  <a:srgbClr val="00D4FF"/>
                </a:gs>
                <a:gs pos="34375">
                  <a:srgbClr val="00E4F7"/>
                </a:gs>
                <a:gs pos="35938">
                  <a:srgbClr val="0CF4EA"/>
                </a:gs>
                <a:gs pos="37500">
                  <a:srgbClr val="18FFDD"/>
                </a:gs>
                <a:gs pos="39062">
                  <a:srgbClr val="25FFD0"/>
                </a:gs>
                <a:gs pos="40625">
                  <a:srgbClr val="32FFC3"/>
                </a:gs>
                <a:gs pos="42188">
                  <a:srgbClr val="3FFFB7"/>
                </a:gs>
                <a:gs pos="43750">
                  <a:srgbClr val="4CFFAA"/>
                </a:gs>
                <a:gs pos="45312">
                  <a:srgbClr val="59FF9D"/>
                </a:gs>
                <a:gs pos="46875">
                  <a:srgbClr val="66FF90"/>
                </a:gs>
                <a:gs pos="48438">
                  <a:srgbClr val="73FF83"/>
                </a:gs>
                <a:gs pos="50000">
                  <a:srgbClr val="83FF73"/>
                </a:gs>
                <a:gs pos="51562">
                  <a:srgbClr val="90FF66"/>
                </a:gs>
                <a:gs pos="53125">
                  <a:srgbClr val="9DFF59"/>
                </a:gs>
                <a:gs pos="54688">
                  <a:srgbClr val="AAFF4C"/>
                </a:gs>
                <a:gs pos="56250">
                  <a:srgbClr val="B7FF3F"/>
                </a:gs>
                <a:gs pos="57812">
                  <a:srgbClr val="C3FF32"/>
                </a:gs>
                <a:gs pos="59375">
                  <a:srgbClr val="D0FF25"/>
                </a:gs>
                <a:gs pos="60938">
                  <a:srgbClr val="DDFF18"/>
                </a:gs>
                <a:gs pos="62500">
                  <a:srgbClr val="EAFF0C"/>
                </a:gs>
                <a:gs pos="64061">
                  <a:srgbClr val="F7F400"/>
                </a:gs>
                <a:gs pos="65625">
                  <a:srgbClr val="FFE500"/>
                </a:gs>
                <a:gs pos="67188">
                  <a:srgbClr val="FFD700"/>
                </a:gs>
                <a:gs pos="68750">
                  <a:srgbClr val="FFC800"/>
                </a:gs>
                <a:gs pos="70312">
                  <a:srgbClr val="FFB900"/>
                </a:gs>
                <a:gs pos="71875">
                  <a:srgbClr val="FFAA00"/>
                </a:gs>
                <a:gs pos="73438">
                  <a:srgbClr val="FF9B00"/>
                </a:gs>
                <a:gs pos="75000">
                  <a:srgbClr val="FF8900"/>
                </a:gs>
                <a:gs pos="76562">
                  <a:srgbClr val="FF7A00"/>
                </a:gs>
                <a:gs pos="78125">
                  <a:srgbClr val="FF6B00"/>
                </a:gs>
                <a:gs pos="79688">
                  <a:srgbClr val="FF5C00"/>
                </a:gs>
                <a:gs pos="81250">
                  <a:srgbClr val="FF4D00"/>
                </a:gs>
                <a:gs pos="82812">
                  <a:srgbClr val="FF3F00"/>
                </a:gs>
                <a:gs pos="84375">
                  <a:srgbClr val="FF3000"/>
                </a:gs>
                <a:gs pos="85938">
                  <a:srgbClr val="FF2100"/>
                </a:gs>
                <a:gs pos="87500">
                  <a:srgbClr val="FE1200"/>
                </a:gs>
                <a:gs pos="89062">
                  <a:srgbClr val="EC0300"/>
                </a:gs>
                <a:gs pos="90625">
                  <a:srgbClr val="DA0000"/>
                </a:gs>
                <a:gs pos="92188">
                  <a:srgbClr val="C80000"/>
                </a:gs>
                <a:gs pos="93750">
                  <a:srgbClr val="B60000"/>
                </a:gs>
                <a:gs pos="95312">
                  <a:srgbClr val="A30000"/>
                </a:gs>
                <a:gs pos="96875">
                  <a:srgbClr val="910000"/>
                </a:gs>
                <a:gs pos="98438">
                  <a:srgbClr val="7F0000"/>
                </a:gs>
                <a:gs pos="100000">
                  <a:srgbClr val="7F0000"/>
                </a:gs>
              </a:gsLst>
              <a:lin ang="16200000" scaled="0"/>
            </a:gra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17" name="Google Shape;317;p1"/>
            <p:cNvSpPr/>
            <p:nvPr/>
          </p:nvSpPr>
          <p:spPr>
            <a:xfrm>
              <a:off x="7652656" y="2632447"/>
              <a:ext cx="66049" cy="1206914"/>
            </a:xfrm>
            <a:custGeom>
              <a:avLst/>
              <a:gdLst/>
              <a:ahLst/>
              <a:cxnLst/>
              <a:rect l="l" t="t" r="r" b="b"/>
              <a:pathLst>
                <a:path w="66049" h="1206914" extrusionOk="0">
                  <a:moveTo>
                    <a:pt x="0" y="0"/>
                  </a:moveTo>
                  <a:lnTo>
                    <a:pt x="66049" y="0"/>
                  </a:lnTo>
                  <a:lnTo>
                    <a:pt x="66049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318" name="Google Shape;318;p1" descr="image.png"/>
            <p:cNvPicPr preferRelativeResize="0"/>
            <p:nvPr/>
          </p:nvPicPr>
          <p:blipFill rotWithShape="1">
            <a:blip r:embed="rId6">
              <a:alphaModFix/>
            </a:blip>
            <a:srcRect/>
            <a:stretch/>
          </p:blipFill>
          <p:spPr>
            <a:xfrm>
              <a:off x="7721707" y="2635449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19" name="Google Shape;319;p1"/>
            <p:cNvSpPr txBox="1"/>
            <p:nvPr/>
          </p:nvSpPr>
          <p:spPr>
            <a:xfrm>
              <a:off x="7781753" y="2887826"/>
              <a:ext cx="200793" cy="14384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10¹</a:t>
              </a:r>
              <a:endParaRPr dirty="0"/>
            </a:p>
          </p:txBody>
        </p:sp>
      </p:grpSp>
      <p:grpSp>
        <p:nvGrpSpPr>
          <p:cNvPr id="320" name="Google Shape;320;p1"/>
          <p:cNvGrpSpPr/>
          <p:nvPr/>
        </p:nvGrpSpPr>
        <p:grpSpPr>
          <a:xfrm>
            <a:off x="3469853" y="3692791"/>
            <a:ext cx="1525781" cy="1288741"/>
            <a:chOff x="7996043" y="2473326"/>
            <a:chExt cx="2037413" cy="1720885"/>
          </a:xfrm>
        </p:grpSpPr>
        <p:pic>
          <p:nvPicPr>
            <p:cNvPr id="321" name="Google Shape;321;p1" descr="image.png"/>
            <p:cNvPicPr preferRelativeResize="0"/>
            <p:nvPr/>
          </p:nvPicPr>
          <p:blipFill rotWithShape="1">
            <a:blip r:embed="rId19">
              <a:alphaModFix/>
            </a:blip>
            <a:srcRect/>
            <a:stretch/>
          </p:blipFill>
          <p:spPr>
            <a:xfrm>
              <a:off x="8081980" y="2473326"/>
              <a:ext cx="1951476" cy="170529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22" name="Google Shape;322;p1"/>
            <p:cNvSpPr/>
            <p:nvPr/>
          </p:nvSpPr>
          <p:spPr>
            <a:xfrm>
              <a:off x="8421236" y="2632447"/>
              <a:ext cx="1206914" cy="1206914"/>
            </a:xfrm>
            <a:custGeom>
              <a:avLst/>
              <a:gdLst/>
              <a:ahLst/>
              <a:cxnLst/>
              <a:rect l="l" t="t" r="r" b="b"/>
              <a:pathLst>
                <a:path w="1206914" h="1206914" extrusionOk="0">
                  <a:moveTo>
                    <a:pt x="0" y="0"/>
                  </a:moveTo>
                  <a:lnTo>
                    <a:pt x="1206914" y="0"/>
                  </a:lnTo>
                  <a:lnTo>
                    <a:pt x="1206914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23" name="Google Shape;323;p1"/>
            <p:cNvSpPr txBox="1"/>
            <p:nvPr/>
          </p:nvSpPr>
          <p:spPr>
            <a:xfrm>
              <a:off x="8838553" y="4029818"/>
              <a:ext cx="574544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1</a:t>
              </a:r>
              <a:endParaRPr dirty="0"/>
            </a:p>
          </p:txBody>
        </p:sp>
        <p:sp>
          <p:nvSpPr>
            <p:cNvPr id="324" name="Google Shape;324;p1"/>
            <p:cNvSpPr txBox="1"/>
            <p:nvPr/>
          </p:nvSpPr>
          <p:spPr>
            <a:xfrm rot="16200000">
              <a:off x="7773101" y="3107838"/>
              <a:ext cx="610277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2</a:t>
              </a:r>
              <a:endParaRPr dirty="0"/>
            </a:p>
          </p:txBody>
        </p:sp>
        <p:pic>
          <p:nvPicPr>
            <p:cNvPr id="325" name="Google Shape;325;p1" descr="image.png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8424238" y="3842362"/>
              <a:ext cx="1194903" cy="180135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326" name="Google Shape;326;p1"/>
            <p:cNvGrpSpPr/>
            <p:nvPr/>
          </p:nvGrpSpPr>
          <p:grpSpPr>
            <a:xfrm>
              <a:off x="8376202" y="3917606"/>
              <a:ext cx="1353283" cy="145531"/>
              <a:chOff x="8376202" y="3917606"/>
              <a:chExt cx="1353283" cy="145531"/>
            </a:xfrm>
          </p:grpSpPr>
          <p:sp>
            <p:nvSpPr>
              <p:cNvPr id="327" name="Google Shape;327;p1"/>
              <p:cNvSpPr txBox="1"/>
              <p:nvPr/>
            </p:nvSpPr>
            <p:spPr>
              <a:xfrm>
                <a:off x="8376202" y="3919294"/>
                <a:ext cx="190807" cy="1438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1</a:t>
                </a:r>
                <a:endParaRPr dirty="0"/>
              </a:p>
            </p:txBody>
          </p:sp>
          <p:sp>
            <p:nvSpPr>
              <p:cNvPr id="328" name="Google Shape;328;p1"/>
              <p:cNvSpPr txBox="1"/>
              <p:nvPr/>
            </p:nvSpPr>
            <p:spPr>
              <a:xfrm>
                <a:off x="8664418" y="3917606"/>
                <a:ext cx="190807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36</a:t>
                </a:r>
                <a:endParaRPr/>
              </a:p>
            </p:txBody>
          </p:sp>
          <p:sp>
            <p:nvSpPr>
              <p:cNvPr id="329" name="Google Shape;329;p1"/>
              <p:cNvSpPr txBox="1"/>
              <p:nvPr/>
            </p:nvSpPr>
            <p:spPr>
              <a:xfrm>
                <a:off x="8970651" y="3917699"/>
                <a:ext cx="182965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0.4</a:t>
                </a:r>
                <a:endParaRPr/>
              </a:p>
            </p:txBody>
          </p:sp>
          <p:sp>
            <p:nvSpPr>
              <p:cNvPr id="330" name="Google Shape;330;p1"/>
              <p:cNvSpPr txBox="1"/>
              <p:nvPr/>
            </p:nvSpPr>
            <p:spPr>
              <a:xfrm>
                <a:off x="9276879" y="3917606"/>
                <a:ext cx="146372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6</a:t>
                </a:r>
                <a:endParaRPr/>
              </a:p>
            </p:txBody>
          </p:sp>
          <p:sp>
            <p:nvSpPr>
              <p:cNvPr id="331" name="Google Shape;331;p1"/>
              <p:cNvSpPr txBox="1"/>
              <p:nvPr/>
            </p:nvSpPr>
            <p:spPr>
              <a:xfrm>
                <a:off x="9583113" y="3918450"/>
                <a:ext cx="146372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2</a:t>
                </a:r>
                <a:endParaRPr/>
              </a:p>
            </p:txBody>
          </p:sp>
        </p:grpSp>
        <p:pic>
          <p:nvPicPr>
            <p:cNvPr id="332" name="Google Shape;332;p1" descr="image.png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8238098" y="2635449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333" name="Google Shape;333;p1"/>
            <p:cNvGrpSpPr/>
            <p:nvPr/>
          </p:nvGrpSpPr>
          <p:grpSpPr>
            <a:xfrm>
              <a:off x="8143695" y="2602706"/>
              <a:ext cx="250685" cy="1338655"/>
              <a:chOff x="8143695" y="2602706"/>
              <a:chExt cx="250685" cy="1338655"/>
            </a:xfrm>
          </p:grpSpPr>
          <p:sp>
            <p:nvSpPr>
              <p:cNvPr id="334" name="Google Shape;334;p1"/>
              <p:cNvSpPr txBox="1"/>
              <p:nvPr/>
            </p:nvSpPr>
            <p:spPr>
              <a:xfrm>
                <a:off x="8172080" y="3797517"/>
                <a:ext cx="210347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9</a:t>
                </a:r>
                <a:endParaRPr/>
              </a:p>
            </p:txBody>
          </p:sp>
          <p:sp>
            <p:nvSpPr>
              <p:cNvPr id="335" name="Google Shape;335;p1"/>
              <p:cNvSpPr txBox="1"/>
              <p:nvPr/>
            </p:nvSpPr>
            <p:spPr>
              <a:xfrm>
                <a:off x="8172081" y="3503478"/>
                <a:ext cx="210347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40</a:t>
                </a:r>
                <a:endParaRPr/>
              </a:p>
            </p:txBody>
          </p:sp>
          <p:sp>
            <p:nvSpPr>
              <p:cNvPr id="336" name="Google Shape;336;p1"/>
              <p:cNvSpPr txBox="1"/>
              <p:nvPr/>
            </p:nvSpPr>
            <p:spPr>
              <a:xfrm>
                <a:off x="8143695" y="3203064"/>
                <a:ext cx="250685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0.6</a:t>
                </a:r>
                <a:endParaRPr/>
              </a:p>
            </p:txBody>
          </p:sp>
          <p:sp>
            <p:nvSpPr>
              <p:cNvPr id="337" name="Google Shape;337;p1"/>
              <p:cNvSpPr txBox="1"/>
              <p:nvPr/>
            </p:nvSpPr>
            <p:spPr>
              <a:xfrm>
                <a:off x="8208693" y="2902837"/>
                <a:ext cx="161361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9</a:t>
                </a:r>
                <a:endParaRPr dirty="0"/>
              </a:p>
            </p:txBody>
          </p:sp>
          <p:sp>
            <p:nvSpPr>
              <p:cNvPr id="338" name="Google Shape;338;p1"/>
              <p:cNvSpPr txBox="1"/>
              <p:nvPr/>
            </p:nvSpPr>
            <p:spPr>
              <a:xfrm>
                <a:off x="8208693" y="2602706"/>
                <a:ext cx="161360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8</a:t>
                </a:r>
                <a:endParaRPr dirty="0"/>
              </a:p>
            </p:txBody>
          </p:sp>
        </p:grpSp>
        <p:sp>
          <p:nvSpPr>
            <p:cNvPr id="339" name="Google Shape;339;p1"/>
            <p:cNvSpPr/>
            <p:nvPr/>
          </p:nvSpPr>
          <p:spPr>
            <a:xfrm>
              <a:off x="9631152" y="2635449"/>
              <a:ext cx="60045" cy="1200908"/>
            </a:xfrm>
            <a:prstGeom prst="rect">
              <a:avLst/>
            </a:prstGeom>
            <a:gradFill>
              <a:gsLst>
                <a:gs pos="0">
                  <a:srgbClr val="00007F"/>
                </a:gs>
                <a:gs pos="1562">
                  <a:srgbClr val="000091"/>
                </a:gs>
                <a:gs pos="3125">
                  <a:srgbClr val="0000A3"/>
                </a:gs>
                <a:gs pos="4688">
                  <a:srgbClr val="0000B6"/>
                </a:gs>
                <a:gs pos="6250">
                  <a:srgbClr val="0000C8"/>
                </a:gs>
                <a:gs pos="7812">
                  <a:srgbClr val="0000DA"/>
                </a:gs>
                <a:gs pos="9375">
                  <a:srgbClr val="0000EC"/>
                </a:gs>
                <a:gs pos="10938">
                  <a:srgbClr val="0000FE"/>
                </a:gs>
                <a:gs pos="12500">
                  <a:srgbClr val="0000FF"/>
                </a:gs>
                <a:gs pos="14062">
                  <a:srgbClr val="0010FF"/>
                </a:gs>
                <a:gs pos="15625">
                  <a:srgbClr val="0020FF"/>
                </a:gs>
                <a:gs pos="17188">
                  <a:srgbClr val="0030FF"/>
                </a:gs>
                <a:gs pos="18750">
                  <a:srgbClr val="0040FF"/>
                </a:gs>
                <a:gs pos="20312">
                  <a:srgbClr val="0050FF"/>
                </a:gs>
                <a:gs pos="21875">
                  <a:srgbClr val="0060FF"/>
                </a:gs>
                <a:gs pos="23438">
                  <a:srgbClr val="0070FF"/>
                </a:gs>
                <a:gs pos="25000">
                  <a:srgbClr val="0084FF"/>
                </a:gs>
                <a:gs pos="26562">
                  <a:srgbClr val="0094FF"/>
                </a:gs>
                <a:gs pos="28125">
                  <a:srgbClr val="00A4FF"/>
                </a:gs>
                <a:gs pos="29688">
                  <a:srgbClr val="00B4FF"/>
                </a:gs>
                <a:gs pos="31250">
                  <a:srgbClr val="00C4FF"/>
                </a:gs>
                <a:gs pos="32812">
                  <a:srgbClr val="00D4FF"/>
                </a:gs>
                <a:gs pos="34375">
                  <a:srgbClr val="00E4F7"/>
                </a:gs>
                <a:gs pos="35938">
                  <a:srgbClr val="0CF4EA"/>
                </a:gs>
                <a:gs pos="37500">
                  <a:srgbClr val="18FFDD"/>
                </a:gs>
                <a:gs pos="39062">
                  <a:srgbClr val="25FFD0"/>
                </a:gs>
                <a:gs pos="40625">
                  <a:srgbClr val="32FFC3"/>
                </a:gs>
                <a:gs pos="42188">
                  <a:srgbClr val="3FFFB7"/>
                </a:gs>
                <a:gs pos="43750">
                  <a:srgbClr val="4CFFAA"/>
                </a:gs>
                <a:gs pos="45312">
                  <a:srgbClr val="59FF9D"/>
                </a:gs>
                <a:gs pos="46875">
                  <a:srgbClr val="66FF90"/>
                </a:gs>
                <a:gs pos="48438">
                  <a:srgbClr val="73FF83"/>
                </a:gs>
                <a:gs pos="50000">
                  <a:srgbClr val="83FF73"/>
                </a:gs>
                <a:gs pos="51562">
                  <a:srgbClr val="90FF66"/>
                </a:gs>
                <a:gs pos="53125">
                  <a:srgbClr val="9DFF59"/>
                </a:gs>
                <a:gs pos="54688">
                  <a:srgbClr val="AAFF4C"/>
                </a:gs>
                <a:gs pos="56250">
                  <a:srgbClr val="B7FF3F"/>
                </a:gs>
                <a:gs pos="57812">
                  <a:srgbClr val="C3FF32"/>
                </a:gs>
                <a:gs pos="59375">
                  <a:srgbClr val="D0FF25"/>
                </a:gs>
                <a:gs pos="60938">
                  <a:srgbClr val="DDFF18"/>
                </a:gs>
                <a:gs pos="62500">
                  <a:srgbClr val="EAFF0C"/>
                </a:gs>
                <a:gs pos="64061">
                  <a:srgbClr val="F7F400"/>
                </a:gs>
                <a:gs pos="65625">
                  <a:srgbClr val="FFE500"/>
                </a:gs>
                <a:gs pos="67188">
                  <a:srgbClr val="FFD700"/>
                </a:gs>
                <a:gs pos="68750">
                  <a:srgbClr val="FFC800"/>
                </a:gs>
                <a:gs pos="70312">
                  <a:srgbClr val="FFB900"/>
                </a:gs>
                <a:gs pos="71875">
                  <a:srgbClr val="FFAA00"/>
                </a:gs>
                <a:gs pos="73438">
                  <a:srgbClr val="FF9B00"/>
                </a:gs>
                <a:gs pos="75000">
                  <a:srgbClr val="FF8900"/>
                </a:gs>
                <a:gs pos="76562">
                  <a:srgbClr val="FF7A00"/>
                </a:gs>
                <a:gs pos="78125">
                  <a:srgbClr val="FF6B00"/>
                </a:gs>
                <a:gs pos="79688">
                  <a:srgbClr val="FF5C00"/>
                </a:gs>
                <a:gs pos="81250">
                  <a:srgbClr val="FF4D00"/>
                </a:gs>
                <a:gs pos="82812">
                  <a:srgbClr val="FF3F00"/>
                </a:gs>
                <a:gs pos="84375">
                  <a:srgbClr val="FF3000"/>
                </a:gs>
                <a:gs pos="85938">
                  <a:srgbClr val="FF2100"/>
                </a:gs>
                <a:gs pos="87500">
                  <a:srgbClr val="FE1200"/>
                </a:gs>
                <a:gs pos="89062">
                  <a:srgbClr val="EC0300"/>
                </a:gs>
                <a:gs pos="90625">
                  <a:srgbClr val="DA0000"/>
                </a:gs>
                <a:gs pos="92188">
                  <a:srgbClr val="C80000"/>
                </a:gs>
                <a:gs pos="93750">
                  <a:srgbClr val="B60000"/>
                </a:gs>
                <a:gs pos="95312">
                  <a:srgbClr val="A30000"/>
                </a:gs>
                <a:gs pos="96875">
                  <a:srgbClr val="910000"/>
                </a:gs>
                <a:gs pos="98438">
                  <a:srgbClr val="7F0000"/>
                </a:gs>
                <a:gs pos="100000">
                  <a:srgbClr val="7F0000"/>
                </a:gs>
              </a:gsLst>
              <a:lin ang="16200000" scaled="0"/>
            </a:gra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40" name="Google Shape;340;p1"/>
            <p:cNvSpPr/>
            <p:nvPr/>
          </p:nvSpPr>
          <p:spPr>
            <a:xfrm>
              <a:off x="9628150" y="2632447"/>
              <a:ext cx="66050" cy="1206914"/>
            </a:xfrm>
            <a:custGeom>
              <a:avLst/>
              <a:gdLst/>
              <a:ahLst/>
              <a:cxnLst/>
              <a:rect l="l" t="t" r="r" b="b"/>
              <a:pathLst>
                <a:path w="66050" h="1206914" extrusionOk="0">
                  <a:moveTo>
                    <a:pt x="0" y="0"/>
                  </a:moveTo>
                  <a:lnTo>
                    <a:pt x="66050" y="0"/>
                  </a:lnTo>
                  <a:lnTo>
                    <a:pt x="66050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341" name="Google Shape;341;p1" descr="image.png"/>
            <p:cNvPicPr preferRelativeResize="0"/>
            <p:nvPr/>
          </p:nvPicPr>
          <p:blipFill rotWithShape="1">
            <a:blip r:embed="rId6">
              <a:alphaModFix/>
            </a:blip>
            <a:srcRect/>
            <a:stretch/>
          </p:blipFill>
          <p:spPr>
            <a:xfrm>
              <a:off x="9697202" y="2635449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42" name="Google Shape;342;p1"/>
            <p:cNvSpPr txBox="1"/>
            <p:nvPr/>
          </p:nvSpPr>
          <p:spPr>
            <a:xfrm>
              <a:off x="9757246" y="2887827"/>
              <a:ext cx="189465" cy="14384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10¹</a:t>
              </a:r>
              <a:endParaRPr dirty="0"/>
            </a:p>
          </p:txBody>
        </p:sp>
      </p:grpSp>
      <p:grpSp>
        <p:nvGrpSpPr>
          <p:cNvPr id="343" name="Google Shape;343;p1"/>
          <p:cNvGrpSpPr/>
          <p:nvPr/>
        </p:nvGrpSpPr>
        <p:grpSpPr>
          <a:xfrm>
            <a:off x="4956360" y="3690848"/>
            <a:ext cx="1530388" cy="1288739"/>
            <a:chOff x="9965390" y="2473326"/>
            <a:chExt cx="2043561" cy="1720884"/>
          </a:xfrm>
        </p:grpSpPr>
        <p:pic>
          <p:nvPicPr>
            <p:cNvPr id="344" name="Google Shape;344;p1" descr="image.png"/>
            <p:cNvPicPr preferRelativeResize="0"/>
            <p:nvPr/>
          </p:nvPicPr>
          <p:blipFill rotWithShape="1">
            <a:blip r:embed="rId20">
              <a:alphaModFix/>
            </a:blip>
            <a:srcRect/>
            <a:stretch/>
          </p:blipFill>
          <p:spPr>
            <a:xfrm>
              <a:off x="10057475" y="2473326"/>
              <a:ext cx="1951476" cy="170529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45" name="Google Shape;345;p1"/>
            <p:cNvSpPr/>
            <p:nvPr/>
          </p:nvSpPr>
          <p:spPr>
            <a:xfrm>
              <a:off x="10396732" y="2632447"/>
              <a:ext cx="1206913" cy="1206914"/>
            </a:xfrm>
            <a:custGeom>
              <a:avLst/>
              <a:gdLst/>
              <a:ahLst/>
              <a:cxnLst/>
              <a:rect l="l" t="t" r="r" b="b"/>
              <a:pathLst>
                <a:path w="1206913" h="1206914" extrusionOk="0">
                  <a:moveTo>
                    <a:pt x="0" y="0"/>
                  </a:moveTo>
                  <a:lnTo>
                    <a:pt x="1206913" y="0"/>
                  </a:lnTo>
                  <a:lnTo>
                    <a:pt x="1206913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46" name="Google Shape;346;p1"/>
            <p:cNvSpPr txBox="1"/>
            <p:nvPr/>
          </p:nvSpPr>
          <p:spPr>
            <a:xfrm>
              <a:off x="10814048" y="4029817"/>
              <a:ext cx="586469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1</a:t>
              </a:r>
              <a:endParaRPr dirty="0"/>
            </a:p>
          </p:txBody>
        </p:sp>
        <p:sp>
          <p:nvSpPr>
            <p:cNvPr id="347" name="Google Shape;347;p1"/>
            <p:cNvSpPr txBox="1"/>
            <p:nvPr/>
          </p:nvSpPr>
          <p:spPr>
            <a:xfrm rot="16200000">
              <a:off x="9726871" y="3092263"/>
              <a:ext cx="641431" cy="1643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optsne_2</a:t>
              </a:r>
              <a:endParaRPr dirty="0"/>
            </a:p>
          </p:txBody>
        </p:sp>
        <p:pic>
          <p:nvPicPr>
            <p:cNvPr id="348" name="Google Shape;348;p1" descr="image.png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10399734" y="3842362"/>
              <a:ext cx="1194903" cy="180135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349" name="Google Shape;349;p1"/>
            <p:cNvGrpSpPr/>
            <p:nvPr/>
          </p:nvGrpSpPr>
          <p:grpSpPr>
            <a:xfrm>
              <a:off x="10351697" y="3917607"/>
              <a:ext cx="1379151" cy="144352"/>
              <a:chOff x="10351697" y="3917607"/>
              <a:chExt cx="1379151" cy="144352"/>
            </a:xfrm>
          </p:grpSpPr>
          <p:sp>
            <p:nvSpPr>
              <p:cNvPr id="350" name="Google Shape;350;p1"/>
              <p:cNvSpPr txBox="1"/>
              <p:nvPr/>
            </p:nvSpPr>
            <p:spPr>
              <a:xfrm>
                <a:off x="10351697" y="3919295"/>
                <a:ext cx="224527" cy="14266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1</a:t>
                </a:r>
                <a:endParaRPr dirty="0"/>
              </a:p>
            </p:txBody>
          </p:sp>
          <p:sp>
            <p:nvSpPr>
              <p:cNvPr id="351" name="Google Shape;351;p1"/>
              <p:cNvSpPr txBox="1"/>
              <p:nvPr/>
            </p:nvSpPr>
            <p:spPr>
              <a:xfrm>
                <a:off x="10639914" y="3917607"/>
                <a:ext cx="224527" cy="142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36</a:t>
                </a:r>
                <a:endParaRPr/>
              </a:p>
            </p:txBody>
          </p:sp>
          <p:sp>
            <p:nvSpPr>
              <p:cNvPr id="352" name="Google Shape;352;p1"/>
              <p:cNvSpPr txBox="1"/>
              <p:nvPr/>
            </p:nvSpPr>
            <p:spPr>
              <a:xfrm>
                <a:off x="10946144" y="3917700"/>
                <a:ext cx="215298" cy="142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0.4</a:t>
                </a:r>
                <a:endParaRPr/>
              </a:p>
            </p:txBody>
          </p:sp>
          <p:sp>
            <p:nvSpPr>
              <p:cNvPr id="353" name="Google Shape;353;p1"/>
              <p:cNvSpPr txBox="1"/>
              <p:nvPr/>
            </p:nvSpPr>
            <p:spPr>
              <a:xfrm>
                <a:off x="11252379" y="3917607"/>
                <a:ext cx="172238" cy="142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6</a:t>
                </a:r>
                <a:endParaRPr/>
              </a:p>
            </p:txBody>
          </p:sp>
          <p:sp>
            <p:nvSpPr>
              <p:cNvPr id="354" name="Google Shape;354;p1"/>
              <p:cNvSpPr txBox="1"/>
              <p:nvPr/>
            </p:nvSpPr>
            <p:spPr>
              <a:xfrm>
                <a:off x="11558610" y="3918451"/>
                <a:ext cx="172238" cy="142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2</a:t>
                </a:r>
                <a:endParaRPr/>
              </a:p>
            </p:txBody>
          </p:sp>
        </p:grpSp>
        <p:pic>
          <p:nvPicPr>
            <p:cNvPr id="355" name="Google Shape;355;p1" descr="image.png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10213593" y="2635449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356" name="Google Shape;356;p1"/>
            <p:cNvGrpSpPr/>
            <p:nvPr/>
          </p:nvGrpSpPr>
          <p:grpSpPr>
            <a:xfrm>
              <a:off x="10114783" y="2602706"/>
              <a:ext cx="267082" cy="1338655"/>
              <a:chOff x="10114783" y="2602706"/>
              <a:chExt cx="267082" cy="1338655"/>
            </a:xfrm>
          </p:grpSpPr>
          <p:sp>
            <p:nvSpPr>
              <p:cNvPr id="357" name="Google Shape;357;p1"/>
              <p:cNvSpPr txBox="1"/>
              <p:nvPr/>
            </p:nvSpPr>
            <p:spPr>
              <a:xfrm>
                <a:off x="10167821" y="3797517"/>
                <a:ext cx="214044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79</a:t>
                </a:r>
                <a:endParaRPr dirty="0"/>
              </a:p>
            </p:txBody>
          </p:sp>
          <p:sp>
            <p:nvSpPr>
              <p:cNvPr id="358" name="Google Shape;358;p1"/>
              <p:cNvSpPr txBox="1"/>
              <p:nvPr/>
            </p:nvSpPr>
            <p:spPr>
              <a:xfrm>
                <a:off x="10175556" y="3503480"/>
                <a:ext cx="182366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40</a:t>
                </a:r>
                <a:endParaRPr/>
              </a:p>
            </p:txBody>
          </p:sp>
          <p:sp>
            <p:nvSpPr>
              <p:cNvPr id="359" name="Google Shape;359;p1"/>
              <p:cNvSpPr txBox="1"/>
              <p:nvPr/>
            </p:nvSpPr>
            <p:spPr>
              <a:xfrm>
                <a:off x="10114783" y="3203063"/>
                <a:ext cx="255090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-0.6</a:t>
                </a:r>
                <a:endParaRPr/>
              </a:p>
            </p:txBody>
          </p:sp>
          <p:sp>
            <p:nvSpPr>
              <p:cNvPr id="360" name="Google Shape;360;p1"/>
              <p:cNvSpPr txBox="1"/>
              <p:nvPr/>
            </p:nvSpPr>
            <p:spPr>
              <a:xfrm>
                <a:off x="10205653" y="2902839"/>
                <a:ext cx="139897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39</a:t>
                </a:r>
                <a:endParaRPr dirty="0"/>
              </a:p>
            </p:txBody>
          </p:sp>
          <p:sp>
            <p:nvSpPr>
              <p:cNvPr id="361" name="Google Shape;361;p1"/>
              <p:cNvSpPr txBox="1"/>
              <p:nvPr/>
            </p:nvSpPr>
            <p:spPr>
              <a:xfrm>
                <a:off x="10181353" y="2602706"/>
                <a:ext cx="164196" cy="1438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0" tIns="0" rIns="0" bIns="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700" b="0" i="0" u="none" strike="noStrike" cap="none" dirty="0">
                    <a:solidFill>
                      <a:srgbClr val="000000"/>
                    </a:solidFill>
                    <a:latin typeface="Noto Sans Light"/>
                    <a:ea typeface="Noto Sans Light"/>
                    <a:cs typeface="Noto Sans Light"/>
                    <a:sym typeface="Noto Sans Light"/>
                  </a:rPr>
                  <a:t>78</a:t>
                </a:r>
                <a:endParaRPr dirty="0"/>
              </a:p>
            </p:txBody>
          </p:sp>
        </p:grpSp>
        <p:sp>
          <p:nvSpPr>
            <p:cNvPr id="362" name="Google Shape;362;p1"/>
            <p:cNvSpPr/>
            <p:nvPr/>
          </p:nvSpPr>
          <p:spPr>
            <a:xfrm>
              <a:off x="11606647" y="2635449"/>
              <a:ext cx="60045" cy="1200908"/>
            </a:xfrm>
            <a:prstGeom prst="rect">
              <a:avLst/>
            </a:prstGeom>
            <a:gradFill>
              <a:gsLst>
                <a:gs pos="0">
                  <a:srgbClr val="00007F"/>
                </a:gs>
                <a:gs pos="1562">
                  <a:srgbClr val="000091"/>
                </a:gs>
                <a:gs pos="3125">
                  <a:srgbClr val="0000A3"/>
                </a:gs>
                <a:gs pos="4688">
                  <a:srgbClr val="0000B6"/>
                </a:gs>
                <a:gs pos="6250">
                  <a:srgbClr val="0000C8"/>
                </a:gs>
                <a:gs pos="7812">
                  <a:srgbClr val="0000DA"/>
                </a:gs>
                <a:gs pos="9375">
                  <a:srgbClr val="0000EC"/>
                </a:gs>
                <a:gs pos="10938">
                  <a:srgbClr val="0000FE"/>
                </a:gs>
                <a:gs pos="12500">
                  <a:srgbClr val="0000FF"/>
                </a:gs>
                <a:gs pos="14062">
                  <a:srgbClr val="0010FF"/>
                </a:gs>
                <a:gs pos="15625">
                  <a:srgbClr val="0020FF"/>
                </a:gs>
                <a:gs pos="17188">
                  <a:srgbClr val="0030FF"/>
                </a:gs>
                <a:gs pos="18750">
                  <a:srgbClr val="0040FF"/>
                </a:gs>
                <a:gs pos="20312">
                  <a:srgbClr val="0050FF"/>
                </a:gs>
                <a:gs pos="21875">
                  <a:srgbClr val="0060FF"/>
                </a:gs>
                <a:gs pos="23438">
                  <a:srgbClr val="0070FF"/>
                </a:gs>
                <a:gs pos="25000">
                  <a:srgbClr val="0084FF"/>
                </a:gs>
                <a:gs pos="26562">
                  <a:srgbClr val="0094FF"/>
                </a:gs>
                <a:gs pos="28125">
                  <a:srgbClr val="00A4FF"/>
                </a:gs>
                <a:gs pos="29688">
                  <a:srgbClr val="00B4FF"/>
                </a:gs>
                <a:gs pos="31250">
                  <a:srgbClr val="00C4FF"/>
                </a:gs>
                <a:gs pos="32812">
                  <a:srgbClr val="00D4FF"/>
                </a:gs>
                <a:gs pos="34375">
                  <a:srgbClr val="00E4F7"/>
                </a:gs>
                <a:gs pos="35938">
                  <a:srgbClr val="0CF4EA"/>
                </a:gs>
                <a:gs pos="37500">
                  <a:srgbClr val="18FFDD"/>
                </a:gs>
                <a:gs pos="39062">
                  <a:srgbClr val="25FFD0"/>
                </a:gs>
                <a:gs pos="40625">
                  <a:srgbClr val="32FFC3"/>
                </a:gs>
                <a:gs pos="42188">
                  <a:srgbClr val="3FFFB7"/>
                </a:gs>
                <a:gs pos="43750">
                  <a:srgbClr val="4CFFAA"/>
                </a:gs>
                <a:gs pos="45312">
                  <a:srgbClr val="59FF9D"/>
                </a:gs>
                <a:gs pos="46875">
                  <a:srgbClr val="66FF90"/>
                </a:gs>
                <a:gs pos="48438">
                  <a:srgbClr val="73FF83"/>
                </a:gs>
                <a:gs pos="50000">
                  <a:srgbClr val="83FF73"/>
                </a:gs>
                <a:gs pos="51562">
                  <a:srgbClr val="90FF66"/>
                </a:gs>
                <a:gs pos="53125">
                  <a:srgbClr val="9DFF59"/>
                </a:gs>
                <a:gs pos="54688">
                  <a:srgbClr val="AAFF4C"/>
                </a:gs>
                <a:gs pos="56250">
                  <a:srgbClr val="B7FF3F"/>
                </a:gs>
                <a:gs pos="57812">
                  <a:srgbClr val="C3FF32"/>
                </a:gs>
                <a:gs pos="59375">
                  <a:srgbClr val="D0FF25"/>
                </a:gs>
                <a:gs pos="60938">
                  <a:srgbClr val="DDFF18"/>
                </a:gs>
                <a:gs pos="62500">
                  <a:srgbClr val="EAFF0C"/>
                </a:gs>
                <a:gs pos="64061">
                  <a:srgbClr val="F7F400"/>
                </a:gs>
                <a:gs pos="65625">
                  <a:srgbClr val="FFE500"/>
                </a:gs>
                <a:gs pos="67188">
                  <a:srgbClr val="FFD700"/>
                </a:gs>
                <a:gs pos="68750">
                  <a:srgbClr val="FFC800"/>
                </a:gs>
                <a:gs pos="70312">
                  <a:srgbClr val="FFB900"/>
                </a:gs>
                <a:gs pos="71875">
                  <a:srgbClr val="FFAA00"/>
                </a:gs>
                <a:gs pos="73438">
                  <a:srgbClr val="FF9B00"/>
                </a:gs>
                <a:gs pos="75000">
                  <a:srgbClr val="FF8900"/>
                </a:gs>
                <a:gs pos="76562">
                  <a:srgbClr val="FF7A00"/>
                </a:gs>
                <a:gs pos="78125">
                  <a:srgbClr val="FF6B00"/>
                </a:gs>
                <a:gs pos="79688">
                  <a:srgbClr val="FF5C00"/>
                </a:gs>
                <a:gs pos="81250">
                  <a:srgbClr val="FF4D00"/>
                </a:gs>
                <a:gs pos="82812">
                  <a:srgbClr val="FF3F00"/>
                </a:gs>
                <a:gs pos="84375">
                  <a:srgbClr val="FF3000"/>
                </a:gs>
                <a:gs pos="85938">
                  <a:srgbClr val="FF2100"/>
                </a:gs>
                <a:gs pos="87500">
                  <a:srgbClr val="FE1200"/>
                </a:gs>
                <a:gs pos="89062">
                  <a:srgbClr val="EC0300"/>
                </a:gs>
                <a:gs pos="90625">
                  <a:srgbClr val="DA0000"/>
                </a:gs>
                <a:gs pos="92188">
                  <a:srgbClr val="C80000"/>
                </a:gs>
                <a:gs pos="93750">
                  <a:srgbClr val="B60000"/>
                </a:gs>
                <a:gs pos="95312">
                  <a:srgbClr val="A30000"/>
                </a:gs>
                <a:gs pos="96875">
                  <a:srgbClr val="910000"/>
                </a:gs>
                <a:gs pos="98438">
                  <a:srgbClr val="7F0000"/>
                </a:gs>
                <a:gs pos="100000">
                  <a:srgbClr val="7F0000"/>
                </a:gs>
              </a:gsLst>
              <a:lin ang="16200000" scaled="0"/>
            </a:gra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63" name="Google Shape;363;p1"/>
            <p:cNvSpPr/>
            <p:nvPr/>
          </p:nvSpPr>
          <p:spPr>
            <a:xfrm>
              <a:off x="11603645" y="2632447"/>
              <a:ext cx="66050" cy="1206914"/>
            </a:xfrm>
            <a:custGeom>
              <a:avLst/>
              <a:gdLst/>
              <a:ahLst/>
              <a:cxnLst/>
              <a:rect l="l" t="t" r="r" b="b"/>
              <a:pathLst>
                <a:path w="66050" h="1206914" extrusionOk="0">
                  <a:moveTo>
                    <a:pt x="0" y="0"/>
                  </a:moveTo>
                  <a:lnTo>
                    <a:pt x="66050" y="0"/>
                  </a:lnTo>
                  <a:lnTo>
                    <a:pt x="66050" y="1206914"/>
                  </a:lnTo>
                  <a:lnTo>
                    <a:pt x="0" y="1206914"/>
                  </a:lnTo>
                  <a:close/>
                </a:path>
              </a:pathLst>
            </a:custGeom>
            <a:noFill/>
            <a:ln w="9525" cap="flat" cmpd="sng">
              <a:solidFill>
                <a:srgbClr val="000000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364" name="Google Shape;364;p1" descr="image.png"/>
            <p:cNvPicPr preferRelativeResize="0"/>
            <p:nvPr/>
          </p:nvPicPr>
          <p:blipFill rotWithShape="1">
            <a:blip r:embed="rId11">
              <a:alphaModFix/>
            </a:blip>
            <a:srcRect/>
            <a:stretch/>
          </p:blipFill>
          <p:spPr>
            <a:xfrm>
              <a:off x="11672697" y="2635449"/>
              <a:ext cx="180135" cy="119490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65" name="Google Shape;365;p1"/>
            <p:cNvSpPr txBox="1"/>
            <p:nvPr/>
          </p:nvSpPr>
          <p:spPr>
            <a:xfrm>
              <a:off x="11732741" y="2881823"/>
              <a:ext cx="178107" cy="14384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 dirty="0">
                  <a:solidFill>
                    <a:srgbClr val="000000"/>
                  </a:solidFill>
                  <a:latin typeface="Noto Sans Light"/>
                  <a:ea typeface="Noto Sans Light"/>
                  <a:cs typeface="Noto Sans Light"/>
                  <a:sym typeface="Noto Sans Light"/>
                </a:rPr>
                <a:t>10¹</a:t>
              </a:r>
              <a:endParaRPr dirty="0"/>
            </a:p>
          </p:txBody>
        </p:sp>
      </p:grpSp>
      <p:sp>
        <p:nvSpPr>
          <p:cNvPr id="366" name="Google Shape;366;p1"/>
          <p:cNvSpPr txBox="1"/>
          <p:nvPr/>
        </p:nvSpPr>
        <p:spPr>
          <a:xfrm>
            <a:off x="887681" y="1114691"/>
            <a:ext cx="288779" cy="1384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0" i="0" u="none" strike="noStrike" cap="none" dirty="0">
                <a:solidFill>
                  <a:srgbClr val="000000"/>
                </a:solidFill>
                <a:latin typeface="Noto Sans Light"/>
                <a:ea typeface="Noto Sans Light"/>
                <a:cs typeface="Noto Sans Light"/>
                <a:sym typeface="Noto Sans Light"/>
              </a:rPr>
              <a:t>CD4</a:t>
            </a:r>
            <a:endParaRPr sz="900" b="0" i="0" u="none" strike="noStrike" cap="none" dirty="0">
              <a:solidFill>
                <a:srgbClr val="000000"/>
              </a:solidFill>
              <a:latin typeface="Noto Sans Light"/>
              <a:ea typeface="Noto Sans Light"/>
              <a:cs typeface="Noto Sans Light"/>
              <a:sym typeface="Noto Sans Light"/>
            </a:endParaRPr>
          </a:p>
        </p:txBody>
      </p:sp>
      <p:sp>
        <p:nvSpPr>
          <p:cNvPr id="367" name="Google Shape;367;p1"/>
          <p:cNvSpPr txBox="1"/>
          <p:nvPr/>
        </p:nvSpPr>
        <p:spPr>
          <a:xfrm>
            <a:off x="2356263" y="1114385"/>
            <a:ext cx="247313" cy="1425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0" i="0" u="none" strike="noStrike" cap="none" dirty="0">
                <a:solidFill>
                  <a:srgbClr val="000000"/>
                </a:solidFill>
                <a:latin typeface="Noto Sans Light"/>
                <a:ea typeface="Noto Sans Light"/>
                <a:cs typeface="Noto Sans Light"/>
                <a:sym typeface="Noto Sans Light"/>
              </a:rPr>
              <a:t>CD8</a:t>
            </a:r>
            <a:endParaRPr sz="900" b="0" i="0" u="none" strike="noStrike" cap="none" dirty="0">
              <a:solidFill>
                <a:srgbClr val="000000"/>
              </a:solidFill>
              <a:latin typeface="Noto Sans Light"/>
              <a:ea typeface="Noto Sans Light"/>
              <a:cs typeface="Noto Sans Light"/>
              <a:sym typeface="Noto Sans Light"/>
            </a:endParaRPr>
          </a:p>
        </p:txBody>
      </p:sp>
      <p:sp>
        <p:nvSpPr>
          <p:cNvPr id="368" name="Google Shape;368;p1"/>
          <p:cNvSpPr txBox="1"/>
          <p:nvPr/>
        </p:nvSpPr>
        <p:spPr>
          <a:xfrm>
            <a:off x="3851725" y="1114908"/>
            <a:ext cx="318740" cy="1384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0" i="0" u="none" strike="noStrike" cap="none" dirty="0">
                <a:solidFill>
                  <a:srgbClr val="000000"/>
                </a:solidFill>
                <a:latin typeface="Noto Sans Light"/>
                <a:ea typeface="Noto Sans Light"/>
                <a:cs typeface="Noto Sans Light"/>
                <a:sym typeface="Noto Sans Light"/>
              </a:rPr>
              <a:t>CCR4</a:t>
            </a:r>
            <a:endParaRPr sz="900" b="0" i="0" u="none" strike="noStrike" cap="none" dirty="0">
              <a:solidFill>
                <a:srgbClr val="000000"/>
              </a:solidFill>
              <a:latin typeface="Noto Sans Light"/>
              <a:ea typeface="Noto Sans Light"/>
              <a:cs typeface="Noto Sans Light"/>
              <a:sym typeface="Noto Sans Light"/>
            </a:endParaRPr>
          </a:p>
        </p:txBody>
      </p:sp>
      <p:sp>
        <p:nvSpPr>
          <p:cNvPr id="369" name="Google Shape;369;p1"/>
          <p:cNvSpPr txBox="1"/>
          <p:nvPr/>
        </p:nvSpPr>
        <p:spPr>
          <a:xfrm>
            <a:off x="5323425" y="1110927"/>
            <a:ext cx="331285" cy="1384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0" i="0" u="none" strike="noStrike" cap="none" dirty="0">
                <a:solidFill>
                  <a:srgbClr val="000000"/>
                </a:solidFill>
                <a:latin typeface="Noto Sans Light"/>
                <a:ea typeface="Noto Sans Light"/>
                <a:cs typeface="Noto Sans Light"/>
                <a:sym typeface="Noto Sans Light"/>
              </a:rPr>
              <a:t>CD38</a:t>
            </a:r>
            <a:endParaRPr sz="900" b="0" i="0" u="none" strike="noStrike" cap="none" dirty="0">
              <a:solidFill>
                <a:srgbClr val="000000"/>
              </a:solidFill>
              <a:latin typeface="Noto Sans Light"/>
              <a:ea typeface="Noto Sans Light"/>
              <a:cs typeface="Noto Sans Light"/>
              <a:sym typeface="Noto Sans Light"/>
            </a:endParaRPr>
          </a:p>
        </p:txBody>
      </p:sp>
      <p:sp>
        <p:nvSpPr>
          <p:cNvPr id="370" name="Google Shape;370;p1"/>
          <p:cNvSpPr txBox="1"/>
          <p:nvPr/>
        </p:nvSpPr>
        <p:spPr>
          <a:xfrm>
            <a:off x="884136" y="2478615"/>
            <a:ext cx="356752" cy="1384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0" i="0" u="none" strike="noStrike" cap="none" dirty="0">
                <a:solidFill>
                  <a:srgbClr val="000000"/>
                </a:solidFill>
                <a:latin typeface="Noto Sans Light"/>
                <a:ea typeface="Noto Sans Light"/>
                <a:cs typeface="Noto Sans Light"/>
                <a:sym typeface="Noto Sans Light"/>
              </a:rPr>
              <a:t>CXCR3</a:t>
            </a:r>
            <a:endParaRPr sz="900" b="0" i="0" u="none" strike="noStrike" cap="none" dirty="0">
              <a:solidFill>
                <a:srgbClr val="000000"/>
              </a:solidFill>
              <a:latin typeface="Noto Sans Light"/>
              <a:ea typeface="Noto Sans Light"/>
              <a:cs typeface="Noto Sans Light"/>
              <a:sym typeface="Noto Sans Light"/>
            </a:endParaRPr>
          </a:p>
        </p:txBody>
      </p:sp>
      <p:sp>
        <p:nvSpPr>
          <p:cNvPr id="371" name="Google Shape;371;p1"/>
          <p:cNvSpPr txBox="1"/>
          <p:nvPr/>
        </p:nvSpPr>
        <p:spPr>
          <a:xfrm>
            <a:off x="2371511" y="2478367"/>
            <a:ext cx="355241" cy="1373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0" i="0" u="none" strike="noStrike" cap="none" dirty="0">
                <a:solidFill>
                  <a:srgbClr val="000000"/>
                </a:solidFill>
                <a:latin typeface="Noto Sans Light"/>
                <a:ea typeface="Noto Sans Light"/>
                <a:cs typeface="Noto Sans Light"/>
                <a:sym typeface="Noto Sans Light"/>
              </a:rPr>
              <a:t>CD127</a:t>
            </a:r>
            <a:endParaRPr sz="900" b="0" i="0" u="none" strike="noStrike" cap="none" dirty="0">
              <a:solidFill>
                <a:srgbClr val="000000"/>
              </a:solidFill>
              <a:latin typeface="Noto Sans Light"/>
              <a:ea typeface="Noto Sans Light"/>
              <a:cs typeface="Noto Sans Light"/>
              <a:sym typeface="Noto Sans Light"/>
            </a:endParaRPr>
          </a:p>
        </p:txBody>
      </p:sp>
      <p:sp>
        <p:nvSpPr>
          <p:cNvPr id="372" name="Google Shape;372;p1"/>
          <p:cNvSpPr txBox="1"/>
          <p:nvPr/>
        </p:nvSpPr>
        <p:spPr>
          <a:xfrm>
            <a:off x="3863455" y="2477241"/>
            <a:ext cx="329716" cy="138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0" i="0" u="none" strike="noStrike" cap="none" dirty="0">
                <a:solidFill>
                  <a:srgbClr val="000000"/>
                </a:solidFill>
                <a:latin typeface="Noto Sans Light"/>
                <a:ea typeface="Noto Sans Light"/>
                <a:cs typeface="Noto Sans Light"/>
                <a:sym typeface="Noto Sans Light"/>
              </a:rPr>
              <a:t>CCR6</a:t>
            </a:r>
            <a:endParaRPr sz="900" b="0" i="0" u="none" strike="noStrike" cap="none" dirty="0">
              <a:solidFill>
                <a:srgbClr val="000000"/>
              </a:solidFill>
              <a:latin typeface="Noto Sans Light"/>
              <a:ea typeface="Noto Sans Light"/>
              <a:cs typeface="Noto Sans Light"/>
              <a:sym typeface="Noto Sans Light"/>
            </a:endParaRPr>
          </a:p>
        </p:txBody>
      </p:sp>
      <p:sp>
        <p:nvSpPr>
          <p:cNvPr id="373" name="Google Shape;373;p1"/>
          <p:cNvSpPr txBox="1"/>
          <p:nvPr/>
        </p:nvSpPr>
        <p:spPr>
          <a:xfrm>
            <a:off x="5339350" y="2478175"/>
            <a:ext cx="315359" cy="1384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0" i="0" u="none" strike="noStrike" cap="none" dirty="0">
                <a:solidFill>
                  <a:srgbClr val="000000"/>
                </a:solidFill>
                <a:latin typeface="Noto Sans Light"/>
                <a:ea typeface="Noto Sans Light"/>
                <a:cs typeface="Noto Sans Light"/>
                <a:sym typeface="Noto Sans Light"/>
              </a:rPr>
              <a:t>CD27</a:t>
            </a:r>
            <a:endParaRPr sz="900" b="0" i="0" u="none" strike="noStrike" cap="none" dirty="0">
              <a:solidFill>
                <a:srgbClr val="000000"/>
              </a:solidFill>
              <a:latin typeface="Noto Sans Light"/>
              <a:ea typeface="Noto Sans Light"/>
              <a:cs typeface="Noto Sans Light"/>
              <a:sym typeface="Noto Sans Light"/>
            </a:endParaRPr>
          </a:p>
        </p:txBody>
      </p:sp>
      <p:sp>
        <p:nvSpPr>
          <p:cNvPr id="374" name="Google Shape;374;p1"/>
          <p:cNvSpPr txBox="1"/>
          <p:nvPr/>
        </p:nvSpPr>
        <p:spPr>
          <a:xfrm>
            <a:off x="892006" y="3837237"/>
            <a:ext cx="400278" cy="1384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0" i="0" u="none" strike="noStrike" cap="none" dirty="0">
                <a:solidFill>
                  <a:srgbClr val="000000"/>
                </a:solidFill>
                <a:latin typeface="Noto Sans Light"/>
                <a:ea typeface="Noto Sans Light"/>
                <a:cs typeface="Noto Sans Light"/>
                <a:sym typeface="Noto Sans Light"/>
              </a:rPr>
              <a:t>CD25</a:t>
            </a:r>
            <a:endParaRPr sz="900" b="0" i="0" u="none" strike="noStrike" cap="none" dirty="0">
              <a:solidFill>
                <a:srgbClr val="000000"/>
              </a:solidFill>
              <a:latin typeface="Noto Sans Light"/>
              <a:ea typeface="Noto Sans Light"/>
              <a:cs typeface="Noto Sans Light"/>
              <a:sym typeface="Noto Sans Light"/>
            </a:endParaRPr>
          </a:p>
        </p:txBody>
      </p:sp>
      <p:sp>
        <p:nvSpPr>
          <p:cNvPr id="375" name="Google Shape;375;p1"/>
          <p:cNvSpPr txBox="1"/>
          <p:nvPr/>
        </p:nvSpPr>
        <p:spPr>
          <a:xfrm>
            <a:off x="2349986" y="3836572"/>
            <a:ext cx="374659" cy="1391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0" i="0" u="none" strike="noStrike" cap="none" dirty="0">
                <a:solidFill>
                  <a:srgbClr val="000000"/>
                </a:solidFill>
                <a:latin typeface="Noto Sans Light"/>
                <a:ea typeface="Noto Sans Light"/>
                <a:cs typeface="Noto Sans Light"/>
                <a:sym typeface="Noto Sans Light"/>
              </a:rPr>
              <a:t>CCR10</a:t>
            </a:r>
            <a:endParaRPr sz="900" b="0" i="0" u="none" strike="noStrike" cap="none" dirty="0">
              <a:solidFill>
                <a:srgbClr val="000000"/>
              </a:solidFill>
              <a:latin typeface="Noto Sans Light"/>
              <a:ea typeface="Noto Sans Light"/>
              <a:cs typeface="Noto Sans Light"/>
              <a:sym typeface="Noto Sans Light"/>
            </a:endParaRPr>
          </a:p>
        </p:txBody>
      </p:sp>
      <p:sp>
        <p:nvSpPr>
          <p:cNvPr id="376" name="Google Shape;376;p1"/>
          <p:cNvSpPr txBox="1"/>
          <p:nvPr/>
        </p:nvSpPr>
        <p:spPr>
          <a:xfrm>
            <a:off x="3843937" y="3839447"/>
            <a:ext cx="417959" cy="1384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0" i="0" u="none" strike="noStrike" cap="none" dirty="0">
                <a:solidFill>
                  <a:srgbClr val="000000"/>
                </a:solidFill>
                <a:latin typeface="Noto Sans Light"/>
                <a:ea typeface="Noto Sans Light"/>
                <a:cs typeface="Noto Sans Light"/>
                <a:sym typeface="Noto Sans Light"/>
              </a:rPr>
              <a:t>HLA-DR</a:t>
            </a:r>
            <a:endParaRPr sz="900" b="0" i="0" u="none" strike="noStrike" cap="none" dirty="0">
              <a:solidFill>
                <a:srgbClr val="000000"/>
              </a:solidFill>
              <a:latin typeface="Noto Sans Light"/>
              <a:ea typeface="Noto Sans Light"/>
              <a:cs typeface="Noto Sans Light"/>
              <a:sym typeface="Noto Sans Light"/>
            </a:endParaRPr>
          </a:p>
        </p:txBody>
      </p:sp>
      <p:sp>
        <p:nvSpPr>
          <p:cNvPr id="377" name="Google Shape;377;p1"/>
          <p:cNvSpPr txBox="1"/>
          <p:nvPr/>
        </p:nvSpPr>
        <p:spPr>
          <a:xfrm>
            <a:off x="5324574" y="3837335"/>
            <a:ext cx="449589" cy="1384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0" i="0" u="none" strike="noStrike" cap="none" dirty="0">
                <a:solidFill>
                  <a:srgbClr val="000000"/>
                </a:solidFill>
                <a:latin typeface="Noto Sans Light"/>
                <a:ea typeface="Noto Sans Light"/>
                <a:cs typeface="Noto Sans Light"/>
                <a:sym typeface="Noto Sans Light"/>
              </a:rPr>
              <a:t>CD45RA</a:t>
            </a:r>
            <a:endParaRPr sz="900" b="0" i="0" u="none" strike="noStrike" cap="none" dirty="0">
              <a:solidFill>
                <a:srgbClr val="000000"/>
              </a:solidFill>
              <a:latin typeface="Noto Sans Light"/>
              <a:ea typeface="Noto Sans Light"/>
              <a:cs typeface="Noto Sans Light"/>
              <a:sym typeface="Noto Sans Light"/>
            </a:endParaRPr>
          </a:p>
        </p:txBody>
      </p:sp>
      <p:sp>
        <p:nvSpPr>
          <p:cNvPr id="378" name="Google Shape;378;p1"/>
          <p:cNvSpPr txBox="1"/>
          <p:nvPr/>
        </p:nvSpPr>
        <p:spPr>
          <a:xfrm>
            <a:off x="128336" y="392280"/>
            <a:ext cx="231935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l Figure 3</a:t>
            </a:r>
            <a:endParaRPr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0</Words>
  <Application>Microsoft Office PowerPoint</Application>
  <PresentationFormat>Widescreen</PresentationFormat>
  <Paragraphs>17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Noto Sans Light</vt:lpstr>
      <vt:lpstr>Arial</vt:lpstr>
      <vt:lpstr>Tema d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io Gil Manso</dc:creator>
  <cp:lastModifiedBy>Marjorie Pion</cp:lastModifiedBy>
  <cp:revision>1</cp:revision>
  <dcterms:created xsi:type="dcterms:W3CDTF">2022-05-03T06:36:25Z</dcterms:created>
  <dcterms:modified xsi:type="dcterms:W3CDTF">2023-04-19T17:08:28Z</dcterms:modified>
</cp:coreProperties>
</file>